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5.xml.rels" ContentType="application/vnd.openxmlformats-package.relationships+xml"/>
  <Override PartName="/ppt/notesSlides/_rels/notesSlide14.xml.rels" ContentType="application/vnd.openxmlformats-package.relationships+xml"/>
  <Override PartName="/ppt/notesSlides/_rels/notesSlide13.xml.rels" ContentType="application/vnd.openxmlformats-package.relationships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7.png" ContentType="image/png"/>
  <Override PartName="/ppt/media/image36.png" ContentType="image/png"/>
  <Override PartName="/ppt/media/image35.png" ContentType="image/png"/>
  <Override PartName="/ppt/media/image30.png" ContentType="image/png"/>
  <Override PartName="/ppt/media/image49.png" ContentType="image/png"/>
  <Override PartName="/ppt/media/image12.png" ContentType="image/png"/>
  <Override PartName="/ppt/media/image47.png" ContentType="image/png"/>
  <Override PartName="/ppt/media/image10.png" ContentType="image/png"/>
  <Override PartName="/ppt/media/image107.png" ContentType="image/png"/>
  <Override PartName="/ppt/media/image39.png" ContentType="image/png"/>
  <Override PartName="/ppt/media/image9.png" ContentType="image/png"/>
  <Override PartName="/ppt/media/image86.png" ContentType="image/png"/>
  <Override PartName="/ppt/media/image48.png" ContentType="image/png"/>
  <Override PartName="/ppt/media/image11.png" ContentType="image/png"/>
  <Override PartName="/ppt/media/image108.png" ContentType="image/png"/>
  <Override PartName="/ppt/media/image6.jpeg" ContentType="image/jpeg"/>
  <Override PartName="/ppt/media/image71.png" ContentType="image/png"/>
  <Override PartName="/ppt/media/image18.png" ContentType="image/png"/>
  <Override PartName="/ppt/media/image83.png" ContentType="image/png"/>
  <Override PartName="/ppt/media/image57.png" ContentType="image/png"/>
  <Override PartName="/ppt/media/image20.png" ContentType="image/png"/>
  <Override PartName="/ppt/media/image117.png" ContentType="image/png"/>
  <Override PartName="/ppt/media/image13.png" ContentType="image/png"/>
  <Override PartName="/ppt/media/image1.png" ContentType="image/png"/>
  <Override PartName="/ppt/media/image50.png" ContentType="image/png"/>
  <Override PartName="/ppt/media/image5.jpeg" ContentType="image/jpeg"/>
  <Override PartName="/ppt/media/image61.png" ContentType="image/png"/>
  <Override PartName="/ppt/media/image38.png" ContentType="image/png"/>
  <Override PartName="/ppt/media/image8.jpeg" ContentType="image/jpeg"/>
  <Override PartName="/ppt/media/image26.png" ContentType="image/png"/>
  <Override PartName="/ppt/media/image91.png" ContentType="image/png"/>
  <Override PartName="/ppt/media/image7.jpeg" ContentType="image/jpeg"/>
  <Override PartName="/ppt/media/image4.png" ContentType="image/png"/>
  <Override PartName="/ppt/media/image16.png" ContentType="image/png"/>
  <Override PartName="/ppt/media/image81.png" ContentType="image/png"/>
  <Override PartName="/ppt/media/image28.png" ContentType="image/png"/>
  <Override PartName="/ppt/media/image93.png" ContentType="image/png"/>
  <Override PartName="/ppt/media/image34.png" ContentType="image/png"/>
  <Override PartName="/ppt/media/image27.png" ContentType="image/png"/>
  <Override PartName="/ppt/media/image92.png" ContentType="image/png"/>
  <Override PartName="/ppt/media/image33.png" ContentType="image/png"/>
  <Override PartName="/ppt/media/image3.png" ContentType="image/png"/>
  <Override PartName="/ppt/media/image15.png" ContentType="image/png"/>
  <Override PartName="/ppt/media/image80.png" ContentType="image/png"/>
  <Override PartName="/ppt/media/image32.png" ContentType="image/png"/>
  <Override PartName="/ppt/media/image73.png" ContentType="image/png"/>
  <Override PartName="/ppt/media/image74.png" ContentType="image/png"/>
  <Override PartName="/ppt/media/image75.png" ContentType="image/png"/>
  <Override PartName="/ppt/media/image76.png" ContentType="image/png"/>
  <Override PartName="/ppt/media/image77.png" ContentType="image/png"/>
  <Override PartName="/ppt/media/image78.png" ContentType="image/png"/>
  <Override PartName="/ppt/media/image87.png" ContentType="image/png"/>
  <Override PartName="/ppt/media/image88.png" ContentType="image/png"/>
  <Override PartName="/ppt/media/image97.png" ContentType="image/png"/>
  <Override PartName="/ppt/media/image104.png" ContentType="image/png"/>
  <Override PartName="/ppt/media/image60.png" ContentType="image/png"/>
  <Override PartName="/ppt/media/image98.png" ContentType="image/png"/>
  <Override PartName="/ppt/media/image105.png" ContentType="image/png"/>
  <Override PartName="/ppt/media/image99.png" ContentType="image/png"/>
  <Override PartName="/ppt/media/image106.png" ContentType="image/png"/>
  <Override PartName="/ppt/media/image62.png" ContentType="image/png"/>
  <Override PartName="/ppt/media/image96.png" ContentType="image/png"/>
  <Override PartName="/ppt/media/image103.png" ContentType="image/png"/>
  <Override PartName="/ppt/media/image116.png" ContentType="image/png"/>
  <Override PartName="/ppt/media/image72.png" ContentType="image/png"/>
  <Override PartName="/ppt/media/image95.png" ContentType="image/png"/>
  <Override PartName="/ppt/media/image102.png" ContentType="image/png"/>
  <Override PartName="/ppt/media/image115.png" ContentType="image/png"/>
  <Override PartName="/ppt/media/image114.png" ContentType="image/png"/>
  <Override PartName="/ppt/media/image70.png" ContentType="image/png"/>
  <Override PartName="/ppt/media/image113.png" ContentType="image/png"/>
  <Override PartName="/ppt/media/image79.png" ContentType="image/png"/>
  <Override PartName="/ppt/media/image101.png" ContentType="image/png"/>
  <Override PartName="/ppt/media/image109.jpeg" ContentType="image/jpeg"/>
  <Override PartName="/ppt/media/image29.png" ContentType="image/png"/>
  <Override PartName="/ppt/media/image94.png" ContentType="image/png"/>
  <Override PartName="/ppt/media/image112.png" ContentType="image/png"/>
  <Override PartName="/ppt/media/image89.png" ContentType="image/png"/>
  <Override PartName="/ppt/media/image111.png" ContentType="image/png"/>
  <Override PartName="/ppt/media/image85.png" ContentType="image/png"/>
  <Override PartName="/ppt/media/image69.png" ContentType="image/png"/>
  <Override PartName="/ppt/media/image68.png" ContentType="image/png"/>
  <Override PartName="/ppt/media/image31.png" ContentType="image/png"/>
  <Override PartName="/ppt/media/image67.png" ContentType="image/png"/>
  <Override PartName="/ppt/media/image66.png" ContentType="image/png"/>
  <Override PartName="/ppt/media/image100.jpeg" ContentType="image/jpeg"/>
  <Override PartName="/ppt/media/image65.png" ContentType="image/png"/>
  <Override PartName="/ppt/media/image64.png" ContentType="image/png"/>
  <Override PartName="/ppt/media/image63.png" ContentType="image/png"/>
  <Override PartName="/ppt/media/image23.png" ContentType="image/png"/>
  <Override PartName="/ppt/media/image22.png" ContentType="image/png"/>
  <Override PartName="/ppt/media/image59.png" ContentType="image/png"/>
  <Override PartName="/ppt/media/image110.png" ContentType="image/png"/>
  <Override PartName="/ppt/media/image24.png" ContentType="image/png"/>
  <Override PartName="/ppt/media/image21.png" ContentType="image/png"/>
  <Override PartName="/ppt/media/image58.png" ContentType="image/png"/>
  <Override PartName="/ppt/media/image19.png" ContentType="image/png"/>
  <Override PartName="/ppt/media/image84.png" ContentType="image/png"/>
  <Override PartName="/ppt/media/image17.png" ContentType="image/png"/>
  <Override PartName="/ppt/media/image82.png" ContentType="image/png"/>
  <Override PartName="/ppt/media/image25.png" ContentType="image/png"/>
  <Override PartName="/ppt/media/image90.png" ContentType="image/png"/>
  <Override PartName="/ppt/media/image2.png" ContentType="image/png"/>
  <Override PartName="/ppt/media/image1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3.xml.rels" ContentType="application/vnd.openxmlformats-package.relationships+xml"/>
  <Override PartName="/ppt/slides/_rels/slide21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23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22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19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  <p:sldId id="278" r:id="rId26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slide" Target="slides/slide23.xml"/><Relationship Id="rId2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23FECF-3DEC-4A6B-85D1-0C0856A1473F}" type="datetime">
              <a:rPr b="0" lang="ja-JP" sz="1200" spc="-1" strike="noStrike">
                <a:solidFill>
                  <a:srgbClr val="000000"/>
                </a:solidFill>
                <a:latin typeface="Calibri"/>
              </a:rPr>
              <a:t>26/08/29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519032-6D1E-4DBE-89B7-177E6A999E67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3.xml.rels><?xml version="1.0" encoding="UTF-8"?>
<Relationships xmlns="http://schemas.openxmlformats.org/package/2006/relationships"><Relationship Id="rId1" Type="http://schemas.openxmlformats.org/officeDocument/2006/relationships/slide" Target="../slides/slide13.xml"/><Relationship Id="rId2" Type="http://schemas.openxmlformats.org/officeDocument/2006/relationships/notesMaster" Target="../notesMasters/notesMaster1.xml"/>
</Relationships>
</file>

<file path=ppt/notesSlides/_rels/notesSlide14.xml.rels><?xml version="1.0" encoding="UTF-8"?>
<Relationships xmlns="http://schemas.openxmlformats.org/package/2006/relationships"><Relationship Id="rId1" Type="http://schemas.openxmlformats.org/officeDocument/2006/relationships/slide" Target="../slides/slide14.xml"/><Relationship Id="rId2" Type="http://schemas.openxmlformats.org/officeDocument/2006/relationships/notesMaster" Target="../notesMasters/notesMaster1.xml"/>
</Relationships>
</file>

<file path=ppt/notesSlides/_rels/notesSlide15.xml.rels><?xml version="1.0" encoding="UTF-8"?>
<Relationships xmlns="http://schemas.openxmlformats.org/package/2006/relationships"><Relationship Id="rId1" Type="http://schemas.openxmlformats.org/officeDocument/2006/relationships/slide" Target="../slides/slide15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1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2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463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100" spc="-1" strike="noStrike">
              <a:solidFill>
                <a:srgbClr val="000000"/>
              </a:solidFill>
              <a:latin typeface="Tahoma"/>
              <a:ea typeface="Tahoma"/>
            </a:endParaRPr>
          </a:p>
        </p:txBody>
      </p:sp>
      <p:sp>
        <p:nvSpPr>
          <p:cNvPr id="464" name="スライド番号プレースホルダ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D38149-DB01-4B56-9347-A5E3785B1854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466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スライド番号プレースホルダ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F298AA-0D58-4B43-B0E4-18EC1C9C9705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8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469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スライド番号プレースホルダ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4BE939-3188-4BD1-AA57-570A7F7D3773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451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100" spc="-1" strike="noStrike">
              <a:solidFill>
                <a:srgbClr val="000000"/>
              </a:solidFill>
              <a:latin typeface="Tahoma"/>
              <a:ea typeface="Tahoma"/>
            </a:endParaRPr>
          </a:p>
        </p:txBody>
      </p:sp>
      <p:sp>
        <p:nvSpPr>
          <p:cNvPr id="452" name="スライド番号プレースホルダ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344DF7-4ED9-4F87-9CFF-924EA15BE997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3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454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スライド番号プレースホルダ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2114F1-2464-4AA1-B29D-F345F4A81ABB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457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H460</a:t>
            </a: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に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miR 221 222</a:t>
            </a: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トランスフェクションして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E-CADHERIN</a:t>
            </a: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と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VIMENTIN</a:t>
            </a: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の３回実験の平均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8" name="スライド番号プレースホルダ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6F585E-8B37-45E4-B839-AC57F71DF5B9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460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2060"/>
              </a:solidFill>
              <a:latin typeface="Tahoma"/>
              <a:ea typeface="Tahoma"/>
            </a:endParaRPr>
          </a:p>
        </p:txBody>
      </p:sp>
      <p:sp>
        <p:nvSpPr>
          <p:cNvPr id="461" name="スライド番号プレースホルダ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E01068-D67F-4FE9-9C28-76E486D4B2FD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65F1DE-978D-4469-9FCA-12FCA9AD53F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E2214A-34E6-4702-9014-C3DBEB8C86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994473-2936-48B6-ABB3-7C1239C187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E92BF3-CE2C-4975-A5B7-4644357994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B7B706-DE70-49BB-A733-F56188A3B9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06DB18-7759-444D-B70B-6969836558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07C578-F448-4FD0-B18F-D47FD10E90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ADC83E-4586-4BB0-8F49-7BD0C94B75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5BA9C1-1104-460A-BE00-85FEC123BF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B0D192-7FF9-4864-954D-BB4DD4D149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69C45B-98DC-44E6-96BC-982EE2B1AF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D51BC0-A96A-44A9-8CB9-5442AFA197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ahoma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ahom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ahoma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ahoma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ahoma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ahoma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ahoma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ahoma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ahoma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Tahoma"/>
                <a:ea typeface="MS Gothic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97A389-F86F-435D-982C-D6A8CFC44A4D}" type="datetime">
              <a:rPr b="0" lang="ja-JP" sz="1400" spc="-1" strike="noStrike">
                <a:solidFill>
                  <a:srgbClr val="000000"/>
                </a:solidFill>
                <a:latin typeface="Tahoma"/>
                <a:ea typeface="MS Gothic"/>
              </a:rPr>
              <a:t>26/08/29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ahoma"/>
                <a:ea typeface="MS Gothic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040241-27F5-4AFB-9C39-0ADB072F2D6F}" type="slidenum">
              <a:rPr b="0" lang="en-US" sz="1400" spc="-1" strike="noStrike">
                <a:solidFill>
                  <a:srgbClr val="000000"/>
                </a:solidFill>
                <a:latin typeface="Tahoma"/>
                <a:ea typeface="MS Gothic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48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50.png"/><Relationship Id="rId2" Type="http://schemas.openxmlformats.org/officeDocument/2006/relationships/image" Target="../media/image51.png"/><Relationship Id="rId3" Type="http://schemas.openxmlformats.org/officeDocument/2006/relationships/image" Target="../media/image52.png"/><Relationship Id="rId4" Type="http://schemas.openxmlformats.org/officeDocument/2006/relationships/image" Target="../media/image53.png"/><Relationship Id="rId5" Type="http://schemas.openxmlformats.org/officeDocument/2006/relationships/image" Target="../media/image54.png"/><Relationship Id="rId6" Type="http://schemas.openxmlformats.org/officeDocument/2006/relationships/image" Target="../media/image55.png"/><Relationship Id="rId7" Type="http://schemas.openxmlformats.org/officeDocument/2006/relationships/image" Target="../media/image56.png"/><Relationship Id="rId8" Type="http://schemas.openxmlformats.org/officeDocument/2006/relationships/image" Target="../media/image57.png"/><Relationship Id="rId9" Type="http://schemas.openxmlformats.org/officeDocument/2006/relationships/image" Target="../media/image58.png"/><Relationship Id="rId10" Type="http://schemas.openxmlformats.org/officeDocument/2006/relationships/image" Target="../media/image59.png"/><Relationship Id="rId11" Type="http://schemas.openxmlformats.org/officeDocument/2006/relationships/image" Target="../media/image60.png"/><Relationship Id="rId12" Type="http://schemas.openxmlformats.org/officeDocument/2006/relationships/image" Target="../media/image61.png"/><Relationship Id="rId13" Type="http://schemas.openxmlformats.org/officeDocument/2006/relationships/image" Target="../media/image62.png"/><Relationship Id="rId14" Type="http://schemas.openxmlformats.org/officeDocument/2006/relationships/image" Target="../media/image63.png"/><Relationship Id="rId15" Type="http://schemas.openxmlformats.org/officeDocument/2006/relationships/image" Target="../media/image64.png"/><Relationship Id="rId16" Type="http://schemas.openxmlformats.org/officeDocument/2006/relationships/image" Target="../media/image65.png"/><Relationship Id="rId17" Type="http://schemas.openxmlformats.org/officeDocument/2006/relationships/image" Target="../media/image66.png"/><Relationship Id="rId18" Type="http://schemas.openxmlformats.org/officeDocument/2006/relationships/image" Target="../media/image67.png"/><Relationship Id="rId19" Type="http://schemas.openxmlformats.org/officeDocument/2006/relationships/image" Target="../media/image68.png"/><Relationship Id="rId20" Type="http://schemas.openxmlformats.org/officeDocument/2006/relationships/image" Target="../media/image69.png"/><Relationship Id="rId21" Type="http://schemas.openxmlformats.org/officeDocument/2006/relationships/image" Target="../media/image70.png"/><Relationship Id="rId2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71.png"/><Relationship Id="rId2" Type="http://schemas.openxmlformats.org/officeDocument/2006/relationships/image" Target="../media/image72.png"/><Relationship Id="rId3" Type="http://schemas.openxmlformats.org/officeDocument/2006/relationships/image" Target="../media/image73.png"/><Relationship Id="rId4" Type="http://schemas.openxmlformats.org/officeDocument/2006/relationships/image" Target="../media/image74.png"/><Relationship Id="rId5" Type="http://schemas.openxmlformats.org/officeDocument/2006/relationships/image" Target="../media/image75.png"/><Relationship Id="rId6" Type="http://schemas.openxmlformats.org/officeDocument/2006/relationships/image" Target="../media/image76.png"/><Relationship Id="rId7" Type="http://schemas.openxmlformats.org/officeDocument/2006/relationships/image" Target="../media/image77.png"/><Relationship Id="rId8" Type="http://schemas.openxmlformats.org/officeDocument/2006/relationships/image" Target="../media/image78.png"/><Relationship Id="rId9" Type="http://schemas.openxmlformats.org/officeDocument/2006/relationships/image" Target="../media/image79.png"/><Relationship Id="rId10" Type="http://schemas.openxmlformats.org/officeDocument/2006/relationships/image" Target="../media/image80.png"/><Relationship Id="rId11" Type="http://schemas.openxmlformats.org/officeDocument/2006/relationships/image" Target="../media/image81.png"/><Relationship Id="rId12" Type="http://schemas.openxmlformats.org/officeDocument/2006/relationships/image" Target="../media/image82.png"/><Relationship Id="rId13" Type="http://schemas.openxmlformats.org/officeDocument/2006/relationships/image" Target="../media/image83.png"/><Relationship Id="rId14" Type="http://schemas.openxmlformats.org/officeDocument/2006/relationships/image" Target="../media/image84.png"/><Relationship Id="rId15" Type="http://schemas.openxmlformats.org/officeDocument/2006/relationships/image" Target="../media/image85.png"/><Relationship Id="rId16" Type="http://schemas.openxmlformats.org/officeDocument/2006/relationships/image" Target="../media/image71.png"/><Relationship Id="rId17" Type="http://schemas.openxmlformats.org/officeDocument/2006/relationships/image" Target="../media/image72.png"/><Relationship Id="rId18" Type="http://schemas.openxmlformats.org/officeDocument/2006/relationships/image" Target="../media/image73.png"/><Relationship Id="rId19" Type="http://schemas.openxmlformats.org/officeDocument/2006/relationships/image" Target="../media/image86.png"/><Relationship Id="rId20" Type="http://schemas.openxmlformats.org/officeDocument/2006/relationships/image" Target="../media/image87.png"/><Relationship Id="rId21" Type="http://schemas.openxmlformats.org/officeDocument/2006/relationships/image" Target="../media/image88.png"/><Relationship Id="rId22" Type="http://schemas.openxmlformats.org/officeDocument/2006/relationships/image" Target="../media/image71.png"/><Relationship Id="rId23" Type="http://schemas.openxmlformats.org/officeDocument/2006/relationships/image" Target="../media/image72.png"/><Relationship Id="rId24" Type="http://schemas.openxmlformats.org/officeDocument/2006/relationships/image" Target="../media/image89.png"/><Relationship Id="rId25" Type="http://schemas.openxmlformats.org/officeDocument/2006/relationships/image" Target="../media/image86.png"/><Relationship Id="rId26" Type="http://schemas.openxmlformats.org/officeDocument/2006/relationships/image" Target="../media/image87.png"/><Relationship Id="rId27" Type="http://schemas.openxmlformats.org/officeDocument/2006/relationships/image" Target="../media/image88.png"/><Relationship Id="rId28" Type="http://schemas.openxmlformats.org/officeDocument/2006/relationships/image" Target="../media/image71.png"/><Relationship Id="rId29" Type="http://schemas.openxmlformats.org/officeDocument/2006/relationships/image" Target="../media/image72.png"/><Relationship Id="rId30" Type="http://schemas.openxmlformats.org/officeDocument/2006/relationships/image" Target="../media/image89.png"/><Relationship Id="rId31" Type="http://schemas.openxmlformats.org/officeDocument/2006/relationships/image" Target="../media/image90.png"/><Relationship Id="rId32" Type="http://schemas.openxmlformats.org/officeDocument/2006/relationships/image" Target="../media/image71.png"/><Relationship Id="rId33" Type="http://schemas.openxmlformats.org/officeDocument/2006/relationships/image" Target="../media/image72.png"/><Relationship Id="rId34" Type="http://schemas.openxmlformats.org/officeDocument/2006/relationships/image" Target="../media/image73.png"/><Relationship Id="rId35" Type="http://schemas.openxmlformats.org/officeDocument/2006/relationships/image" Target="../media/image91.png"/><Relationship Id="rId36" Type="http://schemas.openxmlformats.org/officeDocument/2006/relationships/slideLayout" Target="../slideLayouts/slideLayout1.xml"/><Relationship Id="rId37" Type="http://schemas.openxmlformats.org/officeDocument/2006/relationships/notesSlide" Target="../notesSlides/notesSlide1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92.png"/><Relationship Id="rId2" Type="http://schemas.openxmlformats.org/officeDocument/2006/relationships/image" Target="../media/image93.png"/><Relationship Id="rId3" Type="http://schemas.openxmlformats.org/officeDocument/2006/relationships/image" Target="../media/image94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4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95.png"/><Relationship Id="rId2" Type="http://schemas.openxmlformats.org/officeDocument/2006/relationships/image" Target="../media/image96.png"/><Relationship Id="rId3" Type="http://schemas.openxmlformats.org/officeDocument/2006/relationships/image" Target="../media/image97.png"/><Relationship Id="rId4" Type="http://schemas.openxmlformats.org/officeDocument/2006/relationships/image" Target="../media/image98.png"/><Relationship Id="rId5" Type="http://schemas.openxmlformats.org/officeDocument/2006/relationships/image" Target="../media/image99.png"/><Relationship Id="rId6" Type="http://schemas.openxmlformats.org/officeDocument/2006/relationships/image" Target="../media/image100.jpeg"/><Relationship Id="rId7" Type="http://schemas.openxmlformats.org/officeDocument/2006/relationships/image" Target="../media/image101.png"/><Relationship Id="rId8" Type="http://schemas.openxmlformats.org/officeDocument/2006/relationships/image" Target="../media/image102.png"/><Relationship Id="rId9" Type="http://schemas.openxmlformats.org/officeDocument/2006/relationships/image" Target="../media/image103.png"/><Relationship Id="rId10" Type="http://schemas.openxmlformats.org/officeDocument/2006/relationships/image" Target="../media/image104.png"/><Relationship Id="rId11" Type="http://schemas.openxmlformats.org/officeDocument/2006/relationships/image" Target="../media/image105.png"/><Relationship Id="rId12" Type="http://schemas.openxmlformats.org/officeDocument/2006/relationships/image" Target="../media/image106.png"/><Relationship Id="rId13" Type="http://schemas.openxmlformats.org/officeDocument/2006/relationships/image" Target="../media/image107.png"/><Relationship Id="rId14" Type="http://schemas.openxmlformats.org/officeDocument/2006/relationships/image" Target="../media/image108.png"/><Relationship Id="rId15" Type="http://schemas.openxmlformats.org/officeDocument/2006/relationships/image" Target="../media/image104.png"/><Relationship Id="rId16" Type="http://schemas.openxmlformats.org/officeDocument/2006/relationships/image" Target="../media/image109.jpeg"/><Relationship Id="rId17" Type="http://schemas.openxmlformats.org/officeDocument/2006/relationships/image" Target="../media/image110.png"/><Relationship Id="rId18" Type="http://schemas.openxmlformats.org/officeDocument/2006/relationships/image" Target="../media/image102.png"/><Relationship Id="rId19" Type="http://schemas.openxmlformats.org/officeDocument/2006/relationships/image" Target="../media/image108.png"/><Relationship Id="rId20" Type="http://schemas.openxmlformats.org/officeDocument/2006/relationships/image" Target="../media/image111.png"/><Relationship Id="rId21" Type="http://schemas.openxmlformats.org/officeDocument/2006/relationships/image" Target="../media/image112.png"/><Relationship Id="rId22" Type="http://schemas.openxmlformats.org/officeDocument/2006/relationships/image" Target="../media/image113.png"/><Relationship Id="rId23" Type="http://schemas.openxmlformats.org/officeDocument/2006/relationships/image" Target="../media/image107.png"/><Relationship Id="rId24" Type="http://schemas.openxmlformats.org/officeDocument/2006/relationships/image" Target="../media/image103.png"/><Relationship Id="rId25" Type="http://schemas.openxmlformats.org/officeDocument/2006/relationships/image" Target="../media/image104.png"/><Relationship Id="rId26" Type="http://schemas.openxmlformats.org/officeDocument/2006/relationships/image" Target="../media/image114.png"/><Relationship Id="rId27" Type="http://schemas.openxmlformats.org/officeDocument/2006/relationships/image" Target="../media/image115.png"/><Relationship Id="rId28" Type="http://schemas.openxmlformats.org/officeDocument/2006/relationships/image" Target="../media/image107.png"/><Relationship Id="rId29" Type="http://schemas.openxmlformats.org/officeDocument/2006/relationships/image" Target="../media/image103.png"/><Relationship Id="rId30" Type="http://schemas.openxmlformats.org/officeDocument/2006/relationships/image" Target="../media/image111.png"/><Relationship Id="rId31" Type="http://schemas.openxmlformats.org/officeDocument/2006/relationships/image" Target="../media/image107.png"/><Relationship Id="rId32" Type="http://schemas.openxmlformats.org/officeDocument/2006/relationships/image" Target="../media/image103.png"/><Relationship Id="rId33" Type="http://schemas.openxmlformats.org/officeDocument/2006/relationships/image" Target="../media/image104.png"/><Relationship Id="rId34" Type="http://schemas.openxmlformats.org/officeDocument/2006/relationships/image" Target="../media/image116.png"/><Relationship Id="rId35" Type="http://schemas.openxmlformats.org/officeDocument/2006/relationships/image" Target="../media/image117.png"/><Relationship Id="rId36" Type="http://schemas.openxmlformats.org/officeDocument/2006/relationships/slideLayout" Target="../slideLayouts/slideLayout1.xml"/><Relationship Id="rId37" Type="http://schemas.openxmlformats.org/officeDocument/2006/relationships/notesSlide" Target="../notesSlides/notesSlide1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2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image" Target="../media/image9.png"/><Relationship Id="rId6" Type="http://schemas.openxmlformats.org/officeDocument/2006/relationships/image" Target="../media/image10.png"/><Relationship Id="rId7" Type="http://schemas.openxmlformats.org/officeDocument/2006/relationships/image" Target="../media/image11.png"/><Relationship Id="rId8" Type="http://schemas.openxmlformats.org/officeDocument/2006/relationships/slideLayout" Target="../slideLayouts/slideLayout1.xml"/><Relationship Id="rId9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4.png"/><Relationship Id="rId4" Type="http://schemas.openxmlformats.org/officeDocument/2006/relationships/image" Target="../media/image15.png"/><Relationship Id="rId5" Type="http://schemas.openxmlformats.org/officeDocument/2006/relationships/image" Target="../media/image16.png"/><Relationship Id="rId6" Type="http://schemas.openxmlformats.org/officeDocument/2006/relationships/image" Target="../media/image17.png"/><Relationship Id="rId7" Type="http://schemas.openxmlformats.org/officeDocument/2006/relationships/image" Target="../media/image18.png"/><Relationship Id="rId8" Type="http://schemas.openxmlformats.org/officeDocument/2006/relationships/image" Target="../media/image19.png"/><Relationship Id="rId9" Type="http://schemas.openxmlformats.org/officeDocument/2006/relationships/image" Target="../media/image20.png"/><Relationship Id="rId10" Type="http://schemas.openxmlformats.org/officeDocument/2006/relationships/image" Target="../media/image21.png"/><Relationship Id="rId11" Type="http://schemas.openxmlformats.org/officeDocument/2006/relationships/image" Target="../media/image22.png"/><Relationship Id="rId12" Type="http://schemas.openxmlformats.org/officeDocument/2006/relationships/image" Target="../media/image23.png"/><Relationship Id="rId13" Type="http://schemas.openxmlformats.org/officeDocument/2006/relationships/image" Target="../media/image24.png"/><Relationship Id="rId14" Type="http://schemas.openxmlformats.org/officeDocument/2006/relationships/image" Target="../media/image25.png"/><Relationship Id="rId15" Type="http://schemas.openxmlformats.org/officeDocument/2006/relationships/image" Target="../media/image26.png"/><Relationship Id="rId16" Type="http://schemas.openxmlformats.org/officeDocument/2006/relationships/image" Target="../media/image27.png"/><Relationship Id="rId17" Type="http://schemas.openxmlformats.org/officeDocument/2006/relationships/image" Target="../media/image28.png"/><Relationship Id="rId18" Type="http://schemas.openxmlformats.org/officeDocument/2006/relationships/image" Target="../media/image29.png"/><Relationship Id="rId19" Type="http://schemas.openxmlformats.org/officeDocument/2006/relationships/image" Target="../media/image30.png"/><Relationship Id="rId20" Type="http://schemas.openxmlformats.org/officeDocument/2006/relationships/image" Target="../media/image31.png"/><Relationship Id="rId21" Type="http://schemas.openxmlformats.org/officeDocument/2006/relationships/image" Target="../media/image32.png"/><Relationship Id="rId22" Type="http://schemas.openxmlformats.org/officeDocument/2006/relationships/image" Target="../media/image33.png"/><Relationship Id="rId23" Type="http://schemas.openxmlformats.org/officeDocument/2006/relationships/image" Target="../media/image34.png"/><Relationship Id="rId24" Type="http://schemas.openxmlformats.org/officeDocument/2006/relationships/image" Target="../media/image35.png"/><Relationship Id="rId25" Type="http://schemas.openxmlformats.org/officeDocument/2006/relationships/image" Target="../media/image36.png"/><Relationship Id="rId26" Type="http://schemas.openxmlformats.org/officeDocument/2006/relationships/image" Target="../media/image37.png"/><Relationship Id="rId27" Type="http://schemas.openxmlformats.org/officeDocument/2006/relationships/slideLayout" Target="../slideLayouts/slideLayout1.xml"/><Relationship Id="rId28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8.png"/><Relationship Id="rId2" Type="http://schemas.openxmlformats.org/officeDocument/2006/relationships/image" Target="../media/image39.png"/><Relationship Id="rId3" Type="http://schemas.openxmlformats.org/officeDocument/2006/relationships/image" Target="../media/image40.png"/><Relationship Id="rId4" Type="http://schemas.openxmlformats.org/officeDocument/2006/relationships/image" Target="../media/image41.png"/><Relationship Id="rId5" Type="http://schemas.openxmlformats.org/officeDocument/2006/relationships/image" Target="../media/image42.png"/><Relationship Id="rId6" Type="http://schemas.openxmlformats.org/officeDocument/2006/relationships/image" Target="../media/image43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4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45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47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グループ化 3"/>
          <p:cNvGrpSpPr/>
          <p:nvPr/>
        </p:nvGrpSpPr>
        <p:grpSpPr>
          <a:xfrm>
            <a:off x="468360" y="1484280"/>
            <a:ext cx="8001360" cy="4897440"/>
            <a:chOff x="468360" y="1484280"/>
            <a:chExt cx="8001360" cy="4897440"/>
          </a:xfrm>
        </p:grpSpPr>
        <p:pic>
          <p:nvPicPr>
            <p:cNvPr id="49" name="グラフ 4" descr=""/>
            <p:cNvPicPr/>
            <p:nvPr/>
          </p:nvPicPr>
          <p:blipFill>
            <a:blip r:embed="rId1"/>
            <a:stretch/>
          </p:blipFill>
          <p:spPr>
            <a:xfrm>
              <a:off x="468360" y="1484280"/>
              <a:ext cx="7991280" cy="4897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正方形/長方形 7"/>
            <p:cNvSpPr/>
            <p:nvPr/>
          </p:nvSpPr>
          <p:spPr>
            <a:xfrm>
              <a:off x="7982640" y="3934080"/>
              <a:ext cx="331560" cy="187092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テキスト ボックス 4"/>
            <p:cNvSpPr/>
            <p:nvPr/>
          </p:nvSpPr>
          <p:spPr>
            <a:xfrm>
              <a:off x="7799760" y="3657240"/>
              <a:ext cx="66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Tahoma"/>
                </a:rPr>
                <a:t>HBEC4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" name="正方形/長方形 5"/>
          <p:cNvSpPr/>
          <p:nvPr/>
        </p:nvSpPr>
        <p:spPr>
          <a:xfrm>
            <a:off x="38520" y="0"/>
            <a:ext cx="256896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Figure S1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正方形/長方形 8"/>
          <p:cNvSpPr/>
          <p:nvPr/>
        </p:nvSpPr>
        <p:spPr>
          <a:xfrm rot="16200000">
            <a:off x="-459720" y="3423240"/>
            <a:ext cx="1652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ahoma"/>
                <a:ea typeface="Arial"/>
              </a:rPr>
              <a:t>Relative to RNU-6B</a:t>
            </a:r>
            <a:endParaRPr b="1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グループ化 27"/>
          <p:cNvGrpSpPr/>
          <p:nvPr/>
        </p:nvGrpSpPr>
        <p:grpSpPr>
          <a:xfrm>
            <a:off x="7120080" y="765000"/>
            <a:ext cx="1989000" cy="572040"/>
            <a:chOff x="7120080" y="765000"/>
            <a:chExt cx="1989000" cy="572040"/>
          </a:xfrm>
        </p:grpSpPr>
        <p:sp>
          <p:nvSpPr>
            <p:cNvPr id="55" name="正方形/長方形 13"/>
            <p:cNvSpPr/>
            <p:nvPr/>
          </p:nvSpPr>
          <p:spPr>
            <a:xfrm>
              <a:off x="7120080" y="1123200"/>
              <a:ext cx="144000" cy="1440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正方形/長方形 14"/>
            <p:cNvSpPr/>
            <p:nvPr/>
          </p:nvSpPr>
          <p:spPr>
            <a:xfrm>
              <a:off x="7120080" y="827280"/>
              <a:ext cx="144000" cy="14400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テキスト ボックス 40"/>
            <p:cNvSpPr/>
            <p:nvPr/>
          </p:nvSpPr>
          <p:spPr>
            <a:xfrm>
              <a:off x="7192080" y="1060560"/>
              <a:ext cx="1917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ja-JP" sz="1200" spc="-1" strike="noStrike">
                  <a:solidFill>
                    <a:srgbClr val="000000"/>
                  </a:solidFill>
                  <a:latin typeface="Tahoma"/>
                </a:rPr>
                <a:t>　</a:t>
              </a:r>
              <a:r>
                <a:rPr b="0" lang="en-US" sz="1200" spc="-1" strike="noStrike">
                  <a:solidFill>
                    <a:srgbClr val="000000"/>
                  </a:solidFill>
                  <a:latin typeface="Tahoma"/>
                </a:rPr>
                <a:t>miR-222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テキスト ボックス 40"/>
            <p:cNvSpPr/>
            <p:nvPr/>
          </p:nvSpPr>
          <p:spPr>
            <a:xfrm>
              <a:off x="7147080" y="765000"/>
              <a:ext cx="1917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ahoma"/>
                </a:rPr>
                <a:t> </a:t>
              </a:r>
              <a:r>
                <a:rPr b="0" lang="ja-JP" sz="1200" spc="-1" strike="noStrike">
                  <a:solidFill>
                    <a:srgbClr val="000000"/>
                  </a:solidFill>
                  <a:latin typeface="Tahoma"/>
                </a:rPr>
                <a:t>　</a:t>
              </a:r>
              <a:r>
                <a:rPr b="0" lang="en-US" sz="1200" spc="-1" strike="noStrike">
                  <a:solidFill>
                    <a:srgbClr val="000000"/>
                  </a:solidFill>
                  <a:latin typeface="Tahoma"/>
                </a:rPr>
                <a:t>miR-221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6" name="グラフ 3" descr=""/>
          <p:cNvPicPr/>
          <p:nvPr/>
        </p:nvPicPr>
        <p:blipFill>
          <a:blip r:embed="rId1"/>
          <a:stretch/>
        </p:blipFill>
        <p:spPr>
          <a:xfrm>
            <a:off x="0" y="596880"/>
            <a:ext cx="9144000" cy="5664240"/>
          </a:xfrm>
          <a:prstGeom prst="rect">
            <a:avLst/>
          </a:prstGeom>
          <a:ln w="0">
            <a:noFill/>
          </a:ln>
        </p:spPr>
      </p:pic>
      <p:sp>
        <p:nvSpPr>
          <p:cNvPr id="187" name="PlaceHolder 1"/>
          <p:cNvSpPr>
            <a:spLocks noGrp="1"/>
          </p:cNvSpPr>
          <p:nvPr>
            <p:ph type="title"/>
          </p:nvPr>
        </p:nvSpPr>
        <p:spPr>
          <a:xfrm>
            <a:off x="519120" y="-360"/>
            <a:ext cx="8229600" cy="981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ahoma"/>
              </a:rPr>
              <a:t>H1299 miR-222/H1299 miR-221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88" name="正方形/長方形 6"/>
          <p:cNvSpPr/>
          <p:nvPr/>
        </p:nvSpPr>
        <p:spPr>
          <a:xfrm>
            <a:off x="46800" y="0"/>
            <a:ext cx="268452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Figure S10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9" name="グラフ 3" descr=""/>
          <p:cNvPicPr/>
          <p:nvPr/>
        </p:nvPicPr>
        <p:blipFill>
          <a:blip r:embed="rId1"/>
          <a:stretch/>
        </p:blipFill>
        <p:spPr>
          <a:xfrm>
            <a:off x="0" y="596880"/>
            <a:ext cx="9144000" cy="5664240"/>
          </a:xfrm>
          <a:prstGeom prst="rect">
            <a:avLst/>
          </a:prstGeom>
          <a:ln w="0">
            <a:noFill/>
          </a:ln>
        </p:spPr>
      </p:pic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590400" y="-27360"/>
            <a:ext cx="8229600" cy="981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ahoma"/>
              </a:rPr>
              <a:t>H3255 miR-222/H3255 miR-221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91" name="正方形/長方形 6"/>
          <p:cNvSpPr/>
          <p:nvPr/>
        </p:nvSpPr>
        <p:spPr>
          <a:xfrm>
            <a:off x="46800" y="0"/>
            <a:ext cx="268452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Figure S11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テキスト ボックス 44"/>
          <p:cNvSpPr/>
          <p:nvPr/>
        </p:nvSpPr>
        <p:spPr>
          <a:xfrm>
            <a:off x="2097000" y="-12600"/>
            <a:ext cx="806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ahoma"/>
                <a:ea typeface="MS Gothic"/>
              </a:rPr>
              <a:t>HBEC4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テキスト ボックス 44"/>
          <p:cNvSpPr/>
          <p:nvPr/>
        </p:nvSpPr>
        <p:spPr>
          <a:xfrm>
            <a:off x="4002120" y="-27000"/>
            <a:ext cx="76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ahoma"/>
                <a:ea typeface="MS Gothic"/>
              </a:rPr>
              <a:t>H460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テキスト ボックス 35"/>
          <p:cNvSpPr/>
          <p:nvPr/>
        </p:nvSpPr>
        <p:spPr>
          <a:xfrm>
            <a:off x="7558200" y="-42840"/>
            <a:ext cx="111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ahoma"/>
                <a:ea typeface="MS Gothic"/>
              </a:rPr>
              <a:t>HCC4006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テキスト ボックス 31"/>
          <p:cNvSpPr/>
          <p:nvPr/>
        </p:nvSpPr>
        <p:spPr>
          <a:xfrm>
            <a:off x="5740560" y="-14400"/>
            <a:ext cx="79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ahoma"/>
                <a:ea typeface="MS Gothic"/>
              </a:rPr>
              <a:t>H3255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テキスト ボックス 35"/>
          <p:cNvSpPr/>
          <p:nvPr/>
        </p:nvSpPr>
        <p:spPr>
          <a:xfrm>
            <a:off x="3903840" y="3454560"/>
            <a:ext cx="98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ahoma"/>
                <a:ea typeface="MS Gothic"/>
              </a:rPr>
              <a:t>H838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テキスト ボックス 35"/>
          <p:cNvSpPr/>
          <p:nvPr/>
        </p:nvSpPr>
        <p:spPr>
          <a:xfrm>
            <a:off x="1943280" y="3457440"/>
            <a:ext cx="115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ahoma"/>
                <a:ea typeface="MS Gothic"/>
              </a:rPr>
              <a:t>HCC401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テキスト ボックス 35"/>
          <p:cNvSpPr/>
          <p:nvPr/>
        </p:nvSpPr>
        <p:spPr>
          <a:xfrm>
            <a:off x="5772240" y="3459240"/>
            <a:ext cx="963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ahoma"/>
                <a:ea typeface="MS Gothic"/>
              </a:rPr>
              <a:t>H129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直線コネクタ 17"/>
          <p:cNvSpPr/>
          <p:nvPr/>
        </p:nvSpPr>
        <p:spPr>
          <a:xfrm>
            <a:off x="395280" y="3486240"/>
            <a:ext cx="8604360" cy="0"/>
          </a:xfrm>
          <a:prstGeom prst="line">
            <a:avLst/>
          </a:prstGeom>
          <a:ln w="93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0" name="グループ化 74"/>
          <p:cNvGrpSpPr/>
          <p:nvPr/>
        </p:nvGrpSpPr>
        <p:grpSpPr>
          <a:xfrm>
            <a:off x="695160" y="2349360"/>
            <a:ext cx="8004240" cy="1117800"/>
            <a:chOff x="695160" y="2349360"/>
            <a:chExt cx="8004240" cy="1117800"/>
          </a:xfrm>
        </p:grpSpPr>
        <p:sp>
          <p:nvSpPr>
            <p:cNvPr id="201" name="テキスト ボックス 43"/>
            <p:cNvSpPr/>
            <p:nvPr/>
          </p:nvSpPr>
          <p:spPr>
            <a:xfrm>
              <a:off x="695160" y="2649960"/>
              <a:ext cx="1297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miR-NC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2" name="グループ化 70"/>
            <p:cNvGrpSpPr/>
            <p:nvPr/>
          </p:nvGrpSpPr>
          <p:grpSpPr>
            <a:xfrm>
              <a:off x="1638720" y="2349360"/>
              <a:ext cx="7060680" cy="1117800"/>
              <a:chOff x="1638720" y="2349360"/>
              <a:chExt cx="7060680" cy="1117800"/>
            </a:xfrm>
          </p:grpSpPr>
          <p:pic>
            <p:nvPicPr>
              <p:cNvPr id="203" name="Picture 20" descr=""/>
              <p:cNvPicPr/>
              <p:nvPr/>
            </p:nvPicPr>
            <p:blipFill>
              <a:blip r:embed="rId1"/>
              <a:stretch/>
            </p:blipFill>
            <p:spPr>
              <a:xfrm>
                <a:off x="1638720" y="2349360"/>
                <a:ext cx="1514520" cy="1083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04" name="Picture 2" descr=""/>
              <p:cNvPicPr/>
              <p:nvPr/>
            </p:nvPicPr>
            <p:blipFill>
              <a:blip r:embed="rId2"/>
              <a:stretch/>
            </p:blipFill>
            <p:spPr>
              <a:xfrm>
                <a:off x="3437280" y="2367360"/>
                <a:ext cx="1495440" cy="1085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05" name="Picture 16" descr=""/>
              <p:cNvPicPr/>
              <p:nvPr/>
            </p:nvPicPr>
            <p:blipFill>
              <a:blip r:embed="rId3"/>
              <a:stretch/>
            </p:blipFill>
            <p:spPr>
              <a:xfrm>
                <a:off x="7098480" y="2376720"/>
                <a:ext cx="1600920" cy="1049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06" name="Picture 19" descr=""/>
              <p:cNvPicPr/>
              <p:nvPr/>
            </p:nvPicPr>
            <p:blipFill>
              <a:blip r:embed="rId4"/>
              <a:stretch/>
            </p:blipFill>
            <p:spPr>
              <a:xfrm>
                <a:off x="5266440" y="2396880"/>
                <a:ext cx="1538280" cy="1070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7" name="テキスト ボックス 17"/>
              <p:cNvSpPr/>
              <p:nvPr/>
            </p:nvSpPr>
            <p:spPr>
              <a:xfrm>
                <a:off x="2111400" y="2422080"/>
                <a:ext cx="87876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13.9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13.1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72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0.4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テキスト ボックス 17"/>
              <p:cNvSpPr/>
              <p:nvPr/>
            </p:nvSpPr>
            <p:spPr>
              <a:xfrm>
                <a:off x="3912120" y="2442960"/>
                <a:ext cx="878760" cy="5806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23.5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22.0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52.1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2.5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テキスト ボックス 17"/>
              <p:cNvSpPr/>
              <p:nvPr/>
            </p:nvSpPr>
            <p:spPr>
              <a:xfrm>
                <a:off x="5787000" y="2405520"/>
                <a:ext cx="87876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17.3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14.1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67.7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1.0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テキスト ボックス 17"/>
              <p:cNvSpPr/>
              <p:nvPr/>
            </p:nvSpPr>
            <p:spPr>
              <a:xfrm>
                <a:off x="7733880" y="2412360"/>
                <a:ext cx="87876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19.0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18.0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61.2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1.7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11" name="グループ化 75"/>
          <p:cNvGrpSpPr/>
          <p:nvPr/>
        </p:nvGrpSpPr>
        <p:grpSpPr>
          <a:xfrm>
            <a:off x="647640" y="189000"/>
            <a:ext cx="8137440" cy="2232000"/>
            <a:chOff x="647640" y="189000"/>
            <a:chExt cx="8137440" cy="2232000"/>
          </a:xfrm>
        </p:grpSpPr>
        <p:sp>
          <p:nvSpPr>
            <p:cNvPr id="212" name="テキスト ボックス 40"/>
            <p:cNvSpPr/>
            <p:nvPr/>
          </p:nvSpPr>
          <p:spPr>
            <a:xfrm>
              <a:off x="647640" y="635760"/>
              <a:ext cx="172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miR-221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テキスト ボックス 41"/>
            <p:cNvSpPr/>
            <p:nvPr/>
          </p:nvSpPr>
          <p:spPr>
            <a:xfrm>
              <a:off x="666000" y="1726920"/>
              <a:ext cx="165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miR-222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4" name="グループ化 71"/>
            <p:cNvGrpSpPr/>
            <p:nvPr/>
          </p:nvGrpSpPr>
          <p:grpSpPr>
            <a:xfrm>
              <a:off x="1628640" y="189000"/>
              <a:ext cx="7156440" cy="2232000"/>
              <a:chOff x="1628640" y="189000"/>
              <a:chExt cx="7156440" cy="2232000"/>
            </a:xfrm>
          </p:grpSpPr>
          <p:pic>
            <p:nvPicPr>
              <p:cNvPr id="215" name="Picture 22" descr=""/>
              <p:cNvPicPr/>
              <p:nvPr/>
            </p:nvPicPr>
            <p:blipFill>
              <a:blip r:embed="rId5"/>
              <a:stretch/>
            </p:blipFill>
            <p:spPr>
              <a:xfrm>
                <a:off x="1628640" y="1325880"/>
                <a:ext cx="1526400" cy="1076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6" name="Picture 21" descr=""/>
              <p:cNvPicPr/>
              <p:nvPr/>
            </p:nvPicPr>
            <p:blipFill>
              <a:blip r:embed="rId6"/>
              <a:stretch/>
            </p:blipFill>
            <p:spPr>
              <a:xfrm>
                <a:off x="1628640" y="196920"/>
                <a:ext cx="1505520" cy="105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7" name="Picture 4" descr=""/>
              <p:cNvPicPr/>
              <p:nvPr/>
            </p:nvPicPr>
            <p:blipFill>
              <a:blip r:embed="rId7"/>
              <a:stretch/>
            </p:blipFill>
            <p:spPr>
              <a:xfrm>
                <a:off x="3461040" y="1341000"/>
                <a:ext cx="1497600" cy="1080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18" name="Picture 3" descr=""/>
              <p:cNvPicPr/>
              <p:nvPr/>
            </p:nvPicPr>
            <p:blipFill>
              <a:blip r:embed="rId8"/>
              <a:stretch/>
            </p:blipFill>
            <p:spPr>
              <a:xfrm>
                <a:off x="3461040" y="189000"/>
                <a:ext cx="1476720" cy="1063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19" name="直線コネクタ 35"/>
              <p:cNvSpPr/>
              <p:nvPr/>
            </p:nvSpPr>
            <p:spPr>
              <a:xfrm>
                <a:off x="8650440" y="768240"/>
                <a:ext cx="0" cy="0"/>
              </a:xfrm>
              <a:prstGeom prst="line">
                <a:avLst/>
              </a:prstGeom>
              <a:ln w="9360">
                <a:solidFill>
                  <a:srgbClr val="b6dcd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220" name="Picture 18" descr=""/>
              <p:cNvPicPr/>
              <p:nvPr/>
            </p:nvPicPr>
            <p:blipFill>
              <a:blip r:embed="rId9"/>
              <a:stretch/>
            </p:blipFill>
            <p:spPr>
              <a:xfrm>
                <a:off x="7126560" y="1302840"/>
                <a:ext cx="1658520" cy="1050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1" name="Picture 17" descr=""/>
              <p:cNvPicPr/>
              <p:nvPr/>
            </p:nvPicPr>
            <p:blipFill>
              <a:blip r:embed="rId10"/>
              <a:stretch/>
            </p:blipFill>
            <p:spPr>
              <a:xfrm>
                <a:off x="7126560" y="237600"/>
                <a:ext cx="1639440" cy="1035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2" name="Picture 21" descr=""/>
              <p:cNvPicPr/>
              <p:nvPr/>
            </p:nvPicPr>
            <p:blipFill>
              <a:blip r:embed="rId11"/>
              <a:stretch/>
            </p:blipFill>
            <p:spPr>
              <a:xfrm>
                <a:off x="5287680" y="1325880"/>
                <a:ext cx="1553040" cy="10800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23" name="Picture 20" descr=""/>
              <p:cNvPicPr/>
              <p:nvPr/>
            </p:nvPicPr>
            <p:blipFill>
              <a:blip r:embed="rId12"/>
              <a:stretch/>
            </p:blipFill>
            <p:spPr>
              <a:xfrm>
                <a:off x="5256720" y="245880"/>
                <a:ext cx="1556280" cy="1081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24" name="テキスト ボックス 17"/>
              <p:cNvSpPr/>
              <p:nvPr/>
            </p:nvSpPr>
            <p:spPr>
              <a:xfrm>
                <a:off x="2117160" y="254160"/>
                <a:ext cx="87876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13.4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15.8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68.3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2.5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テキスト ボックス 17"/>
              <p:cNvSpPr/>
              <p:nvPr/>
            </p:nvSpPr>
            <p:spPr>
              <a:xfrm>
                <a:off x="2107440" y="1372320"/>
                <a:ext cx="87876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10.2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9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78.1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2.1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テキスト ボックス 17"/>
              <p:cNvSpPr/>
              <p:nvPr/>
            </p:nvSpPr>
            <p:spPr>
              <a:xfrm>
                <a:off x="3924000" y="258480"/>
                <a:ext cx="878760" cy="5806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20.4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30.8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41.3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7.4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テキスト ボックス 17"/>
              <p:cNvSpPr/>
              <p:nvPr/>
            </p:nvSpPr>
            <p:spPr>
              <a:xfrm>
                <a:off x="3932280" y="1419120"/>
                <a:ext cx="921240" cy="5806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20.4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25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43.9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10.1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テキスト ボックス 17"/>
              <p:cNvSpPr/>
              <p:nvPr/>
            </p:nvSpPr>
            <p:spPr>
              <a:xfrm>
                <a:off x="5767560" y="258480"/>
                <a:ext cx="87876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22.5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23.2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48.5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5.8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テキスト ボックス 17"/>
              <p:cNvSpPr/>
              <p:nvPr/>
            </p:nvSpPr>
            <p:spPr>
              <a:xfrm>
                <a:off x="5794920" y="1343160"/>
                <a:ext cx="87876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19.3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17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57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5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テキスト ボックス 17"/>
              <p:cNvSpPr/>
              <p:nvPr/>
            </p:nvSpPr>
            <p:spPr>
              <a:xfrm>
                <a:off x="7705080" y="254520"/>
                <a:ext cx="92124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11.4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10.5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59.9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18.2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テキスト ボックス 17"/>
              <p:cNvSpPr/>
              <p:nvPr/>
            </p:nvSpPr>
            <p:spPr>
              <a:xfrm>
                <a:off x="7705080" y="1317960"/>
                <a:ext cx="92124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11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9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63.2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15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32" name="グループ化 76"/>
          <p:cNvGrpSpPr/>
          <p:nvPr/>
        </p:nvGrpSpPr>
        <p:grpSpPr>
          <a:xfrm>
            <a:off x="673200" y="5732640"/>
            <a:ext cx="6186240" cy="1123920"/>
            <a:chOff x="673200" y="5732640"/>
            <a:chExt cx="6186240" cy="1123920"/>
          </a:xfrm>
        </p:grpSpPr>
        <p:sp>
          <p:nvSpPr>
            <p:cNvPr id="233" name="テキスト ボックス 43"/>
            <p:cNvSpPr/>
            <p:nvPr/>
          </p:nvSpPr>
          <p:spPr>
            <a:xfrm>
              <a:off x="673200" y="5998320"/>
              <a:ext cx="1296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miR-NC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34" name="グループ化 72"/>
            <p:cNvGrpSpPr/>
            <p:nvPr/>
          </p:nvGrpSpPr>
          <p:grpSpPr>
            <a:xfrm>
              <a:off x="1652040" y="5732640"/>
              <a:ext cx="5207400" cy="1123920"/>
              <a:chOff x="1652040" y="5732640"/>
              <a:chExt cx="5207400" cy="1123920"/>
            </a:xfrm>
          </p:grpSpPr>
          <p:pic>
            <p:nvPicPr>
              <p:cNvPr id="235" name="Picture 2" descr=""/>
              <p:cNvPicPr/>
              <p:nvPr/>
            </p:nvPicPr>
            <p:blipFill>
              <a:blip r:embed="rId13"/>
              <a:stretch/>
            </p:blipFill>
            <p:spPr>
              <a:xfrm>
                <a:off x="3454200" y="5737320"/>
                <a:ext cx="1541880" cy="1119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36" name="Picture 11" descr=""/>
              <p:cNvPicPr/>
              <p:nvPr/>
            </p:nvPicPr>
            <p:blipFill>
              <a:blip r:embed="rId14"/>
              <a:stretch/>
            </p:blipFill>
            <p:spPr>
              <a:xfrm>
                <a:off x="1652040" y="5748120"/>
                <a:ext cx="1517760" cy="1040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37" name="直線コネクタ 20"/>
              <p:cNvSpPr/>
              <p:nvPr/>
            </p:nvSpPr>
            <p:spPr>
              <a:xfrm>
                <a:off x="6750000" y="6840720"/>
                <a:ext cx="0" cy="0"/>
              </a:xfrm>
              <a:prstGeom prst="line">
                <a:avLst/>
              </a:prstGeom>
              <a:ln w="9360">
                <a:solidFill>
                  <a:srgbClr val="b6dcd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1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238" name="Picture 17" descr=""/>
              <p:cNvPicPr/>
              <p:nvPr/>
            </p:nvPicPr>
            <p:blipFill>
              <a:blip r:embed="rId15"/>
              <a:stretch/>
            </p:blipFill>
            <p:spPr>
              <a:xfrm>
                <a:off x="5308920" y="5732640"/>
                <a:ext cx="1550520" cy="1062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39" name="テキスト ボックス 17"/>
              <p:cNvSpPr/>
              <p:nvPr/>
            </p:nvSpPr>
            <p:spPr>
              <a:xfrm>
                <a:off x="2109240" y="5782320"/>
                <a:ext cx="87876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19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25.0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55.0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0.4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テキスト ボックス 17"/>
              <p:cNvSpPr/>
              <p:nvPr/>
            </p:nvSpPr>
            <p:spPr>
              <a:xfrm>
                <a:off x="3986280" y="5820480"/>
                <a:ext cx="878760" cy="5806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23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15.2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60.7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0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テキスト ボックス 17"/>
              <p:cNvSpPr/>
              <p:nvPr/>
            </p:nvSpPr>
            <p:spPr>
              <a:xfrm>
                <a:off x="5818680" y="5757120"/>
                <a:ext cx="87876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27.1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25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46.7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0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42" name="グループ化 77"/>
          <p:cNvGrpSpPr/>
          <p:nvPr/>
        </p:nvGrpSpPr>
        <p:grpSpPr>
          <a:xfrm>
            <a:off x="647640" y="3657600"/>
            <a:ext cx="6203880" cy="2114640"/>
            <a:chOff x="647640" y="3657600"/>
            <a:chExt cx="6203880" cy="2114640"/>
          </a:xfrm>
        </p:grpSpPr>
        <p:sp>
          <p:nvSpPr>
            <p:cNvPr id="243" name="テキスト ボックス 40"/>
            <p:cNvSpPr/>
            <p:nvPr/>
          </p:nvSpPr>
          <p:spPr>
            <a:xfrm>
              <a:off x="647640" y="3915360"/>
              <a:ext cx="172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miR-221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テキスト ボックス 41"/>
            <p:cNvSpPr/>
            <p:nvPr/>
          </p:nvSpPr>
          <p:spPr>
            <a:xfrm>
              <a:off x="651240" y="5006880"/>
              <a:ext cx="1656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miR-222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45" name="グループ化 73"/>
            <p:cNvGrpSpPr/>
            <p:nvPr/>
          </p:nvGrpSpPr>
          <p:grpSpPr>
            <a:xfrm>
              <a:off x="1644120" y="3657600"/>
              <a:ext cx="5207400" cy="2114640"/>
              <a:chOff x="1644120" y="3657600"/>
              <a:chExt cx="5207400" cy="2114640"/>
            </a:xfrm>
          </p:grpSpPr>
          <p:pic>
            <p:nvPicPr>
              <p:cNvPr id="246" name="Picture 3" descr=""/>
              <p:cNvPicPr/>
              <p:nvPr/>
            </p:nvPicPr>
            <p:blipFill>
              <a:blip r:embed="rId16"/>
              <a:stretch/>
            </p:blipFill>
            <p:spPr>
              <a:xfrm>
                <a:off x="3456360" y="3657600"/>
                <a:ext cx="1506960" cy="1084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7" name="Picture 4" descr=""/>
              <p:cNvPicPr/>
              <p:nvPr/>
            </p:nvPicPr>
            <p:blipFill>
              <a:blip r:embed="rId17"/>
              <a:stretch/>
            </p:blipFill>
            <p:spPr>
              <a:xfrm>
                <a:off x="3489120" y="4699080"/>
                <a:ext cx="1503720" cy="1061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8" name="Picture 13" descr=""/>
              <p:cNvPicPr/>
              <p:nvPr/>
            </p:nvPicPr>
            <p:blipFill>
              <a:blip r:embed="rId18"/>
              <a:stretch/>
            </p:blipFill>
            <p:spPr>
              <a:xfrm>
                <a:off x="1661400" y="4718160"/>
                <a:ext cx="1503000" cy="10360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49" name="Picture 12" descr=""/>
              <p:cNvPicPr/>
              <p:nvPr/>
            </p:nvPicPr>
            <p:blipFill>
              <a:blip r:embed="rId19"/>
              <a:stretch/>
            </p:blipFill>
            <p:spPr>
              <a:xfrm>
                <a:off x="1644120" y="3679920"/>
                <a:ext cx="1518480" cy="1048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50" name="Picture 19" descr=""/>
              <p:cNvPicPr/>
              <p:nvPr/>
            </p:nvPicPr>
            <p:blipFill>
              <a:blip r:embed="rId20"/>
              <a:stretch/>
            </p:blipFill>
            <p:spPr>
              <a:xfrm>
                <a:off x="5328360" y="4707720"/>
                <a:ext cx="1523160" cy="1064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251" name="Picture 18" descr=""/>
              <p:cNvPicPr/>
              <p:nvPr/>
            </p:nvPicPr>
            <p:blipFill>
              <a:blip r:embed="rId21"/>
              <a:stretch/>
            </p:blipFill>
            <p:spPr>
              <a:xfrm>
                <a:off x="5316480" y="3669480"/>
                <a:ext cx="1490760" cy="1049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52" name="テキスト ボックス 17"/>
              <p:cNvSpPr/>
              <p:nvPr/>
            </p:nvSpPr>
            <p:spPr>
              <a:xfrm>
                <a:off x="2070000" y="3715560"/>
                <a:ext cx="87876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22.5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37.0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40.0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0.5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テキスト ボックス 17"/>
              <p:cNvSpPr/>
              <p:nvPr/>
            </p:nvSpPr>
            <p:spPr>
              <a:xfrm>
                <a:off x="2133000" y="4754160"/>
                <a:ext cx="87876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20.0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28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50.9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0.5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テキスト ボックス 17"/>
              <p:cNvSpPr/>
              <p:nvPr/>
            </p:nvSpPr>
            <p:spPr>
              <a:xfrm>
                <a:off x="3931560" y="3737520"/>
                <a:ext cx="878760" cy="5806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35.9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24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38.9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0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テキスト ボックス 17"/>
              <p:cNvSpPr/>
              <p:nvPr/>
            </p:nvSpPr>
            <p:spPr>
              <a:xfrm>
                <a:off x="3979080" y="4758480"/>
                <a:ext cx="878760" cy="5806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23.2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19.8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55.8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1.1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テキスト ボックス 17"/>
              <p:cNvSpPr/>
              <p:nvPr/>
            </p:nvSpPr>
            <p:spPr>
              <a:xfrm>
                <a:off x="5793840" y="3674160"/>
                <a:ext cx="87876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30.3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35.5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33.7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0.4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テキスト ボックス 17"/>
              <p:cNvSpPr/>
              <p:nvPr/>
            </p:nvSpPr>
            <p:spPr>
              <a:xfrm>
                <a:off x="5798160" y="4732920"/>
                <a:ext cx="878760" cy="580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2/M :   22.9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 :           35.8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G1 :        40.7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subG1:    0.6%</a:t>
                </a:r>
                <a:endParaRPr b="1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58" name="正方形/長方形 5"/>
          <p:cNvSpPr/>
          <p:nvPr/>
        </p:nvSpPr>
        <p:spPr>
          <a:xfrm>
            <a:off x="0" y="0"/>
            <a:ext cx="1619280" cy="580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Figure S12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9" name="グループ化 79"/>
          <p:cNvGrpSpPr/>
          <p:nvPr/>
        </p:nvGrpSpPr>
        <p:grpSpPr>
          <a:xfrm>
            <a:off x="384120" y="2084400"/>
            <a:ext cx="8640720" cy="1841400"/>
            <a:chOff x="384120" y="2084400"/>
            <a:chExt cx="8640720" cy="1841400"/>
          </a:xfrm>
        </p:grpSpPr>
        <p:grpSp>
          <p:nvGrpSpPr>
            <p:cNvPr id="260" name="グループ化 57"/>
            <p:cNvGrpSpPr/>
            <p:nvPr/>
          </p:nvGrpSpPr>
          <p:grpSpPr>
            <a:xfrm>
              <a:off x="384120" y="2111040"/>
              <a:ext cx="2224800" cy="1752120"/>
              <a:chOff x="384120" y="2111040"/>
              <a:chExt cx="2224800" cy="1752120"/>
            </a:xfrm>
          </p:grpSpPr>
          <p:sp>
            <p:nvSpPr>
              <p:cNvPr id="261" name="Rectangle 12"/>
              <p:cNvSpPr/>
              <p:nvPr/>
            </p:nvSpPr>
            <p:spPr>
              <a:xfrm>
                <a:off x="1314360" y="2264040"/>
                <a:ext cx="129456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HBEC4</a:t>
                </a:r>
                <a:endParaRPr b="1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62" name="グループ化 56"/>
              <p:cNvGrpSpPr/>
              <p:nvPr/>
            </p:nvGrpSpPr>
            <p:grpSpPr>
              <a:xfrm>
                <a:off x="384120" y="2111040"/>
                <a:ext cx="2009160" cy="1752120"/>
                <a:chOff x="384120" y="2111040"/>
                <a:chExt cx="2009160" cy="1752120"/>
              </a:xfrm>
            </p:grpSpPr>
            <p:sp>
              <p:nvSpPr>
                <p:cNvPr id="263" name="Line 18"/>
                <p:cNvSpPr/>
                <p:nvPr/>
              </p:nvSpPr>
              <p:spPr>
                <a:xfrm>
                  <a:off x="1662480" y="2565000"/>
                  <a:ext cx="648360" cy="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4" name="Rectangle 23"/>
                <p:cNvSpPr/>
                <p:nvPr/>
              </p:nvSpPr>
              <p:spPr>
                <a:xfrm>
                  <a:off x="694080" y="3617280"/>
                  <a:ext cx="761400" cy="228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ahoma"/>
                      <a:ea typeface="MS Gothic"/>
                    </a:rPr>
                    <a:t>Actin </a:t>
                  </a:r>
                  <a:endParaRPr b="1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5" name="Rectangle 30"/>
                <p:cNvSpPr/>
                <p:nvPr/>
              </p:nvSpPr>
              <p:spPr>
                <a:xfrm>
                  <a:off x="384120" y="3223440"/>
                  <a:ext cx="1050480" cy="228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ahoma"/>
                      <a:ea typeface="MS Gothic"/>
                    </a:rPr>
                    <a:t>C-Caspase3 </a:t>
                  </a:r>
                  <a:endParaRPr b="1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66" name="グループ化 34"/>
                <p:cNvGrpSpPr/>
                <p:nvPr/>
              </p:nvGrpSpPr>
              <p:grpSpPr>
                <a:xfrm>
                  <a:off x="1518480" y="2111040"/>
                  <a:ext cx="843120" cy="985320"/>
                  <a:chOff x="1518480" y="2111040"/>
                  <a:chExt cx="843120" cy="985320"/>
                </a:xfrm>
              </p:grpSpPr>
              <p:pic>
                <p:nvPicPr>
                  <p:cNvPr id="267" name="テキスト ボックス 25" descr=""/>
                  <p:cNvPicPr/>
                  <p:nvPr/>
                </p:nvPicPr>
                <p:blipFill>
                  <a:blip r:embed="rId1"/>
                  <a:stretch/>
                </p:blipFill>
                <p:spPr>
                  <a:xfrm>
                    <a:off x="1518480" y="2188080"/>
                    <a:ext cx="323640" cy="908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268" name="テキスト ボックス 2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811520" y="2111040"/>
                    <a:ext cx="323640" cy="985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269" name="テキスト ボックス 27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2037960" y="2265120"/>
                    <a:ext cx="323640" cy="831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pic>
              <p:nvPicPr>
                <p:cNvPr id="270" name="Picture 3" descr=""/>
                <p:cNvPicPr/>
                <p:nvPr/>
              </p:nvPicPr>
              <p:blipFill>
                <a:blip r:embed="rId4">
                  <a:grayscl/>
                </a:blip>
                <a:stretch/>
              </p:blipFill>
              <p:spPr>
                <a:xfrm>
                  <a:off x="1514880" y="3633840"/>
                  <a:ext cx="836640" cy="22932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271" name="Picture 8" descr=""/>
                <p:cNvPicPr/>
                <p:nvPr/>
              </p:nvPicPr>
              <p:blipFill>
                <a:blip r:embed="rId5">
                  <a:grayscl/>
                </a:blip>
                <a:srcRect l="0" t="0" r="0" b="6237"/>
                <a:stretch/>
              </p:blipFill>
              <p:spPr>
                <a:xfrm>
                  <a:off x="1486440" y="3180600"/>
                  <a:ext cx="906840" cy="32040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</p:grpSp>
        </p:grpSp>
        <p:grpSp>
          <p:nvGrpSpPr>
            <p:cNvPr id="272" name="グループ化 58"/>
            <p:cNvGrpSpPr/>
            <p:nvPr/>
          </p:nvGrpSpPr>
          <p:grpSpPr>
            <a:xfrm>
              <a:off x="3496320" y="2084400"/>
              <a:ext cx="5528520" cy="1841400"/>
              <a:chOff x="3496320" y="2084400"/>
              <a:chExt cx="5528520" cy="1841400"/>
            </a:xfrm>
          </p:grpSpPr>
          <p:grpSp>
            <p:nvGrpSpPr>
              <p:cNvPr id="273" name="グループ化 53"/>
              <p:cNvGrpSpPr/>
              <p:nvPr/>
            </p:nvGrpSpPr>
            <p:grpSpPr>
              <a:xfrm>
                <a:off x="3496320" y="2276640"/>
                <a:ext cx="1295280" cy="1613520"/>
                <a:chOff x="3496320" y="2276640"/>
                <a:chExt cx="1295280" cy="1613520"/>
              </a:xfrm>
            </p:grpSpPr>
            <p:sp>
              <p:nvSpPr>
                <p:cNvPr id="274" name="Rectangle 12"/>
                <p:cNvSpPr/>
                <p:nvPr/>
              </p:nvSpPr>
              <p:spPr>
                <a:xfrm>
                  <a:off x="3496320" y="2276640"/>
                  <a:ext cx="1295280" cy="228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ahoma"/>
                      <a:ea typeface="MS Gothic"/>
                    </a:rPr>
                    <a:t>H3255</a:t>
                  </a:r>
                  <a:endParaRPr b="1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5" name="Line 18"/>
                <p:cNvSpPr/>
                <p:nvPr/>
              </p:nvSpPr>
              <p:spPr>
                <a:xfrm>
                  <a:off x="3778560" y="2549520"/>
                  <a:ext cx="648720" cy="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276" name="Picture 7" descr=""/>
                <p:cNvPicPr/>
                <p:nvPr/>
              </p:nvPicPr>
              <p:blipFill>
                <a:blip r:embed="rId6">
                  <a:grayscl/>
                </a:blip>
                <a:srcRect l="0" t="10887" r="0" b="1210"/>
                <a:stretch/>
              </p:blipFill>
              <p:spPr>
                <a:xfrm>
                  <a:off x="3680640" y="3204360"/>
                  <a:ext cx="874440" cy="31464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277" name="Picture 8" descr=""/>
                <p:cNvPicPr/>
                <p:nvPr/>
              </p:nvPicPr>
              <p:blipFill>
                <a:blip r:embed="rId7">
                  <a:grayscl/>
                </a:blip>
                <a:srcRect l="0" t="7743" r="0" b="7349"/>
                <a:stretch/>
              </p:blipFill>
              <p:spPr>
                <a:xfrm>
                  <a:off x="3727080" y="3655440"/>
                  <a:ext cx="792000" cy="23472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</p:grpSp>
          <p:grpSp>
            <p:nvGrpSpPr>
              <p:cNvPr id="278" name="グループ化 58"/>
              <p:cNvGrpSpPr/>
              <p:nvPr/>
            </p:nvGrpSpPr>
            <p:grpSpPr>
              <a:xfrm>
                <a:off x="7729560" y="2276640"/>
                <a:ext cx="1295280" cy="1619640"/>
                <a:chOff x="7729560" y="2276640"/>
                <a:chExt cx="1295280" cy="1619640"/>
              </a:xfrm>
            </p:grpSpPr>
            <p:sp>
              <p:nvSpPr>
                <p:cNvPr id="279" name="Rectangle 12"/>
                <p:cNvSpPr/>
                <p:nvPr/>
              </p:nvSpPr>
              <p:spPr>
                <a:xfrm>
                  <a:off x="7729560" y="2276640"/>
                  <a:ext cx="1295280" cy="228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ahoma"/>
                      <a:ea typeface="MS Gothic"/>
                    </a:rPr>
                    <a:t>H1299</a:t>
                  </a:r>
                  <a:endParaRPr b="1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80" name="グループ化 52"/>
                <p:cNvGrpSpPr/>
                <p:nvPr/>
              </p:nvGrpSpPr>
              <p:grpSpPr>
                <a:xfrm>
                  <a:off x="7934760" y="2564640"/>
                  <a:ext cx="996120" cy="1331640"/>
                  <a:chOff x="7934760" y="2564640"/>
                  <a:chExt cx="996120" cy="1331640"/>
                </a:xfrm>
              </p:grpSpPr>
              <p:sp>
                <p:nvSpPr>
                  <p:cNvPr id="281" name="Line 18"/>
                  <p:cNvSpPr/>
                  <p:nvPr/>
                </p:nvSpPr>
                <p:spPr>
                  <a:xfrm>
                    <a:off x="8032680" y="2564640"/>
                    <a:ext cx="648720" cy="0"/>
                  </a:xfrm>
                  <a:prstGeom prst="line">
                    <a:avLst/>
                  </a:prstGeom>
                  <a:ln w="28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1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pic>
                <p:nvPicPr>
                  <p:cNvPr id="282" name="Picture 9" descr=""/>
                  <p:cNvPicPr/>
                  <p:nvPr/>
                </p:nvPicPr>
                <p:blipFill>
                  <a:blip r:embed="rId8">
                    <a:grayscl/>
                  </a:blip>
                  <a:srcRect l="0" t="17440" r="0" b="11190"/>
                  <a:stretch/>
                </p:blipFill>
                <p:spPr>
                  <a:xfrm>
                    <a:off x="7934760" y="3193200"/>
                    <a:ext cx="977400" cy="31464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  <p:pic>
                <p:nvPicPr>
                  <p:cNvPr id="283" name="Picture 12" descr=""/>
                  <p:cNvPicPr/>
                  <p:nvPr/>
                </p:nvPicPr>
                <p:blipFill>
                  <a:blip r:embed="rId9">
                    <a:grayscl/>
                  </a:blip>
                  <a:stretch/>
                </p:blipFill>
                <p:spPr>
                  <a:xfrm>
                    <a:off x="7967880" y="3632760"/>
                    <a:ext cx="963000" cy="26352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</p:pic>
            </p:grpSp>
          </p:grpSp>
          <p:grpSp>
            <p:nvGrpSpPr>
              <p:cNvPr id="284" name="グループ化 54"/>
              <p:cNvGrpSpPr/>
              <p:nvPr/>
            </p:nvGrpSpPr>
            <p:grpSpPr>
              <a:xfrm>
                <a:off x="5612400" y="2276640"/>
                <a:ext cx="1295280" cy="1649160"/>
                <a:chOff x="5612400" y="2276640"/>
                <a:chExt cx="1295280" cy="1649160"/>
              </a:xfrm>
            </p:grpSpPr>
            <p:sp>
              <p:nvSpPr>
                <p:cNvPr id="285" name="Rectangle 12"/>
                <p:cNvSpPr/>
                <p:nvPr/>
              </p:nvSpPr>
              <p:spPr>
                <a:xfrm>
                  <a:off x="5612400" y="2276640"/>
                  <a:ext cx="1295280" cy="228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ahoma"/>
                      <a:ea typeface="MS Gothic"/>
                    </a:rPr>
                    <a:t>HCC4011</a:t>
                  </a:r>
                  <a:endParaRPr b="1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6" name="Line 18"/>
                <p:cNvSpPr/>
                <p:nvPr/>
              </p:nvSpPr>
              <p:spPr>
                <a:xfrm>
                  <a:off x="5906520" y="2523240"/>
                  <a:ext cx="648720" cy="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287" name="Picture 10" descr=""/>
                <p:cNvPicPr/>
                <p:nvPr/>
              </p:nvPicPr>
              <p:blipFill>
                <a:blip r:embed="rId10">
                  <a:grayscl/>
                </a:blip>
                <a:srcRect l="0" t="10757" r="0" b="13347"/>
                <a:stretch/>
              </p:blipFill>
              <p:spPr>
                <a:xfrm>
                  <a:off x="5777640" y="3200760"/>
                  <a:ext cx="892800" cy="31464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288" name="Picture 13" descr=""/>
                <p:cNvPicPr/>
                <p:nvPr/>
              </p:nvPicPr>
              <p:blipFill>
                <a:blip r:embed="rId11">
                  <a:grayscl/>
                </a:blip>
                <a:stretch/>
              </p:blipFill>
              <p:spPr>
                <a:xfrm>
                  <a:off x="5766120" y="3654360"/>
                  <a:ext cx="893520" cy="27144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</p:grpSp>
          <p:grpSp>
            <p:nvGrpSpPr>
              <p:cNvPr id="289" name="グループ化 57"/>
              <p:cNvGrpSpPr/>
              <p:nvPr/>
            </p:nvGrpSpPr>
            <p:grpSpPr>
              <a:xfrm>
                <a:off x="4529520" y="2276640"/>
                <a:ext cx="1294560" cy="1610640"/>
                <a:chOff x="4529520" y="2276640"/>
                <a:chExt cx="1294560" cy="1610640"/>
              </a:xfrm>
            </p:grpSpPr>
            <p:grpSp>
              <p:nvGrpSpPr>
                <p:cNvPr id="290" name="グループ化 55"/>
                <p:cNvGrpSpPr/>
                <p:nvPr/>
              </p:nvGrpSpPr>
              <p:grpSpPr>
                <a:xfrm>
                  <a:off x="4529520" y="2276640"/>
                  <a:ext cx="1294560" cy="273240"/>
                  <a:chOff x="4529520" y="2276640"/>
                  <a:chExt cx="1294560" cy="273240"/>
                </a:xfrm>
              </p:grpSpPr>
              <p:sp>
                <p:nvSpPr>
                  <p:cNvPr id="291" name="Rectangle 12"/>
                  <p:cNvSpPr/>
                  <p:nvPr/>
                </p:nvSpPr>
                <p:spPr>
                  <a:xfrm>
                    <a:off x="4529520" y="2276640"/>
                    <a:ext cx="1294560" cy="2286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ctr">
                    <a:no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000000"/>
                        </a:solidFill>
                        <a:latin typeface="Tahoma"/>
                        <a:ea typeface="MS Gothic"/>
                      </a:rPr>
                      <a:t>HCC4006</a:t>
                    </a:r>
                    <a:endParaRPr b="1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2" name="Line 18"/>
                  <p:cNvSpPr/>
                  <p:nvPr/>
                </p:nvSpPr>
                <p:spPr>
                  <a:xfrm>
                    <a:off x="4858200" y="2549880"/>
                    <a:ext cx="648360" cy="0"/>
                  </a:xfrm>
                  <a:prstGeom prst="line">
                    <a:avLst/>
                  </a:prstGeom>
                  <a:ln w="284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1" lang="en-US" sz="1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pic>
              <p:nvPicPr>
                <p:cNvPr id="293" name="Picture 4" descr=""/>
                <p:cNvPicPr/>
                <p:nvPr/>
              </p:nvPicPr>
              <p:blipFill>
                <a:blip r:embed="rId12">
                  <a:grayscl/>
                </a:blip>
                <a:stretch/>
              </p:blipFill>
              <p:spPr>
                <a:xfrm>
                  <a:off x="4704120" y="3665880"/>
                  <a:ext cx="909000" cy="22140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294" name="Picture 7" descr=""/>
                <p:cNvPicPr/>
                <p:nvPr/>
              </p:nvPicPr>
              <p:blipFill>
                <a:blip r:embed="rId13">
                  <a:grayscl/>
                </a:blip>
                <a:srcRect l="0" t="6025" r="0" b="1903"/>
                <a:stretch/>
              </p:blipFill>
              <p:spPr>
                <a:xfrm>
                  <a:off x="4642920" y="3200760"/>
                  <a:ext cx="1029600" cy="31464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</p:grpSp>
          <p:grpSp>
            <p:nvGrpSpPr>
              <p:cNvPr id="295" name="グループ化 59"/>
              <p:cNvGrpSpPr/>
              <p:nvPr/>
            </p:nvGrpSpPr>
            <p:grpSpPr>
              <a:xfrm>
                <a:off x="6695640" y="2276640"/>
                <a:ext cx="1295280" cy="262080"/>
                <a:chOff x="6695640" y="2276640"/>
                <a:chExt cx="1295280" cy="262080"/>
              </a:xfrm>
            </p:grpSpPr>
            <p:sp>
              <p:nvSpPr>
                <p:cNvPr id="296" name="Rectangle 12"/>
                <p:cNvSpPr/>
                <p:nvPr/>
              </p:nvSpPr>
              <p:spPr>
                <a:xfrm>
                  <a:off x="6695640" y="2276640"/>
                  <a:ext cx="1295280" cy="2286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ahoma"/>
                      <a:ea typeface="MS Gothic"/>
                    </a:rPr>
                    <a:t>H838</a:t>
                  </a:r>
                  <a:endParaRPr b="1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7" name="Line 18"/>
                <p:cNvSpPr/>
                <p:nvPr/>
              </p:nvSpPr>
              <p:spPr>
                <a:xfrm>
                  <a:off x="7024320" y="2538720"/>
                  <a:ext cx="648720" cy="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1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298" name="Picture 10" descr=""/>
              <p:cNvPicPr/>
              <p:nvPr/>
            </p:nvPicPr>
            <p:blipFill>
              <a:blip r:embed="rId14">
                <a:grayscl/>
              </a:blip>
              <a:srcRect l="0" t="10830" r="0" b="5776"/>
              <a:stretch/>
            </p:blipFill>
            <p:spPr>
              <a:xfrm>
                <a:off x="6873480" y="3658320"/>
                <a:ext cx="917640" cy="2509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pic>
            <p:nvPicPr>
              <p:cNvPr id="299" name="Picture 11" descr=""/>
              <p:cNvPicPr/>
              <p:nvPr/>
            </p:nvPicPr>
            <p:blipFill>
              <a:blip r:embed="rId15">
                <a:grayscl/>
              </a:blip>
              <a:stretch/>
            </p:blipFill>
            <p:spPr>
              <a:xfrm>
                <a:off x="6875640" y="3199680"/>
                <a:ext cx="944640" cy="3103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pic>
            <p:nvPicPr>
              <p:cNvPr id="300" name="テキスト ボックス 61" descr=""/>
              <p:cNvPicPr/>
              <p:nvPr/>
            </p:nvPicPr>
            <p:blipFill>
              <a:blip r:embed="rId16"/>
              <a:stretch/>
            </p:blipFill>
            <p:spPr>
              <a:xfrm>
                <a:off x="3693600" y="2175840"/>
                <a:ext cx="322920" cy="932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01" name="テキスト ボックス 62" descr=""/>
              <p:cNvPicPr/>
              <p:nvPr/>
            </p:nvPicPr>
            <p:blipFill>
              <a:blip r:embed="rId17"/>
              <a:stretch/>
            </p:blipFill>
            <p:spPr>
              <a:xfrm>
                <a:off x="3980160" y="2096280"/>
                <a:ext cx="322920" cy="1012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02" name="テキスト ボックス 63" descr=""/>
              <p:cNvPicPr/>
              <p:nvPr/>
            </p:nvPicPr>
            <p:blipFill>
              <a:blip r:embed="rId18"/>
              <a:stretch/>
            </p:blipFill>
            <p:spPr>
              <a:xfrm>
                <a:off x="4212000" y="2255040"/>
                <a:ext cx="322920" cy="853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03" name="テキスト ボックス 64" descr=""/>
              <p:cNvPicPr/>
              <p:nvPr/>
            </p:nvPicPr>
            <p:blipFill>
              <a:blip r:embed="rId19"/>
              <a:stretch/>
            </p:blipFill>
            <p:spPr>
              <a:xfrm>
                <a:off x="4717800" y="2175840"/>
                <a:ext cx="322920" cy="926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04" name="テキスト ボックス 65" descr=""/>
              <p:cNvPicPr/>
              <p:nvPr/>
            </p:nvPicPr>
            <p:blipFill>
              <a:blip r:embed="rId20"/>
              <a:stretch/>
            </p:blipFill>
            <p:spPr>
              <a:xfrm>
                <a:off x="5004360" y="2096280"/>
                <a:ext cx="322920" cy="1006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05" name="テキスト ボックス 69" descr=""/>
              <p:cNvPicPr/>
              <p:nvPr/>
            </p:nvPicPr>
            <p:blipFill>
              <a:blip r:embed="rId21"/>
              <a:stretch/>
            </p:blipFill>
            <p:spPr>
              <a:xfrm>
                <a:off x="5254560" y="2248920"/>
                <a:ext cx="322920" cy="853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06" name="テキスト ボックス 70" descr=""/>
              <p:cNvPicPr/>
              <p:nvPr/>
            </p:nvPicPr>
            <p:blipFill>
              <a:blip r:embed="rId22"/>
              <a:stretch/>
            </p:blipFill>
            <p:spPr>
              <a:xfrm>
                <a:off x="5797080" y="2163600"/>
                <a:ext cx="322920" cy="932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07" name="テキスト ボックス 71" descr=""/>
              <p:cNvPicPr/>
              <p:nvPr/>
            </p:nvPicPr>
            <p:blipFill>
              <a:blip r:embed="rId23"/>
              <a:stretch/>
            </p:blipFill>
            <p:spPr>
              <a:xfrm>
                <a:off x="6089760" y="2084400"/>
                <a:ext cx="322920" cy="1012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08" name="テキスト ボックス 72" descr=""/>
              <p:cNvPicPr/>
              <p:nvPr/>
            </p:nvPicPr>
            <p:blipFill>
              <a:blip r:embed="rId24"/>
              <a:stretch/>
            </p:blipFill>
            <p:spPr>
              <a:xfrm>
                <a:off x="6333480" y="2236680"/>
                <a:ext cx="322920" cy="859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09" name="テキスト ボックス 73" descr=""/>
              <p:cNvPicPr/>
              <p:nvPr/>
            </p:nvPicPr>
            <p:blipFill>
              <a:blip r:embed="rId25"/>
              <a:stretch/>
            </p:blipFill>
            <p:spPr>
              <a:xfrm>
                <a:off x="6876000" y="2187720"/>
                <a:ext cx="322920" cy="926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10" name="テキスト ボックス 74" descr=""/>
              <p:cNvPicPr/>
              <p:nvPr/>
            </p:nvPicPr>
            <p:blipFill>
              <a:blip r:embed="rId26"/>
              <a:stretch/>
            </p:blipFill>
            <p:spPr>
              <a:xfrm>
                <a:off x="7168680" y="2108520"/>
                <a:ext cx="322920" cy="10062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11" name="テキスト ボックス 75" descr=""/>
              <p:cNvPicPr/>
              <p:nvPr/>
            </p:nvPicPr>
            <p:blipFill>
              <a:blip r:embed="rId27"/>
              <a:stretch/>
            </p:blipFill>
            <p:spPr>
              <a:xfrm>
                <a:off x="7418880" y="2261160"/>
                <a:ext cx="322920" cy="853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12" name="テキスト ボックス 76" descr=""/>
              <p:cNvPicPr/>
              <p:nvPr/>
            </p:nvPicPr>
            <p:blipFill>
              <a:blip r:embed="rId28"/>
              <a:stretch/>
            </p:blipFill>
            <p:spPr>
              <a:xfrm>
                <a:off x="7955280" y="2193840"/>
                <a:ext cx="322920" cy="9327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13" name="テキスト ボックス 77" descr=""/>
              <p:cNvPicPr/>
              <p:nvPr/>
            </p:nvPicPr>
            <p:blipFill>
              <a:blip r:embed="rId29"/>
              <a:stretch/>
            </p:blipFill>
            <p:spPr>
              <a:xfrm>
                <a:off x="8241840" y="2114640"/>
                <a:ext cx="322920" cy="1012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14" name="テキスト ボックス 78" descr=""/>
              <p:cNvPicPr/>
              <p:nvPr/>
            </p:nvPicPr>
            <p:blipFill>
              <a:blip r:embed="rId30"/>
              <a:stretch/>
            </p:blipFill>
            <p:spPr>
              <a:xfrm>
                <a:off x="8491680" y="2267280"/>
                <a:ext cx="322920" cy="859680"/>
              </a:xfrm>
              <a:prstGeom prst="rect">
                <a:avLst/>
              </a:prstGeom>
              <a:ln w="0">
                <a:noFill/>
              </a:ln>
            </p:spPr>
          </p:pic>
        </p:grpSp>
        <p:pic>
          <p:nvPicPr>
            <p:cNvPr id="315" name="Picture 3" descr=""/>
            <p:cNvPicPr/>
            <p:nvPr/>
          </p:nvPicPr>
          <p:blipFill>
            <a:blip r:embed="rId31">
              <a:grayscl/>
            </a:blip>
            <a:srcRect l="0" t="19948" r="0" b="0"/>
            <a:stretch/>
          </p:blipFill>
          <p:spPr>
            <a:xfrm>
              <a:off x="2555280" y="3197160"/>
              <a:ext cx="936000" cy="3290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316" name="Rectangle 12"/>
            <p:cNvSpPr/>
            <p:nvPr/>
          </p:nvSpPr>
          <p:spPr>
            <a:xfrm>
              <a:off x="2401560" y="2277000"/>
              <a:ext cx="129456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460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Line 18"/>
            <p:cNvSpPr/>
            <p:nvPr/>
          </p:nvSpPr>
          <p:spPr>
            <a:xfrm>
              <a:off x="2706840" y="2549880"/>
              <a:ext cx="6480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318" name="テキスト ボックス 68" descr=""/>
            <p:cNvPicPr/>
            <p:nvPr/>
          </p:nvPicPr>
          <p:blipFill>
            <a:blip r:embed="rId32"/>
            <a:stretch/>
          </p:blipFill>
          <p:spPr>
            <a:xfrm>
              <a:off x="2560320" y="2188440"/>
              <a:ext cx="322920" cy="932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19" name="テキスト ボックス 80" descr=""/>
            <p:cNvPicPr/>
            <p:nvPr/>
          </p:nvPicPr>
          <p:blipFill>
            <a:blip r:embed="rId33"/>
            <a:stretch/>
          </p:blipFill>
          <p:spPr>
            <a:xfrm>
              <a:off x="2852640" y="2108880"/>
              <a:ext cx="322920" cy="1011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20" name="テキスト ボックス 81" descr=""/>
            <p:cNvPicPr/>
            <p:nvPr/>
          </p:nvPicPr>
          <p:blipFill>
            <a:blip r:embed="rId34"/>
            <a:stretch/>
          </p:blipFill>
          <p:spPr>
            <a:xfrm>
              <a:off x="3084480" y="2267640"/>
              <a:ext cx="322920" cy="853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21" name="Picture 2" descr=""/>
            <p:cNvPicPr/>
            <p:nvPr/>
          </p:nvPicPr>
          <p:blipFill>
            <a:blip r:embed="rId35">
              <a:grayscl/>
            </a:blip>
            <a:srcRect l="0" t="8237" r="0" b="0"/>
            <a:stretch/>
          </p:blipFill>
          <p:spPr>
            <a:xfrm>
              <a:off x="2555280" y="3655440"/>
              <a:ext cx="936000" cy="2289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</p:grpSp>
      <p:sp>
        <p:nvSpPr>
          <p:cNvPr id="322" name="正方形/長方形 5"/>
          <p:cNvSpPr/>
          <p:nvPr/>
        </p:nvSpPr>
        <p:spPr>
          <a:xfrm>
            <a:off x="0" y="0"/>
            <a:ext cx="277164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Figure S13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3" name="グループ化 31"/>
          <p:cNvGrpSpPr/>
          <p:nvPr/>
        </p:nvGrpSpPr>
        <p:grpSpPr>
          <a:xfrm>
            <a:off x="295200" y="260280"/>
            <a:ext cx="8848800" cy="5905440"/>
            <a:chOff x="295200" y="260280"/>
            <a:chExt cx="8848800" cy="5905440"/>
          </a:xfrm>
        </p:grpSpPr>
        <p:pic>
          <p:nvPicPr>
            <p:cNvPr id="324" name="グラフ 32" descr=""/>
            <p:cNvPicPr/>
            <p:nvPr/>
          </p:nvPicPr>
          <p:blipFill>
            <a:blip r:embed="rId1"/>
            <a:stretch/>
          </p:blipFill>
          <p:spPr>
            <a:xfrm>
              <a:off x="609480" y="3069720"/>
              <a:ext cx="8357760" cy="309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25" name="グラフ 33" descr=""/>
            <p:cNvPicPr/>
            <p:nvPr/>
          </p:nvPicPr>
          <p:blipFill>
            <a:blip r:embed="rId2"/>
            <a:stretch/>
          </p:blipFill>
          <p:spPr>
            <a:xfrm>
              <a:off x="1773720" y="266040"/>
              <a:ext cx="6571800" cy="2949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26" name="グラフ 34" descr=""/>
            <p:cNvPicPr/>
            <p:nvPr/>
          </p:nvPicPr>
          <p:blipFill>
            <a:blip r:embed="rId3"/>
            <a:stretch/>
          </p:blipFill>
          <p:spPr>
            <a:xfrm>
              <a:off x="755640" y="260280"/>
              <a:ext cx="8211600" cy="2882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27" name="正方形/長方形 11"/>
            <p:cNvSpPr/>
            <p:nvPr/>
          </p:nvSpPr>
          <p:spPr>
            <a:xfrm>
              <a:off x="3543840" y="824760"/>
              <a:ext cx="916560" cy="186012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正方形/長方形 13"/>
            <p:cNvSpPr/>
            <p:nvPr/>
          </p:nvSpPr>
          <p:spPr>
            <a:xfrm>
              <a:off x="1420920" y="824760"/>
              <a:ext cx="916560" cy="186012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正方形/長方形 14"/>
            <p:cNvSpPr/>
            <p:nvPr/>
          </p:nvSpPr>
          <p:spPr>
            <a:xfrm>
              <a:off x="4628520" y="824760"/>
              <a:ext cx="916560" cy="186012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正方形/長方形 15"/>
            <p:cNvSpPr/>
            <p:nvPr/>
          </p:nvSpPr>
          <p:spPr>
            <a:xfrm>
              <a:off x="5688000" y="824760"/>
              <a:ext cx="916560" cy="186012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正方形/長方形 16"/>
            <p:cNvSpPr/>
            <p:nvPr/>
          </p:nvSpPr>
          <p:spPr>
            <a:xfrm>
              <a:off x="6750720" y="824760"/>
              <a:ext cx="916560" cy="186012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正方形/長方形 17"/>
            <p:cNvSpPr/>
            <p:nvPr/>
          </p:nvSpPr>
          <p:spPr>
            <a:xfrm>
              <a:off x="6764040" y="3880800"/>
              <a:ext cx="916560" cy="179388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正方形/長方形 19"/>
            <p:cNvSpPr/>
            <p:nvPr/>
          </p:nvSpPr>
          <p:spPr>
            <a:xfrm>
              <a:off x="5687280" y="3885840"/>
              <a:ext cx="916560" cy="177156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正方形/長方形 20"/>
            <p:cNvSpPr/>
            <p:nvPr/>
          </p:nvSpPr>
          <p:spPr>
            <a:xfrm>
              <a:off x="4615200" y="3885840"/>
              <a:ext cx="916560" cy="177156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正方形/長方形 21"/>
            <p:cNvSpPr/>
            <p:nvPr/>
          </p:nvSpPr>
          <p:spPr>
            <a:xfrm>
              <a:off x="3547440" y="3885840"/>
              <a:ext cx="916560" cy="177156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正方形/長方形 22"/>
            <p:cNvSpPr/>
            <p:nvPr/>
          </p:nvSpPr>
          <p:spPr>
            <a:xfrm>
              <a:off x="1401480" y="3867480"/>
              <a:ext cx="916560" cy="179712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テキスト ボックス 14"/>
            <p:cNvSpPr/>
            <p:nvPr/>
          </p:nvSpPr>
          <p:spPr>
            <a:xfrm>
              <a:off x="7891560" y="582120"/>
              <a:ext cx="1252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1299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テキスト ボックス 4"/>
            <p:cNvSpPr/>
            <p:nvPr/>
          </p:nvSpPr>
          <p:spPr>
            <a:xfrm>
              <a:off x="4646520" y="587520"/>
              <a:ext cx="840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CC4006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テキスト ボックス 4"/>
            <p:cNvSpPr/>
            <p:nvPr/>
          </p:nvSpPr>
          <p:spPr>
            <a:xfrm>
              <a:off x="3699000" y="597960"/>
              <a:ext cx="645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3255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テキスト ボックス 4"/>
            <p:cNvSpPr/>
            <p:nvPr/>
          </p:nvSpPr>
          <p:spPr>
            <a:xfrm>
              <a:off x="5642640" y="582120"/>
              <a:ext cx="1615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CC4011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テキスト ボックス 4"/>
            <p:cNvSpPr/>
            <p:nvPr/>
          </p:nvSpPr>
          <p:spPr>
            <a:xfrm>
              <a:off x="1494360" y="608040"/>
              <a:ext cx="66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BEC4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正方形/長方形 8"/>
            <p:cNvSpPr/>
            <p:nvPr/>
          </p:nvSpPr>
          <p:spPr>
            <a:xfrm rot="16200000">
              <a:off x="-435600" y="1167120"/>
              <a:ext cx="16934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Relative to GAPDH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正方形/長方形 8"/>
            <p:cNvSpPr/>
            <p:nvPr/>
          </p:nvSpPr>
          <p:spPr>
            <a:xfrm rot="16200000">
              <a:off x="-419040" y="4223880"/>
              <a:ext cx="1691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Relative to GAPDH</a:t>
              </a:r>
              <a:endParaRPr b="1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正方形/長方形 35"/>
            <p:cNvSpPr/>
            <p:nvPr/>
          </p:nvSpPr>
          <p:spPr>
            <a:xfrm>
              <a:off x="7831800" y="824760"/>
              <a:ext cx="916560" cy="186012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テキスト ボックス 4"/>
            <p:cNvSpPr/>
            <p:nvPr/>
          </p:nvSpPr>
          <p:spPr>
            <a:xfrm>
              <a:off x="6906600" y="608040"/>
              <a:ext cx="1615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838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正方形/長方形 37"/>
            <p:cNvSpPr/>
            <p:nvPr/>
          </p:nvSpPr>
          <p:spPr>
            <a:xfrm>
              <a:off x="7826400" y="3874320"/>
              <a:ext cx="916560" cy="178380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テキスト ボックス 14"/>
            <p:cNvSpPr/>
            <p:nvPr/>
          </p:nvSpPr>
          <p:spPr>
            <a:xfrm>
              <a:off x="7857000" y="3639600"/>
              <a:ext cx="1252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1299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テキスト ボックス 4"/>
            <p:cNvSpPr/>
            <p:nvPr/>
          </p:nvSpPr>
          <p:spPr>
            <a:xfrm>
              <a:off x="4707360" y="3645360"/>
              <a:ext cx="840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CC4006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テキスト ボックス 4"/>
            <p:cNvSpPr/>
            <p:nvPr/>
          </p:nvSpPr>
          <p:spPr>
            <a:xfrm>
              <a:off x="3645000" y="3655440"/>
              <a:ext cx="645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3255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テキスト ボックス 4"/>
            <p:cNvSpPr/>
            <p:nvPr/>
          </p:nvSpPr>
          <p:spPr>
            <a:xfrm>
              <a:off x="5745240" y="3639600"/>
              <a:ext cx="1615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CC4011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テキスト ボックス 4"/>
            <p:cNvSpPr/>
            <p:nvPr/>
          </p:nvSpPr>
          <p:spPr>
            <a:xfrm>
              <a:off x="1477800" y="3650040"/>
              <a:ext cx="66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BEC4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テキスト ボックス 4"/>
            <p:cNvSpPr/>
            <p:nvPr/>
          </p:nvSpPr>
          <p:spPr>
            <a:xfrm>
              <a:off x="6916680" y="3665880"/>
              <a:ext cx="1615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838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正方形/長方形 16"/>
            <p:cNvSpPr/>
            <p:nvPr/>
          </p:nvSpPr>
          <p:spPr>
            <a:xfrm>
              <a:off x="2466720" y="828360"/>
              <a:ext cx="916560" cy="186012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テキスト ボックス 4"/>
            <p:cNvSpPr/>
            <p:nvPr/>
          </p:nvSpPr>
          <p:spPr>
            <a:xfrm>
              <a:off x="2591280" y="616320"/>
              <a:ext cx="55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460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正方形/長方形 16"/>
            <p:cNvSpPr/>
            <p:nvPr/>
          </p:nvSpPr>
          <p:spPr>
            <a:xfrm>
              <a:off x="2475720" y="3864600"/>
              <a:ext cx="916560" cy="1798920"/>
            </a:xfrm>
            <a:prstGeom prst="rect">
              <a:avLst/>
            </a:prstGeom>
            <a:noFill/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テキスト ボックス 4"/>
            <p:cNvSpPr/>
            <p:nvPr/>
          </p:nvSpPr>
          <p:spPr>
            <a:xfrm>
              <a:off x="2600280" y="3627360"/>
              <a:ext cx="558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460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7" name="正方形/長方形 5"/>
          <p:cNvSpPr/>
          <p:nvPr/>
        </p:nvSpPr>
        <p:spPr>
          <a:xfrm>
            <a:off x="0" y="0"/>
            <a:ext cx="277164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Figure S14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正方形/長方形 54"/>
          <p:cNvSpPr/>
          <p:nvPr/>
        </p:nvSpPr>
        <p:spPr>
          <a:xfrm>
            <a:off x="46800" y="0"/>
            <a:ext cx="268452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Figure S15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Rectangle 30"/>
          <p:cNvSpPr/>
          <p:nvPr/>
        </p:nvSpPr>
        <p:spPr>
          <a:xfrm>
            <a:off x="395280" y="3019320"/>
            <a:ext cx="105084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ahoma"/>
                <a:ea typeface="MS Gothic"/>
              </a:rPr>
              <a:t>PTEN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Rectangle 23"/>
          <p:cNvSpPr/>
          <p:nvPr/>
        </p:nvSpPr>
        <p:spPr>
          <a:xfrm>
            <a:off x="539640" y="3362400"/>
            <a:ext cx="7621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ahoma"/>
                <a:ea typeface="MS Gothic"/>
              </a:rPr>
              <a:t>Actin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Rectangle 12"/>
          <p:cNvSpPr/>
          <p:nvPr/>
        </p:nvSpPr>
        <p:spPr>
          <a:xfrm>
            <a:off x="1220760" y="1928880"/>
            <a:ext cx="11556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ahoma"/>
                <a:ea typeface="MS Gothic"/>
              </a:rPr>
              <a:t>HBEC4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62" name="Picture 2" descr=""/>
          <p:cNvPicPr/>
          <p:nvPr/>
        </p:nvPicPr>
        <p:blipFill>
          <a:blip r:embed="rId1">
            <a:grayscl/>
          </a:blip>
          <a:srcRect l="0" t="9677" r="0" b="19859"/>
          <a:stretch/>
        </p:blipFill>
        <p:spPr>
          <a:xfrm>
            <a:off x="1425600" y="3357720"/>
            <a:ext cx="720720" cy="250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63" name="Picture 6" descr=""/>
          <p:cNvPicPr/>
          <p:nvPr/>
        </p:nvPicPr>
        <p:blipFill>
          <a:blip r:embed="rId2">
            <a:grayscl/>
          </a:blip>
          <a:srcRect l="0" t="13048" r="0" b="19102"/>
          <a:stretch/>
        </p:blipFill>
        <p:spPr>
          <a:xfrm>
            <a:off x="1409760" y="3062160"/>
            <a:ext cx="720720" cy="243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364" name="Line 18"/>
          <p:cNvSpPr/>
          <p:nvPr/>
        </p:nvSpPr>
        <p:spPr>
          <a:xfrm>
            <a:off x="1465200" y="2268360"/>
            <a:ext cx="5778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5" name="グループ化 34"/>
          <p:cNvGrpSpPr/>
          <p:nvPr/>
        </p:nvGrpSpPr>
        <p:grpSpPr>
          <a:xfrm>
            <a:off x="1397160" y="1924200"/>
            <a:ext cx="730080" cy="984240"/>
            <a:chOff x="1397160" y="1924200"/>
            <a:chExt cx="730080" cy="984240"/>
          </a:xfrm>
        </p:grpSpPr>
        <p:pic>
          <p:nvPicPr>
            <p:cNvPr id="366" name="テキスト ボックス 25" descr=""/>
            <p:cNvPicPr/>
            <p:nvPr/>
          </p:nvPicPr>
          <p:blipFill>
            <a:blip r:embed="rId3"/>
            <a:stretch/>
          </p:blipFill>
          <p:spPr>
            <a:xfrm>
              <a:off x="1397160" y="1995480"/>
              <a:ext cx="299160" cy="912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67" name="テキスト ボックス 151" descr=""/>
            <p:cNvPicPr/>
            <p:nvPr/>
          </p:nvPicPr>
          <p:blipFill>
            <a:blip r:embed="rId4"/>
            <a:stretch/>
          </p:blipFill>
          <p:spPr>
            <a:xfrm>
              <a:off x="1642320" y="1924200"/>
              <a:ext cx="299160" cy="984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68" name="テキスト ボックス 27" descr=""/>
            <p:cNvPicPr/>
            <p:nvPr/>
          </p:nvPicPr>
          <p:blipFill>
            <a:blip r:embed="rId5"/>
            <a:stretch/>
          </p:blipFill>
          <p:spPr>
            <a:xfrm>
              <a:off x="1834200" y="2073240"/>
              <a:ext cx="293040" cy="83520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369" name="Picture 10" descr=""/>
          <p:cNvPicPr/>
          <p:nvPr/>
        </p:nvPicPr>
        <p:blipFill>
          <a:blip r:embed="rId6">
            <a:grayscl/>
          </a:blip>
          <a:srcRect l="0" t="14118" r="0" b="13583"/>
          <a:stretch/>
        </p:blipFill>
        <p:spPr>
          <a:xfrm>
            <a:off x="3567240" y="3363840"/>
            <a:ext cx="718920" cy="244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70" name="Picture 12" descr=""/>
          <p:cNvPicPr/>
          <p:nvPr/>
        </p:nvPicPr>
        <p:blipFill>
          <a:blip r:embed="rId7">
            <a:grayscl/>
          </a:blip>
          <a:srcRect l="0" t="21350" r="0" b="20985"/>
          <a:stretch/>
        </p:blipFill>
        <p:spPr>
          <a:xfrm>
            <a:off x="3565440" y="3062160"/>
            <a:ext cx="720720" cy="236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371" name="Rectangle 12"/>
          <p:cNvSpPr/>
          <p:nvPr/>
        </p:nvSpPr>
        <p:spPr>
          <a:xfrm>
            <a:off x="3330720" y="1920960"/>
            <a:ext cx="1155600" cy="22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ahoma"/>
                <a:ea typeface="MS Gothic"/>
              </a:rPr>
              <a:t>H3255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72" name="テキスト ボックス 117" descr=""/>
          <p:cNvPicPr/>
          <p:nvPr/>
        </p:nvPicPr>
        <p:blipFill>
          <a:blip r:embed="rId8"/>
          <a:stretch/>
        </p:blipFill>
        <p:spPr>
          <a:xfrm>
            <a:off x="3541680" y="1987560"/>
            <a:ext cx="304920" cy="931680"/>
          </a:xfrm>
          <a:prstGeom prst="rect">
            <a:avLst/>
          </a:prstGeom>
          <a:ln w="0">
            <a:noFill/>
          </a:ln>
        </p:spPr>
      </p:pic>
      <p:pic>
        <p:nvPicPr>
          <p:cNvPr id="373" name="テキスト ボックス 118" descr=""/>
          <p:cNvPicPr/>
          <p:nvPr/>
        </p:nvPicPr>
        <p:blipFill>
          <a:blip r:embed="rId9"/>
          <a:stretch/>
        </p:blipFill>
        <p:spPr>
          <a:xfrm>
            <a:off x="3780000" y="1908000"/>
            <a:ext cx="304560" cy="1011240"/>
          </a:xfrm>
          <a:prstGeom prst="rect">
            <a:avLst/>
          </a:prstGeom>
          <a:ln w="0">
            <a:noFill/>
          </a:ln>
        </p:spPr>
      </p:pic>
      <p:pic>
        <p:nvPicPr>
          <p:cNvPr id="374" name="テキスト ボックス 119" descr=""/>
          <p:cNvPicPr/>
          <p:nvPr/>
        </p:nvPicPr>
        <p:blipFill>
          <a:blip r:embed="rId10"/>
          <a:stretch/>
        </p:blipFill>
        <p:spPr>
          <a:xfrm>
            <a:off x="3998880" y="2066760"/>
            <a:ext cx="304920" cy="852480"/>
          </a:xfrm>
          <a:prstGeom prst="rect">
            <a:avLst/>
          </a:prstGeom>
          <a:ln w="0">
            <a:noFill/>
          </a:ln>
        </p:spPr>
      </p:pic>
      <p:pic>
        <p:nvPicPr>
          <p:cNvPr id="375" name="Picture 3" descr=""/>
          <p:cNvPicPr/>
          <p:nvPr/>
        </p:nvPicPr>
        <p:blipFill>
          <a:blip r:embed="rId11">
            <a:grayscl/>
          </a:blip>
          <a:srcRect l="0" t="20464" r="0" b="19657"/>
          <a:stretch/>
        </p:blipFill>
        <p:spPr>
          <a:xfrm>
            <a:off x="4568760" y="3381480"/>
            <a:ext cx="720720" cy="237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76" name="Picture 7" descr=""/>
          <p:cNvPicPr/>
          <p:nvPr/>
        </p:nvPicPr>
        <p:blipFill>
          <a:blip r:embed="rId12">
            <a:grayscl/>
          </a:blip>
          <a:srcRect l="0" t="21086" r="0" b="17954"/>
          <a:stretch/>
        </p:blipFill>
        <p:spPr>
          <a:xfrm>
            <a:off x="4554360" y="3097080"/>
            <a:ext cx="719280" cy="238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377" name="グループ化 55"/>
          <p:cNvGrpSpPr/>
          <p:nvPr/>
        </p:nvGrpSpPr>
        <p:grpSpPr>
          <a:xfrm>
            <a:off x="4325760" y="1933560"/>
            <a:ext cx="1155960" cy="334800"/>
            <a:chOff x="4325760" y="1933560"/>
            <a:chExt cx="1155960" cy="334800"/>
          </a:xfrm>
        </p:grpSpPr>
        <p:sp>
          <p:nvSpPr>
            <p:cNvPr id="378" name="Rectangle 12"/>
            <p:cNvSpPr/>
            <p:nvPr/>
          </p:nvSpPr>
          <p:spPr>
            <a:xfrm>
              <a:off x="4325760" y="1933560"/>
              <a:ext cx="1155960" cy="22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CC4006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Line 18"/>
            <p:cNvSpPr/>
            <p:nvPr/>
          </p:nvSpPr>
          <p:spPr>
            <a:xfrm>
              <a:off x="4610880" y="2268360"/>
              <a:ext cx="5788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380" name="テキスト ボックス 120" descr=""/>
          <p:cNvPicPr/>
          <p:nvPr/>
        </p:nvPicPr>
        <p:blipFill>
          <a:blip r:embed="rId13"/>
          <a:stretch/>
        </p:blipFill>
        <p:spPr>
          <a:xfrm>
            <a:off x="4522680" y="1987560"/>
            <a:ext cx="298440" cy="931680"/>
          </a:xfrm>
          <a:prstGeom prst="rect">
            <a:avLst/>
          </a:prstGeom>
          <a:ln w="0">
            <a:noFill/>
          </a:ln>
        </p:spPr>
      </p:pic>
      <p:pic>
        <p:nvPicPr>
          <p:cNvPr id="381" name="テキスト ボックス 121" descr=""/>
          <p:cNvPicPr/>
          <p:nvPr/>
        </p:nvPicPr>
        <p:blipFill>
          <a:blip r:embed="rId14"/>
          <a:stretch/>
        </p:blipFill>
        <p:spPr>
          <a:xfrm>
            <a:off x="4767120" y="1908000"/>
            <a:ext cx="298440" cy="1011240"/>
          </a:xfrm>
          <a:prstGeom prst="rect">
            <a:avLst/>
          </a:prstGeom>
          <a:ln w="0">
            <a:noFill/>
          </a:ln>
        </p:spPr>
      </p:pic>
      <p:pic>
        <p:nvPicPr>
          <p:cNvPr id="382" name="テキスト ボックス 122" descr=""/>
          <p:cNvPicPr/>
          <p:nvPr/>
        </p:nvPicPr>
        <p:blipFill>
          <a:blip r:embed="rId15"/>
          <a:stretch/>
        </p:blipFill>
        <p:spPr>
          <a:xfrm>
            <a:off x="4986360" y="2066760"/>
            <a:ext cx="304920" cy="852480"/>
          </a:xfrm>
          <a:prstGeom prst="rect">
            <a:avLst/>
          </a:prstGeom>
          <a:ln w="0">
            <a:noFill/>
          </a:ln>
        </p:spPr>
      </p:pic>
      <p:pic>
        <p:nvPicPr>
          <p:cNvPr id="383" name="Picture 11" descr=""/>
          <p:cNvPicPr/>
          <p:nvPr/>
        </p:nvPicPr>
        <p:blipFill>
          <a:blip r:embed="rId16">
            <a:grayscl/>
          </a:blip>
          <a:srcRect l="0" t="20082" r="0" b="22732"/>
          <a:stretch/>
        </p:blipFill>
        <p:spPr>
          <a:xfrm>
            <a:off x="5605560" y="3389400"/>
            <a:ext cx="718920" cy="237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84" name="Picture 13" descr=""/>
          <p:cNvPicPr/>
          <p:nvPr/>
        </p:nvPicPr>
        <p:blipFill>
          <a:blip r:embed="rId17">
            <a:grayscl/>
          </a:blip>
          <a:srcRect l="0" t="32756" r="0" b="19884"/>
          <a:stretch/>
        </p:blipFill>
        <p:spPr>
          <a:xfrm>
            <a:off x="5589720" y="3095640"/>
            <a:ext cx="720720" cy="243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385" name="グループ化 54"/>
          <p:cNvGrpSpPr/>
          <p:nvPr/>
        </p:nvGrpSpPr>
        <p:grpSpPr>
          <a:xfrm>
            <a:off x="5394240" y="1909800"/>
            <a:ext cx="1157400" cy="330120"/>
            <a:chOff x="5394240" y="1909800"/>
            <a:chExt cx="1157400" cy="330120"/>
          </a:xfrm>
        </p:grpSpPr>
        <p:sp>
          <p:nvSpPr>
            <p:cNvPr id="386" name="Rectangle 12"/>
            <p:cNvSpPr/>
            <p:nvPr/>
          </p:nvSpPr>
          <p:spPr>
            <a:xfrm>
              <a:off x="5394240" y="1909800"/>
              <a:ext cx="11574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CC4011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Line 18"/>
            <p:cNvSpPr/>
            <p:nvPr/>
          </p:nvSpPr>
          <p:spPr>
            <a:xfrm>
              <a:off x="5666040" y="2239920"/>
              <a:ext cx="5796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388" name="テキスト ボックス 123" descr=""/>
          <p:cNvPicPr/>
          <p:nvPr/>
        </p:nvPicPr>
        <p:blipFill>
          <a:blip r:embed="rId18"/>
          <a:stretch/>
        </p:blipFill>
        <p:spPr>
          <a:xfrm>
            <a:off x="5559480" y="1974960"/>
            <a:ext cx="304920" cy="933480"/>
          </a:xfrm>
          <a:prstGeom prst="rect">
            <a:avLst/>
          </a:prstGeom>
          <a:ln w="0">
            <a:noFill/>
          </a:ln>
        </p:spPr>
      </p:pic>
      <p:pic>
        <p:nvPicPr>
          <p:cNvPr id="389" name="テキスト ボックス 124" descr=""/>
          <p:cNvPicPr/>
          <p:nvPr/>
        </p:nvPicPr>
        <p:blipFill>
          <a:blip r:embed="rId19"/>
          <a:stretch/>
        </p:blipFill>
        <p:spPr>
          <a:xfrm>
            <a:off x="5797440" y="1914480"/>
            <a:ext cx="298440" cy="1011240"/>
          </a:xfrm>
          <a:prstGeom prst="rect">
            <a:avLst/>
          </a:prstGeom>
          <a:ln w="0">
            <a:noFill/>
          </a:ln>
        </p:spPr>
      </p:pic>
      <p:pic>
        <p:nvPicPr>
          <p:cNvPr id="390" name="テキスト ボックス 125" descr=""/>
          <p:cNvPicPr/>
          <p:nvPr/>
        </p:nvPicPr>
        <p:blipFill>
          <a:blip r:embed="rId20"/>
          <a:stretch/>
        </p:blipFill>
        <p:spPr>
          <a:xfrm>
            <a:off x="6016680" y="2054160"/>
            <a:ext cx="298440" cy="854280"/>
          </a:xfrm>
          <a:prstGeom prst="rect">
            <a:avLst/>
          </a:prstGeom>
          <a:ln w="0">
            <a:noFill/>
          </a:ln>
        </p:spPr>
      </p:pic>
      <p:pic>
        <p:nvPicPr>
          <p:cNvPr id="391" name="Picture 14" descr=""/>
          <p:cNvPicPr/>
          <p:nvPr/>
        </p:nvPicPr>
        <p:blipFill>
          <a:blip r:embed="rId21">
            <a:grayscl/>
          </a:blip>
          <a:srcRect l="0" t="12941" r="0" b="14332"/>
          <a:stretch/>
        </p:blipFill>
        <p:spPr>
          <a:xfrm>
            <a:off x="6620040" y="3370320"/>
            <a:ext cx="720720" cy="244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392" name="Picture 15" descr=""/>
          <p:cNvPicPr/>
          <p:nvPr/>
        </p:nvPicPr>
        <p:blipFill>
          <a:blip r:embed="rId22">
            <a:grayscl/>
          </a:blip>
          <a:srcRect l="0" t="17197" r="0" b="0"/>
          <a:stretch/>
        </p:blipFill>
        <p:spPr>
          <a:xfrm>
            <a:off x="6603840" y="3079800"/>
            <a:ext cx="719280" cy="235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393" name="グループ化 59"/>
          <p:cNvGrpSpPr/>
          <p:nvPr/>
        </p:nvGrpSpPr>
        <p:grpSpPr>
          <a:xfrm>
            <a:off x="6397560" y="1920960"/>
            <a:ext cx="1157400" cy="320760"/>
            <a:chOff x="6397560" y="1920960"/>
            <a:chExt cx="1157400" cy="320760"/>
          </a:xfrm>
        </p:grpSpPr>
        <p:sp>
          <p:nvSpPr>
            <p:cNvPr id="394" name="Rectangle 12"/>
            <p:cNvSpPr/>
            <p:nvPr/>
          </p:nvSpPr>
          <p:spPr>
            <a:xfrm>
              <a:off x="6397560" y="1920960"/>
              <a:ext cx="1157400" cy="229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838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Line 18"/>
            <p:cNvSpPr/>
            <p:nvPr/>
          </p:nvSpPr>
          <p:spPr>
            <a:xfrm>
              <a:off x="6658920" y="2241720"/>
              <a:ext cx="5796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396" name="テキスト ボックス 126" descr=""/>
          <p:cNvPicPr/>
          <p:nvPr/>
        </p:nvPicPr>
        <p:blipFill>
          <a:blip r:embed="rId23"/>
          <a:stretch/>
        </p:blipFill>
        <p:spPr>
          <a:xfrm>
            <a:off x="6566040" y="2000160"/>
            <a:ext cx="298440" cy="932040"/>
          </a:xfrm>
          <a:prstGeom prst="rect">
            <a:avLst/>
          </a:prstGeom>
          <a:ln w="0">
            <a:noFill/>
          </a:ln>
        </p:spPr>
      </p:pic>
      <p:pic>
        <p:nvPicPr>
          <p:cNvPr id="397" name="テキスト ボックス 127" descr=""/>
          <p:cNvPicPr/>
          <p:nvPr/>
        </p:nvPicPr>
        <p:blipFill>
          <a:blip r:embed="rId24"/>
          <a:stretch/>
        </p:blipFill>
        <p:spPr>
          <a:xfrm>
            <a:off x="6778800" y="1920960"/>
            <a:ext cx="304560" cy="1011240"/>
          </a:xfrm>
          <a:prstGeom prst="rect">
            <a:avLst/>
          </a:prstGeom>
          <a:ln w="0">
            <a:noFill/>
          </a:ln>
        </p:spPr>
      </p:pic>
      <p:pic>
        <p:nvPicPr>
          <p:cNvPr id="398" name="テキスト ボックス 128" descr=""/>
          <p:cNvPicPr/>
          <p:nvPr/>
        </p:nvPicPr>
        <p:blipFill>
          <a:blip r:embed="rId25"/>
          <a:stretch/>
        </p:blipFill>
        <p:spPr>
          <a:xfrm>
            <a:off x="7010280" y="2077920"/>
            <a:ext cx="304920" cy="854280"/>
          </a:xfrm>
          <a:prstGeom prst="rect">
            <a:avLst/>
          </a:prstGeom>
          <a:ln w="0">
            <a:noFill/>
          </a:ln>
        </p:spPr>
      </p:pic>
      <p:pic>
        <p:nvPicPr>
          <p:cNvPr id="399" name="Picture 5" descr=""/>
          <p:cNvPicPr/>
          <p:nvPr/>
        </p:nvPicPr>
        <p:blipFill>
          <a:blip r:embed="rId26">
            <a:grayscl/>
          </a:blip>
          <a:srcRect l="0" t="23564" r="0" b="11392"/>
          <a:stretch/>
        </p:blipFill>
        <p:spPr>
          <a:xfrm>
            <a:off x="7669080" y="3368520"/>
            <a:ext cx="719280" cy="243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00" name="Picture 9" descr=""/>
          <p:cNvPicPr/>
          <p:nvPr/>
        </p:nvPicPr>
        <p:blipFill>
          <a:blip r:embed="rId27">
            <a:grayscl/>
          </a:blip>
          <a:srcRect l="0" t="15615" r="0" b="13690"/>
          <a:stretch/>
        </p:blipFill>
        <p:spPr>
          <a:xfrm>
            <a:off x="7658280" y="3059280"/>
            <a:ext cx="720720" cy="242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401" name="グループ化 58"/>
          <p:cNvGrpSpPr/>
          <p:nvPr/>
        </p:nvGrpSpPr>
        <p:grpSpPr>
          <a:xfrm>
            <a:off x="7416720" y="1917720"/>
            <a:ext cx="1157400" cy="342720"/>
            <a:chOff x="7416720" y="1917720"/>
            <a:chExt cx="1157400" cy="342720"/>
          </a:xfrm>
        </p:grpSpPr>
        <p:sp>
          <p:nvSpPr>
            <p:cNvPr id="402" name="Rectangle 12"/>
            <p:cNvSpPr/>
            <p:nvPr/>
          </p:nvSpPr>
          <p:spPr>
            <a:xfrm>
              <a:off x="7416720" y="1917720"/>
              <a:ext cx="1157400" cy="22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1299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Line 18"/>
            <p:cNvSpPr/>
            <p:nvPr/>
          </p:nvSpPr>
          <p:spPr>
            <a:xfrm>
              <a:off x="7693560" y="2260440"/>
              <a:ext cx="57960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04" name="テキスト ボックス 129" descr=""/>
          <p:cNvPicPr/>
          <p:nvPr/>
        </p:nvPicPr>
        <p:blipFill>
          <a:blip r:embed="rId28"/>
          <a:stretch/>
        </p:blipFill>
        <p:spPr>
          <a:xfrm>
            <a:off x="7607160" y="2004840"/>
            <a:ext cx="298440" cy="933480"/>
          </a:xfrm>
          <a:prstGeom prst="rect">
            <a:avLst/>
          </a:prstGeom>
          <a:ln w="0">
            <a:noFill/>
          </a:ln>
        </p:spPr>
      </p:pic>
      <p:pic>
        <p:nvPicPr>
          <p:cNvPr id="405" name="テキスト ボックス 130" descr=""/>
          <p:cNvPicPr/>
          <p:nvPr/>
        </p:nvPicPr>
        <p:blipFill>
          <a:blip r:embed="rId29"/>
          <a:stretch/>
        </p:blipFill>
        <p:spPr>
          <a:xfrm>
            <a:off x="7827840" y="1925640"/>
            <a:ext cx="304920" cy="1012680"/>
          </a:xfrm>
          <a:prstGeom prst="rect">
            <a:avLst/>
          </a:prstGeom>
          <a:ln w="0">
            <a:noFill/>
          </a:ln>
        </p:spPr>
      </p:pic>
      <p:pic>
        <p:nvPicPr>
          <p:cNvPr id="406" name="テキスト ボックス 131" descr=""/>
          <p:cNvPicPr/>
          <p:nvPr/>
        </p:nvPicPr>
        <p:blipFill>
          <a:blip r:embed="rId30"/>
          <a:stretch/>
        </p:blipFill>
        <p:spPr>
          <a:xfrm>
            <a:off x="8053560" y="2084400"/>
            <a:ext cx="298440" cy="853920"/>
          </a:xfrm>
          <a:prstGeom prst="rect">
            <a:avLst/>
          </a:prstGeom>
          <a:ln w="0">
            <a:noFill/>
          </a:ln>
        </p:spPr>
      </p:pic>
      <p:sp>
        <p:nvSpPr>
          <p:cNvPr id="407" name="Rectangle 12"/>
          <p:cNvSpPr/>
          <p:nvPr/>
        </p:nvSpPr>
        <p:spPr>
          <a:xfrm>
            <a:off x="2233440" y="1909800"/>
            <a:ext cx="11559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ahoma"/>
                <a:ea typeface="MS Gothic"/>
              </a:rPr>
              <a:t>H460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08" name="テキスト ボックス 25" descr=""/>
          <p:cNvPicPr/>
          <p:nvPr/>
        </p:nvPicPr>
        <p:blipFill>
          <a:blip r:embed="rId31"/>
          <a:stretch/>
        </p:blipFill>
        <p:spPr>
          <a:xfrm>
            <a:off x="2408400" y="1994040"/>
            <a:ext cx="298440" cy="931680"/>
          </a:xfrm>
          <a:prstGeom prst="rect">
            <a:avLst/>
          </a:prstGeom>
          <a:ln w="0">
            <a:noFill/>
          </a:ln>
        </p:spPr>
      </p:pic>
      <p:pic>
        <p:nvPicPr>
          <p:cNvPr id="409" name="テキスト ボックス 81" descr=""/>
          <p:cNvPicPr/>
          <p:nvPr/>
        </p:nvPicPr>
        <p:blipFill>
          <a:blip r:embed="rId32"/>
          <a:stretch/>
        </p:blipFill>
        <p:spPr>
          <a:xfrm>
            <a:off x="2633760" y="1914480"/>
            <a:ext cx="304560" cy="1011240"/>
          </a:xfrm>
          <a:prstGeom prst="rect">
            <a:avLst/>
          </a:prstGeom>
          <a:ln w="0">
            <a:noFill/>
          </a:ln>
        </p:spPr>
      </p:pic>
      <p:pic>
        <p:nvPicPr>
          <p:cNvPr id="410" name="テキスト ボックス 27" descr=""/>
          <p:cNvPicPr/>
          <p:nvPr/>
        </p:nvPicPr>
        <p:blipFill>
          <a:blip r:embed="rId33"/>
          <a:stretch/>
        </p:blipFill>
        <p:spPr>
          <a:xfrm>
            <a:off x="2835360" y="2073240"/>
            <a:ext cx="304560" cy="852480"/>
          </a:xfrm>
          <a:prstGeom prst="rect">
            <a:avLst/>
          </a:prstGeom>
          <a:ln w="0">
            <a:noFill/>
          </a:ln>
        </p:spPr>
      </p:pic>
      <p:sp>
        <p:nvSpPr>
          <p:cNvPr id="411" name="Line 18"/>
          <p:cNvSpPr/>
          <p:nvPr/>
        </p:nvSpPr>
        <p:spPr>
          <a:xfrm>
            <a:off x="2523960" y="2262240"/>
            <a:ext cx="5796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12" name="Picture 2" descr=""/>
          <p:cNvPicPr/>
          <p:nvPr/>
        </p:nvPicPr>
        <p:blipFill>
          <a:blip r:embed="rId34">
            <a:grayscl/>
          </a:blip>
          <a:stretch/>
        </p:blipFill>
        <p:spPr>
          <a:xfrm>
            <a:off x="2411280" y="3070080"/>
            <a:ext cx="719280" cy="233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13" name="Picture 3" descr=""/>
          <p:cNvPicPr/>
          <p:nvPr/>
        </p:nvPicPr>
        <p:blipFill>
          <a:blip r:embed="rId35">
            <a:grayscl/>
          </a:blip>
          <a:stretch/>
        </p:blipFill>
        <p:spPr>
          <a:xfrm>
            <a:off x="2441520" y="3357720"/>
            <a:ext cx="720720" cy="241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14" name="Line 18"/>
          <p:cNvSpPr/>
          <p:nvPr/>
        </p:nvSpPr>
        <p:spPr>
          <a:xfrm>
            <a:off x="3579840" y="2259000"/>
            <a:ext cx="5792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正方形/長方形 1"/>
          <p:cNvSpPr/>
          <p:nvPr/>
        </p:nvSpPr>
        <p:spPr>
          <a:xfrm>
            <a:off x="1434600" y="28526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正方形/長方形 60"/>
          <p:cNvSpPr/>
          <p:nvPr/>
        </p:nvSpPr>
        <p:spPr>
          <a:xfrm>
            <a:off x="1694160" y="28526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正方形/長方形 61"/>
          <p:cNvSpPr/>
          <p:nvPr/>
        </p:nvSpPr>
        <p:spPr>
          <a:xfrm>
            <a:off x="3589560" y="28526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正方形/長方形 62"/>
          <p:cNvSpPr/>
          <p:nvPr/>
        </p:nvSpPr>
        <p:spPr>
          <a:xfrm>
            <a:off x="3805560" y="28526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正方形/長方形 63"/>
          <p:cNvSpPr/>
          <p:nvPr/>
        </p:nvSpPr>
        <p:spPr>
          <a:xfrm>
            <a:off x="4525200" y="28526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正方形/長方形 65"/>
          <p:cNvSpPr/>
          <p:nvPr/>
        </p:nvSpPr>
        <p:spPr>
          <a:xfrm>
            <a:off x="4814280" y="28526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正方形/長方形 66"/>
          <p:cNvSpPr/>
          <p:nvPr/>
        </p:nvSpPr>
        <p:spPr>
          <a:xfrm>
            <a:off x="5605560" y="28526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22" name=""/>
          <p:cNvGraphicFramePr/>
          <p:nvPr/>
        </p:nvGraphicFramePr>
        <p:xfrm>
          <a:off x="250920" y="620640"/>
          <a:ext cx="8713800" cy="5776920"/>
        </p:xfrm>
        <a:graphic>
          <a:graphicData uri="http://schemas.openxmlformats.org/drawingml/2006/table">
            <a:tbl>
              <a:tblPr/>
              <a:tblGrid>
                <a:gridCol w="2178000"/>
                <a:gridCol w="1015920"/>
                <a:gridCol w="1163520"/>
                <a:gridCol w="4356360"/>
              </a:tblGrid>
              <a:tr h="431640"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athway name</a:t>
                      </a: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(KEGG ID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ount (%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-Value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ene</a:t>
                      </a: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argets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5684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athway in cancer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7</a:t>
                      </a:r>
                      <a:r>
                        <a:rPr b="0" lang="ja-JP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(3.3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9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Mdm2, ARNT, CASP8, CCNA1, Cdk6, CDKN1A, CDKN1B, fgf1, fzd1, ITGA3, LAMA5, MAPK1, PIK3R2, Stat3, tcf7l1, TPM3, ETS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60228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ECM-receptor interaction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7 (1.4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2.8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ITGA3, CD44, LAMA5, SV2A, Thbs1, Thbs2, Thbs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9680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53 signaling pathway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6 (1.2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3.9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Mdm2, Mdm4, CASP8, Cdk6, CDKN1A, Thbs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45900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Melanoma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6 (1.2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4.6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Mdm2, Cdk6, CDKN1A, fgf1, MAPK1, PIK3R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60228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mTOR signaling pathway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5 (1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5.5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Ddit4, MAPK1, PIK3R2, Rps6ka3, Ulk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60264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hronic myeloid leukemia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6 (1.2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5.6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Mdm2, Cdk6, CDKN1A, CDKN1B, MAPK1, PIK3R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60552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ysteine and methionine metabolism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4 (0.8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6.7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O1, mat1a, mtaP, TRDMT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60264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cute myeloid leukemia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5 (1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7.6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CNA1, MAPK1, PIK3R2, Stat3, tcf7l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5900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lioma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5 (1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9.6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Mdm2, Cdk6, CDKN1A, MAPK1, PIK3R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45900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rostate cancer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6 (1.2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0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1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Mdm2, CDKN1A, CDKN1B, MAPK1, PIK3R2, tcf7l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23" name="テキスト ボックス 2"/>
          <p:cNvSpPr/>
          <p:nvPr/>
        </p:nvSpPr>
        <p:spPr>
          <a:xfrm>
            <a:off x="3599640" y="44280"/>
            <a:ext cx="2043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H1299</a:t>
            </a:r>
            <a:r>
              <a:rPr b="1" lang="ja-JP" sz="2000" spc="-1" strike="noStrike">
                <a:solidFill>
                  <a:srgbClr val="000000"/>
                </a:solidFill>
                <a:latin typeface="Tahoma"/>
                <a:ea typeface="MS Gothic"/>
              </a:rPr>
              <a:t> </a:t>
            </a: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miR-221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正方形/長方形 4"/>
          <p:cNvSpPr/>
          <p:nvPr/>
        </p:nvSpPr>
        <p:spPr>
          <a:xfrm>
            <a:off x="41400" y="0"/>
            <a:ext cx="247284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Table S1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25" name=""/>
          <p:cNvGraphicFramePr/>
          <p:nvPr/>
        </p:nvGraphicFramePr>
        <p:xfrm>
          <a:off x="250920" y="620640"/>
          <a:ext cx="8713800" cy="2446560"/>
        </p:xfrm>
        <a:graphic>
          <a:graphicData uri="http://schemas.openxmlformats.org/drawingml/2006/table">
            <a:tbl>
              <a:tblPr/>
              <a:tblGrid>
                <a:gridCol w="2178000"/>
                <a:gridCol w="1015920"/>
                <a:gridCol w="1163520"/>
                <a:gridCol w="4356360"/>
              </a:tblGrid>
              <a:tr h="431640"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athway name (KEGG ID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ount (%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-Value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ene</a:t>
                      </a: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argets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45684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Melanoma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7 (1.2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3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Fgf1, Fgf10, Fgf3, Fgf5, MET, PIK3CD, PIK3R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60264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xon guidance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9 (1.5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2.5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ROCK2, Cfl2, efna2, GNAI3, MET, Nfatc3, Pak2, ppp3ca, SEMA6B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9680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dherens junction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6 (1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6.0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Fer, MET, Pard3, PVRL1, PVRL2, ptpn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459000"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Regulation of actin cytoskeleton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1 (1.9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7.1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ROCK2, Cfl2, DIAPH2, Fgf1, Fgf10, Fgf3, Fgf5, ITGB2, Pak2, PIK3CD, PIK3R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26" name="テキスト ボックス 4"/>
          <p:cNvSpPr/>
          <p:nvPr/>
        </p:nvSpPr>
        <p:spPr>
          <a:xfrm>
            <a:off x="3599640" y="44280"/>
            <a:ext cx="2043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H1299</a:t>
            </a:r>
            <a:r>
              <a:rPr b="1" lang="ja-JP" sz="2000" spc="-1" strike="noStrike">
                <a:solidFill>
                  <a:srgbClr val="000000"/>
                </a:solidFill>
                <a:latin typeface="Tahoma"/>
                <a:ea typeface="MS Gothic"/>
              </a:rPr>
              <a:t> </a:t>
            </a: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miR-222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正方形/長方形 6"/>
          <p:cNvSpPr/>
          <p:nvPr/>
        </p:nvSpPr>
        <p:spPr>
          <a:xfrm>
            <a:off x="41400" y="0"/>
            <a:ext cx="247284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Table S2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28" name=""/>
          <p:cNvGraphicFramePr/>
          <p:nvPr/>
        </p:nvGraphicFramePr>
        <p:xfrm>
          <a:off x="179280" y="449280"/>
          <a:ext cx="8820360" cy="6251400"/>
        </p:xfrm>
        <a:graphic>
          <a:graphicData uri="http://schemas.openxmlformats.org/drawingml/2006/table">
            <a:tbl>
              <a:tblPr/>
              <a:tblGrid>
                <a:gridCol w="2206800"/>
                <a:gridCol w="1028520"/>
                <a:gridCol w="1175040"/>
                <a:gridCol w="4410000"/>
              </a:tblGrid>
              <a:tr h="284040"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athway name (KEGG ID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ount (%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-Value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ene</a:t>
                      </a: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argets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0069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ytokine-cytokine receptor interaction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55 (4.1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5.1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11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40, Cd70, Fas, Acvrl1, bmp2, CCL2, CCL20, CCL23, CCL26, CCL5, CCR1, CXCL1, CXCL16, CXCL2, CXCL3, CXCL6, csf1, EPO, FLT3LG, Hgf, INHBA, INHBE, Ifna10, Ifna16, Ifna17, Ifna2, Ifna4, Ifna6, IFNB1, Ifne, IFNW1, Il1r1, IL1R2, IL10RA, IL18, il2rb, Il20rb, IL22RA1, IL23A, IL28B, IL29, Il3, IL4R, IL6, IL7R, IL8, LIF, LTB, TNF, TNFSF10, TNFSF13B, Tnfsf14, TNFRSF8, TNFRSF9, VEGFA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7009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ntigen processing and presentation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24 (1.8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9.0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9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B2M, CTSS, HSPA1A, HSPA1B, Ifna10, Ifna16, Ifna17, Ifna2, Ifna4, Ifna6, ifi30, HLA-A, HLA-E, HLA-F, HLA-DMB, HLA-DOB, HLA-dpa1, HLA-DQA2, HLA-DQB1, LOC100133583, HLA-DRA, PSME1, PSME2, LOC652614, tap1, TAP2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54900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utoimmune thyroid disease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8 (1.3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2.4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7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40, Fas, Ifna10, , Ifna16, Ifna17, Ifna2, Ifna4, Ifna6, HLA-A, HLA-E, HLA-F, HLA-DMB, HLA-DOB, KLA-dpa1, HLA-DQA2, HLA-DQB1, LOC100133583, HLA-DRA, LOC652614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45720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ytosolic DNA-sensing pathway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8 (1.3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8.3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7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DDX58, AIM2, Adar, CASP1, CCL5, IRF7, Ifna10, , Ifna16, Ifna17, Ifna2, Ifna4, Ifna6, IFNB1, IL18, IL6, NFKBIA, RIPK3, trex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8384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RIG-I-like receptor signaling pathway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20 (1.5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2.2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6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DDX58, dhx58, ISG15, TRAF3, CASP8, IFIH1, IRF7, Ifna10, Ifna16, Ifna17, Ifna2, Ifna4, Ifna6, IFNB1, Ifne, IFNW1, IL8, NFKBIA, TRIM25, TNF 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54900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Jak-STAT signaling pathway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31 (2.3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5.1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6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Jak2, CCND3, EPO, IRF9, Ifna10, Ifna16, Ifna17, Ifna2, Ifna4, Ifna6, IFNB1, Ifne, IFNW1, IL10RA, il2rb, Il20rb, IL22RA1, IL23A, IL28B, IL29, Il3, IL4R, IL6, IL7R, LIF, PIK3CD, STAT1, STAT2, STAT4, Socs1, Socs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60444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oll-like receptor signaling pathway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23 (1.7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4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5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40, TRAF3, CASP8, CCL5, IRF7, Ifna10, IFNA16, IFNA17, Ifna2, IFNA4, IFNA6, IFNB1, Tab1, NFKBIA, PIK3CD, STAT1, TLR1, TLR3, TICAM1, IL6, IL8, Jun, TNF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45684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llograft rejection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3 (1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5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5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40, Fas, HLA-A, HLA-E, HLA-F, HLA-DMB, HLA-DOB, HLA-dpa1,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LA-DQA2, HLA-DQB1, LOC100133583, HLA-DRA, LOC652614, TNF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70128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ell adhesion molecules (CAMs)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27 (2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6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5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274, CD40, CD58, Cdh15, Cldn8, Alcam, LOC100133690, ICOSLG, ITGA4, itga6, Itgav, ITGB8, HLA-A, HLA-E, HLA-F, HLA-DMB, HLA-DOB, hla-dpa1, HLA-DQA2, HLA-DQB1, LOC100133583, HLA-DRA, NEO1, nrcam, PVRL2, Pdcd1, PDCD1LG2, LOC652614, SDC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45684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raft-versus-host disease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3 (1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3.7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5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Fas, IL6, HLA-A, HLA-E, HLA-F, HLA-DMB, HLA-DOB, hla-dpa1, HLA-DQA2, HLA-DQB1, LOC100133583, HLA-DRA, LOC652614, TNF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29" name="テキスト ボックス 4"/>
          <p:cNvSpPr/>
          <p:nvPr/>
        </p:nvSpPr>
        <p:spPr>
          <a:xfrm>
            <a:off x="3533760" y="4680"/>
            <a:ext cx="2428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H3255</a:t>
            </a:r>
            <a:r>
              <a:rPr b="1" lang="ja-JP" sz="2000" spc="-1" strike="noStrike">
                <a:solidFill>
                  <a:srgbClr val="000000"/>
                </a:solidFill>
                <a:latin typeface="Tahoma"/>
                <a:ea typeface="MS Gothic"/>
              </a:rPr>
              <a:t> </a:t>
            </a: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miR-221 (1)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正方形/長方形 6"/>
          <p:cNvSpPr/>
          <p:nvPr/>
        </p:nvSpPr>
        <p:spPr>
          <a:xfrm>
            <a:off x="41400" y="0"/>
            <a:ext cx="247284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Table S3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1" name=""/>
          <p:cNvGraphicFramePr/>
          <p:nvPr/>
        </p:nvGraphicFramePr>
        <p:xfrm>
          <a:off x="179280" y="476280"/>
          <a:ext cx="8820360" cy="6027840"/>
        </p:xfrm>
        <a:graphic>
          <a:graphicData uri="http://schemas.openxmlformats.org/drawingml/2006/table">
            <a:tbl>
              <a:tblPr/>
              <a:tblGrid>
                <a:gridCol w="2224080"/>
                <a:gridCol w="1011240"/>
                <a:gridCol w="1175040"/>
                <a:gridCol w="4410000"/>
              </a:tblGrid>
              <a:tr h="431640"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athway name (KEGG ID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ount (%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-Value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ene</a:t>
                      </a: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argets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0508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ype I diabetes mellitus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3 (1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8.4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5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Fas, Gad1, HLA-A, HLA-E, HLA-F, HLA-DMB, HLA-DOB, hla-dpa1, HLA-DQA2, HLA-DQB1, LOC100133583, HLA-DRA, LOC652614, TNF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60300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NOD-like receptor signaling pathway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5 (1.1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3.5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4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BIRC3, CASP1, CASP8, Ccl2, CCL5, CXCL1, CXCL2, IL18, IL6, IL8, Tab1, NFKBIA, RIPK2, TNF, TNFAIP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9716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ematopoietic cell lineage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7 (1.3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3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3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36, CD44, csf1, EPO, FLT3LG, ITGA4, ITGA5, itga6, Il1r1, IL1R2, Il3, IL4R, IL6, IL7R, HLA-DRA, TFRC, TNF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45720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Intestinal immune network for IgA production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3 (0.9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6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3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40, ICOSLG, ITGA4, IL6, HLA-DMB, HLA-DOB, HLA-dpa1, HLA-DQA2, HLA-DQB1, LOC100133583, HLA-DRA, MAP3K14, TNFSF13B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60300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sthma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9 (0.7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7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3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40,Il3, HLA-DMB, HLA-DOB, hla-dpa1, HLA-DQA2, HLA-DQB1, LOC100133583, HLA-DRA, TNF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64764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Viral myocarditis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4 (1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4.2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3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40, CASP8, HLA-A, HLA-E, HLA-F, HLA-DMB, HLA-DOB, HLA-dpa1, HLA-DQA2, HLA-DQB1, LOC100133583, HLA-DRA, Myh3, LOC652614, abl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85428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athways in cancer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41 (3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5.5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3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Fas,NKX3-1, SMAD2, SMAD3, Traf1, TRAF3, APC, BIRC3, bmp2, CASP8, COL4A4, Ccne2, CDKN1B, egln3, FGF2, FGF8, FGFR2, fn1, FLT3LG, fzd5, Hhip, Hgf, IGF1R, itga6, Itgav, IL6, IL8, Jun, LAMA3, Lamb3, Mmp1, NFKBIA, Ppard, PIK3CD, LOC652346, PML, RXRG, STAT1, SPI1, TGFA, VEGFA, WNT10A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51444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ECM-receptor interaction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4 (1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7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36, CD44, COL4A4, fn1, ITGA4, ITGA5, itga6, Itgav, ITGB8, LAMA3, Lamb3, SDC2, TNC, thbs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5720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Small cell lung cancer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4 (1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7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raf1, TRAF3, BIRC3, COL4A4, Ccne2, CDKN1B, fn1, itga6, Itgav, LAMA3, Lamb3, NFKBIA, PIK3CD, RXRG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45720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BC transporters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9 (0.7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2.4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BCA1, ABCA3, ABCA6, ABCA8, ABCB4, ABCC4, ABCG2, TAP1, TAP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32" name="テキスト ボックス 6"/>
          <p:cNvSpPr/>
          <p:nvPr/>
        </p:nvSpPr>
        <p:spPr>
          <a:xfrm>
            <a:off x="3533760" y="76320"/>
            <a:ext cx="2428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H3255</a:t>
            </a:r>
            <a:r>
              <a:rPr b="1" lang="ja-JP" sz="2000" spc="-1" strike="noStrike">
                <a:solidFill>
                  <a:srgbClr val="000000"/>
                </a:solidFill>
                <a:latin typeface="Tahoma"/>
                <a:ea typeface="MS Gothic"/>
              </a:rPr>
              <a:t> </a:t>
            </a: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miR-221 (2)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テキスト ボックス 3"/>
          <p:cNvSpPr/>
          <p:nvPr/>
        </p:nvSpPr>
        <p:spPr>
          <a:xfrm>
            <a:off x="2517120" y="-6480"/>
            <a:ext cx="877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MS Gothic"/>
              </a:rPr>
              <a:t>Cont’d.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正方形/長方形 4"/>
          <p:cNvSpPr/>
          <p:nvPr/>
        </p:nvSpPr>
        <p:spPr>
          <a:xfrm>
            <a:off x="41400" y="0"/>
            <a:ext cx="247284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Table S3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" name="グループ化 15"/>
          <p:cNvGrpSpPr/>
          <p:nvPr/>
        </p:nvGrpSpPr>
        <p:grpSpPr>
          <a:xfrm>
            <a:off x="4645080" y="692280"/>
            <a:ext cx="3456000" cy="2792160"/>
            <a:chOff x="4645080" y="692280"/>
            <a:chExt cx="3456000" cy="2792160"/>
          </a:xfrm>
        </p:grpSpPr>
        <p:pic>
          <p:nvPicPr>
            <p:cNvPr id="60" name="Picture 12" descr="C:\Users\owner\Downloads\Desktop\130929 miR221 miR222 画像\HBEC4　miR221-3p　100倍.tif"/>
            <p:cNvPicPr/>
            <p:nvPr/>
          </p:nvPicPr>
          <p:blipFill>
            <a:blip r:embed="rId1"/>
            <a:stretch/>
          </p:blipFill>
          <p:spPr>
            <a:xfrm>
              <a:off x="4704840" y="927720"/>
              <a:ext cx="3396240" cy="2556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テキスト ボックス 15"/>
            <p:cNvSpPr/>
            <p:nvPr/>
          </p:nvSpPr>
          <p:spPr>
            <a:xfrm>
              <a:off x="4645080" y="692280"/>
              <a:ext cx="1222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ahoma"/>
                </a:rPr>
                <a:t>miR-221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2" name="グループ化 14"/>
          <p:cNvGrpSpPr/>
          <p:nvPr/>
        </p:nvGrpSpPr>
        <p:grpSpPr>
          <a:xfrm>
            <a:off x="614520" y="692280"/>
            <a:ext cx="3463920" cy="2792160"/>
            <a:chOff x="614520" y="692280"/>
            <a:chExt cx="3463920" cy="2792160"/>
          </a:xfrm>
        </p:grpSpPr>
        <p:pic>
          <p:nvPicPr>
            <p:cNvPr id="63" name="Picture 14" descr="C:\Users\owner\Downloads\Desktop\130929 miR221 miR222 画像\HBEC4　miR NC　100倍.tif"/>
            <p:cNvPicPr/>
            <p:nvPr/>
          </p:nvPicPr>
          <p:blipFill>
            <a:blip r:embed="rId2"/>
            <a:stretch/>
          </p:blipFill>
          <p:spPr>
            <a:xfrm>
              <a:off x="683280" y="927720"/>
              <a:ext cx="3395160" cy="2556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テキスト ボックス 15"/>
            <p:cNvSpPr/>
            <p:nvPr/>
          </p:nvSpPr>
          <p:spPr>
            <a:xfrm>
              <a:off x="614520" y="692280"/>
              <a:ext cx="12207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ahoma"/>
                </a:rPr>
                <a:t>miR-NC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5" name="グループ化 16"/>
          <p:cNvGrpSpPr/>
          <p:nvPr/>
        </p:nvGrpSpPr>
        <p:grpSpPr>
          <a:xfrm>
            <a:off x="4646520" y="3716280"/>
            <a:ext cx="3463920" cy="2792520"/>
            <a:chOff x="4646520" y="3716280"/>
            <a:chExt cx="3463920" cy="2792520"/>
          </a:xfrm>
        </p:grpSpPr>
        <p:pic>
          <p:nvPicPr>
            <p:cNvPr id="66" name="Picture 13" descr="C:\Users\owner\Downloads\Desktop\130929 miR221 miR222 画像\HBEC4　miR222-3p　100倍.tif"/>
            <p:cNvPicPr/>
            <p:nvPr/>
          </p:nvPicPr>
          <p:blipFill>
            <a:blip r:embed="rId3"/>
            <a:stretch/>
          </p:blipFill>
          <p:spPr>
            <a:xfrm>
              <a:off x="4716720" y="3951720"/>
              <a:ext cx="3393720" cy="2557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7" name="テキスト ボックス 15"/>
            <p:cNvSpPr/>
            <p:nvPr/>
          </p:nvSpPr>
          <p:spPr>
            <a:xfrm>
              <a:off x="4646520" y="3716280"/>
              <a:ext cx="12218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ahoma"/>
                </a:rPr>
                <a:t>miR-222</a:t>
              </a:r>
              <a:endParaRPr b="1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cxnSp>
        <p:nvCxnSpPr>
          <p:cNvPr id="68" name="直線矢印コネクタ 12"/>
          <p:cNvCxnSpPr/>
          <p:nvPr/>
        </p:nvCxnSpPr>
        <p:spPr>
          <a:xfrm>
            <a:off x="5003640" y="1483920"/>
            <a:ext cx="145440" cy="14472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69" name="直線矢印コネクタ 13"/>
          <p:cNvCxnSpPr/>
          <p:nvPr/>
        </p:nvCxnSpPr>
        <p:spPr>
          <a:xfrm>
            <a:off x="5364000" y="2636640"/>
            <a:ext cx="145440" cy="14472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70" name="直線矢印コネクタ 14"/>
          <p:cNvCxnSpPr/>
          <p:nvPr/>
        </p:nvCxnSpPr>
        <p:spPr>
          <a:xfrm>
            <a:off x="6084360" y="2276280"/>
            <a:ext cx="143640" cy="14472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71" name="直線矢印コネクタ 15"/>
          <p:cNvCxnSpPr/>
          <p:nvPr/>
        </p:nvCxnSpPr>
        <p:spPr>
          <a:xfrm>
            <a:off x="7235640" y="1341000"/>
            <a:ext cx="144720" cy="14364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72" name="直線矢印コネクタ 16"/>
          <p:cNvCxnSpPr/>
          <p:nvPr/>
        </p:nvCxnSpPr>
        <p:spPr>
          <a:xfrm>
            <a:off x="6227640" y="1989000"/>
            <a:ext cx="145440" cy="14544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73" name="直線矢印コネクタ 17"/>
          <p:cNvCxnSpPr/>
          <p:nvPr/>
        </p:nvCxnSpPr>
        <p:spPr>
          <a:xfrm>
            <a:off x="6732360" y="4436640"/>
            <a:ext cx="143640" cy="14472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74" name="直線矢印コネクタ 18"/>
          <p:cNvCxnSpPr/>
          <p:nvPr/>
        </p:nvCxnSpPr>
        <p:spPr>
          <a:xfrm>
            <a:off x="5724000" y="4724280"/>
            <a:ext cx="143640" cy="14544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75" name="直線矢印コネクタ 19"/>
          <p:cNvCxnSpPr/>
          <p:nvPr/>
        </p:nvCxnSpPr>
        <p:spPr>
          <a:xfrm>
            <a:off x="5508360" y="6092640"/>
            <a:ext cx="143640" cy="14472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76" name="直線矢印コネクタ 20"/>
          <p:cNvCxnSpPr/>
          <p:nvPr/>
        </p:nvCxnSpPr>
        <p:spPr>
          <a:xfrm>
            <a:off x="6372000" y="5949720"/>
            <a:ext cx="144720" cy="14364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cxnSp>
        <p:nvCxnSpPr>
          <p:cNvPr id="77" name="直線矢印コネクタ 21"/>
          <p:cNvCxnSpPr/>
          <p:nvPr/>
        </p:nvCxnSpPr>
        <p:spPr>
          <a:xfrm>
            <a:off x="7451640" y="4508280"/>
            <a:ext cx="145440" cy="144720"/>
          </a:xfrm>
          <a:prstGeom prst="straightConnector1">
            <a:avLst/>
          </a:prstGeom>
          <a:ln w="2556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78" name="正方形/長方形 5"/>
          <p:cNvSpPr/>
          <p:nvPr/>
        </p:nvSpPr>
        <p:spPr>
          <a:xfrm>
            <a:off x="38520" y="0"/>
            <a:ext cx="256896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Figure S2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5" name=""/>
          <p:cNvGraphicFramePr/>
          <p:nvPr/>
        </p:nvGraphicFramePr>
        <p:xfrm>
          <a:off x="108000" y="692280"/>
          <a:ext cx="8891640" cy="4279680"/>
        </p:xfrm>
        <a:graphic>
          <a:graphicData uri="http://schemas.openxmlformats.org/drawingml/2006/table">
            <a:tbl>
              <a:tblPr/>
              <a:tblGrid>
                <a:gridCol w="2241360"/>
                <a:gridCol w="1019160"/>
                <a:gridCol w="1148040"/>
                <a:gridCol w="4483080"/>
              </a:tblGrid>
              <a:tr h="431640"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athway name (KEGG ID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ount (%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-Value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ene</a:t>
                      </a: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argets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7636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Sphingolipid metabolism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8 (0.6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3.6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UGT8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ERK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DEGS1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ALC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PAP2A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Sptlc2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NEU2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SGPP2</a:t>
                      </a:r>
                      <a:r>
                        <a:rPr b="0" lang="ja-JP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5047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53 signaling pathway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1 (0.8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4.7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Fas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ASP8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CND3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cne2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cng1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ADD45A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MAIP1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SESN1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SESN3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SHISA5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zmat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57960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Epithelial cell signaling in </a:t>
                      </a:r>
                      <a:r>
                        <a:rPr b="0" i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elicobacter pylori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infection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1 (0.8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4.7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TP6V1G3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TP6V1C2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TP6v1b1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IT1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CL5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XCL1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BEGF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IL8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Jun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MAP3K14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NFKBIA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57780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omplement and coagulation cascades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1 (0.8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5.1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46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F2R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F3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1r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1s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4BPA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FB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LAUR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serpind1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3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LOC100133511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LOC653879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HBD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0656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Systemic lupus erythematosus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4 (1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5.7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40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1r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1s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1h2ad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1H3A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1H3B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1H3C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1H3D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1H3E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1H3F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1h3g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1H3H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1h3i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1H3J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2H3A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2h3c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2H3D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2H2AA3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IST2H2AA4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LA-DMB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LA-DOB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la-dpa1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LA-DQA2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LA-DQB1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LOC100133583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LA-DRA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3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LOC100133511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LOC653879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RIM21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NF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60300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poptosis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2 (0.9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9.4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FLAR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Fas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BIRC3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asp7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ASP8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Il1r1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Il3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MAP3K14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NFKBIA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IK3CD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　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NF,</a:t>
                      </a:r>
                      <a:r>
                        <a:rPr b="0" lang="ja-JP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NFSF10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36" name="テキスト ボックス 4"/>
          <p:cNvSpPr/>
          <p:nvPr/>
        </p:nvSpPr>
        <p:spPr>
          <a:xfrm>
            <a:off x="3533760" y="44280"/>
            <a:ext cx="2428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H3255</a:t>
            </a:r>
            <a:r>
              <a:rPr b="1" lang="ja-JP" sz="2000" spc="-1" strike="noStrike">
                <a:solidFill>
                  <a:srgbClr val="000000"/>
                </a:solidFill>
                <a:latin typeface="Tahoma"/>
                <a:ea typeface="MS Gothic"/>
              </a:rPr>
              <a:t> </a:t>
            </a: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miR-221 (3)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テキスト ボックス 7"/>
          <p:cNvSpPr/>
          <p:nvPr/>
        </p:nvSpPr>
        <p:spPr>
          <a:xfrm>
            <a:off x="2517120" y="-6480"/>
            <a:ext cx="877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MS Gothic"/>
              </a:rPr>
              <a:t>Cont’d.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正方形/長方形 8"/>
          <p:cNvSpPr/>
          <p:nvPr/>
        </p:nvSpPr>
        <p:spPr>
          <a:xfrm>
            <a:off x="41400" y="0"/>
            <a:ext cx="247284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Table S3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39" name=""/>
          <p:cNvGraphicFramePr/>
          <p:nvPr/>
        </p:nvGraphicFramePr>
        <p:xfrm>
          <a:off x="250920" y="404640"/>
          <a:ext cx="8569080" cy="6210360"/>
        </p:xfrm>
        <a:graphic>
          <a:graphicData uri="http://schemas.openxmlformats.org/drawingml/2006/table">
            <a:tbl>
              <a:tblPr/>
              <a:tblGrid>
                <a:gridCol w="2305080"/>
                <a:gridCol w="1079280"/>
                <a:gridCol w="900360"/>
                <a:gridCol w="4284360"/>
              </a:tblGrid>
              <a:tr h="449280"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athway name (KEGG ID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ount (%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-Value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ene</a:t>
                      </a: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argets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6955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ntigen processing and presentation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8 (1.7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7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5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B2M, CTSS, HSPA5, LOC400750, Ifna10, IFNA17, IFNA4, HLA-A, HLA-E, HLA-F,HLA-DOB, hla-dpa1, HLA-DRA, hla-drb1, HLA-DRB4, RFX5, LOC652614, hla-dqa1, LOC100133678, tap1, TAP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57636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utoimmune thyroid disease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2 (1.1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3.3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4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Ifna10, IFNA17, IFNA4, HLA-A, HLA-E, HLA-F, HLA-DOB, hla-dpa1, HLA-DRA, hla-drb1, HLA-DRB4, LOC652614, hla-dqa1, LOC100133678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50472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raft-versus-host disease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0 (0.9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6.8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4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IL6, HLA-A, HLA-E, HLA-F, HLA-DOB, hla-dpa1, HLA-DRA, hla-drb1, HLA-DRB4, LOC652614, hla-dqa1, LOC100133678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701640"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ell adhesion molecules (CAMs) 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20 (1.9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7.7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4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274, CLDN1, CLDN23, Cldn8, Alcam, LOC100133690, Itgav, ITGB8, HLA-A, HLA-E, HLA-F, HLA-DOB, hla-dpa1, HLA-DRA, hla-drb1, HLA-DRB4, NEO1, nrcam, SIGLEC1, LOC652614, hla-dqa1, LOC100133678, SDC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62712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ype I diabetes mellitus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0 (0.9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2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3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ad1, HLA-A, HLA-E, HLA-F,HLA-DOB, hla-dpa1, HLA-DRA, hla-drb1, HLA-DRB4, LOC652614, hla-dqa1, LOC100133678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52380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omplement and coagulation cascades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3 (1.2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4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3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46, F2R, C1r,C1s, C4BPA, C5, C5ar1, CFB, PLAUR, SERPINA1, C3, LOC100133511, LOC653879, THBD, TFPI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70164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ytokine-cytokine receptor interaction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31 (2.9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5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3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70, RELT, AMHR2, bmp2, CCL20, CCL26, CCL5, CCR7, CXCL1, CXCL2, Cxcl3, Flt4, INHBA, Ifna10, IFNA17, IFNA4, IFNB1, IL1R2, il2rb, il20ra, IL22RA1, IL23A, IL28B, IL29, IL6, IL7R, IL8, TNFSF10, TNFSF13B, TNFRSF9, VEGFC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45720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llograft rejection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9 (0.8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8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3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LA-A, HLA-E, HLA-F, HLA-DOB, hla-dpa1 ,HLA-DRA, hla-drb1, HLA-DRB4, LOC652614, hla-dqa1, LOC100133678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51588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ytosolic DNA-sensing pathway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1 (1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2.5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3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DDX58, AIM2, CASP1, CCL5, IRF7, Ifna10, IFNA17, IFNA4, IFNB1, IL6, NFKBIA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45720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RIG-I-like receptor signaling pathway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2 (1.1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5.5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3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DDX58, dhx58, ISG15, CYLD, IFIH1, IRF7, Ifna10, IFNA17, IFNA4, IFNB1, IL8, NFKBIA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40" name="テキスト ボックス 6"/>
          <p:cNvSpPr/>
          <p:nvPr/>
        </p:nvSpPr>
        <p:spPr>
          <a:xfrm>
            <a:off x="3533760" y="4680"/>
            <a:ext cx="2428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H3255</a:t>
            </a:r>
            <a:r>
              <a:rPr b="1" lang="ja-JP" sz="2000" spc="-1" strike="noStrike">
                <a:solidFill>
                  <a:srgbClr val="000000"/>
                </a:solidFill>
                <a:latin typeface="Tahoma"/>
                <a:ea typeface="MS Gothic"/>
              </a:rPr>
              <a:t> </a:t>
            </a: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miR-222 (1)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正方形/長方形 4"/>
          <p:cNvSpPr/>
          <p:nvPr/>
        </p:nvSpPr>
        <p:spPr>
          <a:xfrm>
            <a:off x="41400" y="0"/>
            <a:ext cx="247284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Table S4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2" name=""/>
          <p:cNvGraphicFramePr/>
          <p:nvPr/>
        </p:nvGraphicFramePr>
        <p:xfrm>
          <a:off x="179280" y="620640"/>
          <a:ext cx="8820360" cy="5716800"/>
        </p:xfrm>
        <a:graphic>
          <a:graphicData uri="http://schemas.openxmlformats.org/drawingml/2006/table">
            <a:tbl>
              <a:tblPr/>
              <a:tblGrid>
                <a:gridCol w="2206800"/>
                <a:gridCol w="1028520"/>
                <a:gridCol w="1175040"/>
                <a:gridCol w="4410000"/>
              </a:tblGrid>
              <a:tr h="284400"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athway name (KEGG ID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ount (%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-Value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ene</a:t>
                      </a: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argets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8104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oll-like receptor signaling pathway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4 (1.3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.3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CL5, IRF7, Ifna10, IFNA17, IFNA4, IFNB1, IL6, IL8, LY96, MAP3K8, NFKBIA, STAT1, TLR3, Ticam2, tmed7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70164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athways in cancer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32 (3.0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2.0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NKX3-1, Skp2, SMAD2, appl1, APC, BIRC3, bmp2, COL4A4, DAPK2, dapk3, DVL3, fgf13, FGFR2, fgfr3, fn1, FZD4, fzd5, Hhip, IGF1R, Itgav, IL6, IL8, LAMA3, LAMC2, Mmp1, NRAS, NFKBIA, LOC652346, PML, PIAS2, STAT1, VEGFC, WNT5A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52380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O-Glycan biosynthesis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6 (0.6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4.2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ALNT10, galnt11, GALNT1, GALNT13, GALNT2, GALNTL1, Wbscr17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45720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NOD-like receptor signaling pathway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9 (0.8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4.6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BIRC3, CASP1, CCL5, CXCL1, CXCL2, IL6, IL8, NFKBIA, TNFAIP3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7772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Bladder cancer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7 (0.6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5.2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DAPK2, dapk3, fgfr3, IL8, Mmp1, NRAS, VEGFC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85428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Systemic lupus erythematosus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2 (1.1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5.5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1r, C1s, C5, Hist1h2ag, Hist1h2ah, Hist1h2ai, Hist1h2ak, HIST1H2AL, HIST1H2AM, Hist1h2ad, HIST1H3A, HIST1H3B, HIST1H3C, HIST1H3D, HIST1H3E, HIST1H3F, hist1h3g, HIST1H3H, Hist1h3i, HIST1H3J, HIST2H3A, hist2h3c, HIST2H3D, HLA-DOB,hla-dpa1, HLA-DRA, C3, LOC100133511, LOC653879, hla-dqa1, LOC100133678, TRIM2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5720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BC transporters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7 (0.6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6.3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ABCA1, abca4, ABCB4, abcc4, Abcg2, tap1, TAP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45720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Jak-STAT signaling pathway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6 (1.5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7.6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IRF9, Ifna10, IFNA17, IFNA4, IFNB1, il2rb, il20ra, IL22RA1, IL23A, IL28B, IL29, IL6, IL7R, PIAS2, LOC344593, LOC442113, PTPN11, STAT1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46512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Viral myocarditis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9 (0.8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8.7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HLA-A, HLA-E, HLA-F, HLA-DOB, hla-dpa1, HLA-DRA, hla-drb1, HLA-DRB4, LOC652614, hla-dqa1, LOC100133678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7e7e7"/>
                    </a:solidFill>
                  </a:tcPr>
                </a:tc>
              </a:tr>
              <a:tr h="45720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ECM-receptor interaction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10 (0.9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9.3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D36, COL4A4, Col5a2, fn1, HMMR, Itgav, ITGB8, LAMA3, LAMC2, SDC2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43" name="テキスト ボックス 4"/>
          <p:cNvSpPr/>
          <p:nvPr/>
        </p:nvSpPr>
        <p:spPr>
          <a:xfrm>
            <a:off x="3678120" y="76320"/>
            <a:ext cx="2428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H3255</a:t>
            </a:r>
            <a:r>
              <a:rPr b="1" lang="ja-JP" sz="2000" spc="-1" strike="noStrike">
                <a:solidFill>
                  <a:srgbClr val="000000"/>
                </a:solidFill>
                <a:latin typeface="Tahoma"/>
                <a:ea typeface="MS Gothic"/>
              </a:rPr>
              <a:t> </a:t>
            </a: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miR-222 (2)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テキスト ボックス 5"/>
          <p:cNvSpPr/>
          <p:nvPr/>
        </p:nvSpPr>
        <p:spPr>
          <a:xfrm>
            <a:off x="2517120" y="-6480"/>
            <a:ext cx="877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MS Gothic"/>
              </a:rPr>
              <a:t>Cont’d.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正方形/長方形 6"/>
          <p:cNvSpPr/>
          <p:nvPr/>
        </p:nvSpPr>
        <p:spPr>
          <a:xfrm>
            <a:off x="41400" y="0"/>
            <a:ext cx="247284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Table S4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6" name=""/>
          <p:cNvGraphicFramePr/>
          <p:nvPr/>
        </p:nvGraphicFramePr>
        <p:xfrm>
          <a:off x="179280" y="723960"/>
          <a:ext cx="8640720" cy="833400"/>
        </p:xfrm>
        <a:graphic>
          <a:graphicData uri="http://schemas.openxmlformats.org/drawingml/2006/table">
            <a:tbl>
              <a:tblPr/>
              <a:tblGrid>
                <a:gridCol w="2160720"/>
                <a:gridCol w="1009800"/>
                <a:gridCol w="1150920"/>
                <a:gridCol w="4319280"/>
              </a:tblGrid>
              <a:tr h="284040"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athway name (KEGG ID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Count (%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P-Value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Gene</a:t>
                      </a:r>
                      <a:r>
                        <a:rPr b="1" lang="ja-JP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 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targets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549360">
                <a:tc>
                  <a:txBody>
                    <a:bodyPr lIns="9360" rIns="9360" tIns="93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Intestinal immune network for IgA production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360" marR="936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7 (0.6)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9.5×10</a:t>
                      </a:r>
                      <a:r>
                        <a:rPr b="0" lang="en-US" sz="1200" spc="-1" strike="noStrike" baseline="30000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-2</a:t>
                      </a: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  <a:tc>
                  <a:txBody>
                    <a:bodyPr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ahoma"/>
                          <a:ea typeface="MS Gothic"/>
                        </a:rPr>
                        <a:t>IL6, HLA-DOB, hla-dpa1, HLA-DRA, hla-drb1, HLA-DRB4, hla-dqa1, LOC100133678, TNFSF13B</a:t>
                      </a: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1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 w="1224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solidFill>
                      <a:srgbClr val="e7e7e7"/>
                    </a:solidFill>
                  </a:tcPr>
                </a:tc>
              </a:tr>
            </a:tbl>
          </a:graphicData>
        </a:graphic>
      </p:graphicFrame>
      <p:sp>
        <p:nvSpPr>
          <p:cNvPr id="447" name="テキスト ボックス 4"/>
          <p:cNvSpPr/>
          <p:nvPr/>
        </p:nvSpPr>
        <p:spPr>
          <a:xfrm>
            <a:off x="3606840" y="149400"/>
            <a:ext cx="2428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H3255</a:t>
            </a:r>
            <a:r>
              <a:rPr b="1" lang="ja-JP" sz="2000" spc="-1" strike="noStrike">
                <a:solidFill>
                  <a:srgbClr val="000000"/>
                </a:solidFill>
                <a:latin typeface="Tahoma"/>
                <a:ea typeface="MS Gothic"/>
              </a:rPr>
              <a:t> </a:t>
            </a:r>
            <a:r>
              <a:rPr b="1" lang="en-US" sz="2000" spc="-1" strike="noStrike">
                <a:solidFill>
                  <a:srgbClr val="000000"/>
                </a:solidFill>
                <a:latin typeface="Tahoma"/>
                <a:ea typeface="MS Gothic"/>
              </a:rPr>
              <a:t>miR-222 (3)</a:t>
            </a:r>
            <a:endParaRPr b="1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テキスト ボックス 5"/>
          <p:cNvSpPr/>
          <p:nvPr/>
        </p:nvSpPr>
        <p:spPr>
          <a:xfrm>
            <a:off x="2517120" y="-6480"/>
            <a:ext cx="877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MS Gothic"/>
              </a:rPr>
              <a:t>Cont’d.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正方形/長方形 6"/>
          <p:cNvSpPr/>
          <p:nvPr/>
        </p:nvSpPr>
        <p:spPr>
          <a:xfrm>
            <a:off x="41400" y="0"/>
            <a:ext cx="247284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Table S4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テキスト ボックス 2"/>
          <p:cNvSpPr/>
          <p:nvPr/>
        </p:nvSpPr>
        <p:spPr>
          <a:xfrm>
            <a:off x="2382840" y="2421000"/>
            <a:ext cx="2260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ahoma"/>
                <a:ea typeface="Tahoma"/>
              </a:rPr>
              <a:t>E-CADHERIN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テキスト ボックス 4"/>
          <p:cNvSpPr/>
          <p:nvPr/>
        </p:nvSpPr>
        <p:spPr>
          <a:xfrm>
            <a:off x="2325600" y="3121200"/>
            <a:ext cx="2751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ahoma"/>
                <a:ea typeface="Tahoma"/>
              </a:rPr>
              <a:t>SIP1</a:t>
            </a:r>
            <a:r>
              <a:rPr b="1" lang="ja-JP" sz="1400" spc="-1" strike="noStrike">
                <a:solidFill>
                  <a:srgbClr val="000000"/>
                </a:solidFill>
                <a:latin typeface="Tahoma"/>
                <a:ea typeface="Tahoma"/>
              </a:rPr>
              <a:t>（</a:t>
            </a:r>
            <a:r>
              <a:rPr b="1" lang="en-US" sz="1400" spc="-1" strike="noStrike">
                <a:solidFill>
                  <a:srgbClr val="000000"/>
                </a:solidFill>
                <a:latin typeface="Tahoma"/>
                <a:ea typeface="Tahoma"/>
              </a:rPr>
              <a:t>ZEB2</a:t>
            </a:r>
            <a:r>
              <a:rPr b="1" lang="ja-JP" sz="1400" spc="-1" strike="noStrike">
                <a:solidFill>
                  <a:srgbClr val="000000"/>
                </a:solidFill>
                <a:latin typeface="Tahoma"/>
                <a:ea typeface="Tahoma"/>
              </a:rPr>
              <a:t>）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テキスト ボックス 6"/>
          <p:cNvSpPr/>
          <p:nvPr/>
        </p:nvSpPr>
        <p:spPr>
          <a:xfrm>
            <a:off x="3132000" y="4365720"/>
            <a:ext cx="136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ahoma"/>
                <a:ea typeface="Tahoma"/>
              </a:rPr>
              <a:t>ACTIN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テキスト ボックス 9"/>
          <p:cNvSpPr/>
          <p:nvPr/>
        </p:nvSpPr>
        <p:spPr>
          <a:xfrm>
            <a:off x="3059280" y="3755880"/>
            <a:ext cx="1512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ahoma"/>
                <a:ea typeface="Tahoma"/>
              </a:rPr>
              <a:t>SLUG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Picture 4" descr="C:\Users\與語直之\Desktop\Dropbox\その他\基礎\画像\HBEC4 miR221・miR222導入後western blot\2014年8月\HBEC4 (miR221・miR222・NC) actin.jpg"/>
          <p:cNvPicPr/>
          <p:nvPr/>
        </p:nvPicPr>
        <p:blipFill>
          <a:blip r:embed="rId1"/>
          <a:srcRect l="3103" t="0" r="4949" b="0"/>
          <a:stretch/>
        </p:blipFill>
        <p:spPr>
          <a:xfrm>
            <a:off x="4255920" y="4292640"/>
            <a:ext cx="1684440" cy="504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4" name="Picture 5" descr="C:\Users\與語直之\Desktop\Dropbox\その他\基礎\画像\HBEC4 miR221・miR222導入後western blot\2014年8月\HBEC4 (miR221・miR222・NC) Slug.jpg"/>
          <p:cNvPicPr/>
          <p:nvPr/>
        </p:nvPicPr>
        <p:blipFill>
          <a:blip r:embed="rId2"/>
          <a:srcRect l="0" t="0" r="0" b="10786"/>
          <a:stretch/>
        </p:blipFill>
        <p:spPr>
          <a:xfrm>
            <a:off x="4265640" y="3645000"/>
            <a:ext cx="1655640" cy="563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5" name="Picture 2" descr="C:\Users\與語直之\Desktop\Dropbox\その他\基礎\画像\HBEC4 miR221・miR222導入後western blot\2014年8月\HBEC4 E-cadherin miR221・miR222・NC.jpg"/>
          <p:cNvPicPr/>
          <p:nvPr/>
        </p:nvPicPr>
        <p:blipFill>
          <a:blip r:embed="rId3"/>
          <a:stretch/>
        </p:blipFill>
        <p:spPr>
          <a:xfrm>
            <a:off x="4235400" y="2278080"/>
            <a:ext cx="1655640" cy="574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6" name="Picture 4" descr="C:\Users\與語直之\Desktop\Dropbox\その他\基礎\画像\HBEC4 miR221・miR222導入後western blot\2014年8月\HBEC4 SIP1 miR221・miR222・NC001.jpg"/>
          <p:cNvPicPr/>
          <p:nvPr/>
        </p:nvPicPr>
        <p:blipFill>
          <a:blip r:embed="rId4"/>
          <a:stretch/>
        </p:blipFill>
        <p:spPr>
          <a:xfrm>
            <a:off x="4257720" y="2997360"/>
            <a:ext cx="1677960" cy="552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7" name="テキスト ボックス 25" descr=""/>
          <p:cNvPicPr/>
          <p:nvPr/>
        </p:nvPicPr>
        <p:blipFill>
          <a:blip r:embed="rId5"/>
          <a:stretch/>
        </p:blipFill>
        <p:spPr>
          <a:xfrm>
            <a:off x="4340160" y="1268280"/>
            <a:ext cx="354240" cy="951120"/>
          </a:xfrm>
          <a:prstGeom prst="rect">
            <a:avLst/>
          </a:prstGeom>
          <a:ln w="0">
            <a:noFill/>
          </a:ln>
        </p:spPr>
      </p:pic>
      <p:pic>
        <p:nvPicPr>
          <p:cNvPr id="88" name="テキスト ボックス 18" descr=""/>
          <p:cNvPicPr/>
          <p:nvPr/>
        </p:nvPicPr>
        <p:blipFill>
          <a:blip r:embed="rId6"/>
          <a:stretch/>
        </p:blipFill>
        <p:spPr>
          <a:xfrm>
            <a:off x="4816440" y="1195560"/>
            <a:ext cx="352440" cy="1029960"/>
          </a:xfrm>
          <a:prstGeom prst="rect">
            <a:avLst/>
          </a:prstGeom>
          <a:ln w="0">
            <a:noFill/>
          </a:ln>
        </p:spPr>
      </p:pic>
      <p:pic>
        <p:nvPicPr>
          <p:cNvPr id="89" name="テキスト ボックス 27" descr=""/>
          <p:cNvPicPr/>
          <p:nvPr/>
        </p:nvPicPr>
        <p:blipFill>
          <a:blip r:embed="rId7"/>
          <a:stretch/>
        </p:blipFill>
        <p:spPr>
          <a:xfrm>
            <a:off x="5364000" y="1347840"/>
            <a:ext cx="354240" cy="871560"/>
          </a:xfrm>
          <a:prstGeom prst="rect">
            <a:avLst/>
          </a:prstGeom>
          <a:ln w="0">
            <a:noFill/>
          </a:ln>
        </p:spPr>
      </p:pic>
      <p:sp>
        <p:nvSpPr>
          <p:cNvPr id="90" name="Line 18"/>
          <p:cNvSpPr/>
          <p:nvPr/>
        </p:nvSpPr>
        <p:spPr>
          <a:xfrm>
            <a:off x="4356000" y="1557360"/>
            <a:ext cx="12956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12"/>
          <p:cNvSpPr/>
          <p:nvPr/>
        </p:nvSpPr>
        <p:spPr>
          <a:xfrm>
            <a:off x="4357800" y="1197000"/>
            <a:ext cx="129384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ahoma"/>
                <a:ea typeface="MS Gothic"/>
              </a:rPr>
              <a:t>HBEC4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正方形/長方形 5"/>
          <p:cNvSpPr/>
          <p:nvPr/>
        </p:nvSpPr>
        <p:spPr>
          <a:xfrm>
            <a:off x="38520" y="0"/>
            <a:ext cx="256896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Figure S3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直線コネクタ 40"/>
          <p:cNvSpPr/>
          <p:nvPr/>
        </p:nvSpPr>
        <p:spPr>
          <a:xfrm>
            <a:off x="-73080" y="3284640"/>
            <a:ext cx="8602560" cy="0"/>
          </a:xfrm>
          <a:prstGeom prst="line">
            <a:avLst/>
          </a:prstGeom>
          <a:ln w="93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76"/>
          <p:cNvSpPr/>
          <p:nvPr/>
        </p:nvSpPr>
        <p:spPr>
          <a:xfrm>
            <a:off x="3511440" y="625320"/>
            <a:ext cx="542880" cy="21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mbria"/>
                <a:ea typeface="MS Gothic"/>
              </a:rPr>
              <a:t>E-CADHERIN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直線コネクタ 67"/>
          <p:cNvSpPr/>
          <p:nvPr/>
        </p:nvSpPr>
        <p:spPr>
          <a:xfrm>
            <a:off x="146160" y="404640"/>
            <a:ext cx="8602560" cy="0"/>
          </a:xfrm>
          <a:prstGeom prst="line">
            <a:avLst/>
          </a:prstGeom>
          <a:ln w="9360">
            <a:solidFill>
              <a:srgbClr val="00206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75"/>
          <p:cNvSpPr/>
          <p:nvPr/>
        </p:nvSpPr>
        <p:spPr>
          <a:xfrm>
            <a:off x="2408400" y="3500280"/>
            <a:ext cx="599760" cy="13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mbria"/>
                <a:ea typeface="MS Gothic"/>
              </a:rPr>
              <a:t>DAPI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76"/>
          <p:cNvSpPr/>
          <p:nvPr/>
        </p:nvSpPr>
        <p:spPr>
          <a:xfrm>
            <a:off x="3511440" y="3452760"/>
            <a:ext cx="509760" cy="27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mbria"/>
                <a:ea typeface="MS Gothic"/>
              </a:rPr>
              <a:t>VIMENTIN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77"/>
          <p:cNvSpPr/>
          <p:nvPr/>
        </p:nvSpPr>
        <p:spPr>
          <a:xfrm>
            <a:off x="1366920" y="3516480"/>
            <a:ext cx="600120" cy="8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5640" bIns="35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mbria"/>
                <a:ea typeface="MS Gothic"/>
              </a:rPr>
              <a:t>Actin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76"/>
          <p:cNvSpPr/>
          <p:nvPr/>
        </p:nvSpPr>
        <p:spPr>
          <a:xfrm>
            <a:off x="4552920" y="3541680"/>
            <a:ext cx="509760" cy="82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5640" bIns="3564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mbria"/>
                <a:ea typeface="MS Gothic"/>
              </a:rPr>
              <a:t>Merged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0" name="グループ化 65"/>
          <p:cNvGrpSpPr/>
          <p:nvPr/>
        </p:nvGrpSpPr>
        <p:grpSpPr>
          <a:xfrm>
            <a:off x="-42840" y="438120"/>
            <a:ext cx="5105520" cy="2298240"/>
            <a:chOff x="-42840" y="438120"/>
            <a:chExt cx="5105520" cy="2298240"/>
          </a:xfrm>
        </p:grpSpPr>
        <p:sp>
          <p:nvSpPr>
            <p:cNvPr id="101" name="テキスト ボックス 38"/>
            <p:cNvSpPr/>
            <p:nvPr/>
          </p:nvSpPr>
          <p:spPr>
            <a:xfrm>
              <a:off x="14400" y="1123920"/>
              <a:ext cx="83772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miR-221</a:t>
              </a:r>
              <a:endParaRPr b="1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テキスト ボックス 43"/>
            <p:cNvSpPr/>
            <p:nvPr/>
          </p:nvSpPr>
          <p:spPr>
            <a:xfrm>
              <a:off x="19800" y="1795680"/>
              <a:ext cx="83772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miR-222</a:t>
              </a:r>
              <a:endParaRPr b="1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テキスト ボックス 48"/>
            <p:cNvSpPr/>
            <p:nvPr/>
          </p:nvSpPr>
          <p:spPr>
            <a:xfrm>
              <a:off x="36720" y="2444400"/>
              <a:ext cx="793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miR-NC</a:t>
              </a:r>
              <a:endParaRPr b="1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テキスト ボックス 35"/>
            <p:cNvSpPr/>
            <p:nvPr/>
          </p:nvSpPr>
          <p:spPr>
            <a:xfrm>
              <a:off x="-42840" y="438120"/>
              <a:ext cx="129564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BEC4</a:t>
              </a:r>
              <a:endParaRPr b="1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75"/>
            <p:cNvSpPr/>
            <p:nvPr/>
          </p:nvSpPr>
          <p:spPr>
            <a:xfrm>
              <a:off x="2420640" y="662760"/>
              <a:ext cx="600120" cy="13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mbria"/>
                  <a:ea typeface="MS Gothic"/>
                </a:rPr>
                <a:t>DAPI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77"/>
            <p:cNvSpPr/>
            <p:nvPr/>
          </p:nvSpPr>
          <p:spPr>
            <a:xfrm>
              <a:off x="1379160" y="681480"/>
              <a:ext cx="600120" cy="82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5640" bIns="35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mbria"/>
                  <a:ea typeface="MS Gothic"/>
                </a:rPr>
                <a:t>Actin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76"/>
            <p:cNvSpPr/>
            <p:nvPr/>
          </p:nvSpPr>
          <p:spPr>
            <a:xfrm>
              <a:off x="4553280" y="686520"/>
              <a:ext cx="509400" cy="82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5640" bIns="35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mbria"/>
                  <a:ea typeface="MS Gothic"/>
                </a:rPr>
                <a:t>Merged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8" name="グループ化 56"/>
          <p:cNvGrpSpPr/>
          <p:nvPr/>
        </p:nvGrpSpPr>
        <p:grpSpPr>
          <a:xfrm>
            <a:off x="-13680" y="3500280"/>
            <a:ext cx="1080720" cy="2109600"/>
            <a:chOff x="-13680" y="3500280"/>
            <a:chExt cx="1080720" cy="2109600"/>
          </a:xfrm>
        </p:grpSpPr>
        <p:sp>
          <p:nvSpPr>
            <p:cNvPr id="109" name="テキスト ボックス 22"/>
            <p:cNvSpPr/>
            <p:nvPr/>
          </p:nvSpPr>
          <p:spPr>
            <a:xfrm>
              <a:off x="31680" y="4094280"/>
              <a:ext cx="83772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miR-221</a:t>
              </a:r>
              <a:endParaRPr b="1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テキスト ボックス 27"/>
            <p:cNvSpPr/>
            <p:nvPr/>
          </p:nvSpPr>
          <p:spPr>
            <a:xfrm>
              <a:off x="-2880" y="4681800"/>
              <a:ext cx="83772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miR-222</a:t>
              </a:r>
              <a:endParaRPr b="1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テキスト ボックス 32"/>
            <p:cNvSpPr/>
            <p:nvPr/>
          </p:nvSpPr>
          <p:spPr>
            <a:xfrm>
              <a:off x="14400" y="5317920"/>
              <a:ext cx="793440" cy="291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miR-NC</a:t>
              </a:r>
              <a:endParaRPr b="1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テキスト ボックス 35"/>
            <p:cNvSpPr/>
            <p:nvPr/>
          </p:nvSpPr>
          <p:spPr>
            <a:xfrm>
              <a:off x="-13680" y="3500280"/>
              <a:ext cx="10807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BEC4</a:t>
              </a:r>
              <a:endParaRPr b="1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13" name="Picture 6" descr="C:\Users\owner\Downloads\Desktop\リバイス実験\HBEC4 免疫染色　E-cad VIM\2014.9.29 HBEC4（B）免疫染色　山下\2014.9.29 HBEC4 B Ecad 免疫染色　山下\HBEC4 miR　221  （B） 統合 1　200倍.tif"/>
          <p:cNvPicPr/>
          <p:nvPr/>
        </p:nvPicPr>
        <p:blipFill>
          <a:blip r:embed="rId1"/>
          <a:stretch/>
        </p:blipFill>
        <p:spPr>
          <a:xfrm>
            <a:off x="4322880" y="922320"/>
            <a:ext cx="976320" cy="735120"/>
          </a:xfrm>
          <a:prstGeom prst="rect">
            <a:avLst/>
          </a:prstGeom>
          <a:ln w="0">
            <a:noFill/>
          </a:ln>
        </p:spPr>
      </p:pic>
      <p:pic>
        <p:nvPicPr>
          <p:cNvPr id="114" name="Picture 7" descr="C:\Users\owner\Downloads\Desktop\リバイス実験\HBEC4 免疫染色　E-cad VIM\2014.9.29 HBEC4（B）免疫染色　山下\2014.9.29 HBEC4 B Ecad 免疫染色　山下\HBEC4 miR　221 （B） DAPI 1　200倍.tif"/>
          <p:cNvPicPr/>
          <p:nvPr/>
        </p:nvPicPr>
        <p:blipFill>
          <a:blip r:embed="rId2"/>
          <a:stretch/>
        </p:blipFill>
        <p:spPr>
          <a:xfrm>
            <a:off x="2232000" y="907920"/>
            <a:ext cx="974880" cy="735120"/>
          </a:xfrm>
          <a:prstGeom prst="rect">
            <a:avLst/>
          </a:prstGeom>
          <a:ln w="0">
            <a:noFill/>
          </a:ln>
        </p:spPr>
      </p:pic>
      <p:pic>
        <p:nvPicPr>
          <p:cNvPr id="115" name="Picture 8" descr="C:\Users\owner\Downloads\Desktop\リバイス実験\HBEC4 免疫染色　E-cad VIM\2014.9.29 HBEC4（B）免疫染色　山下\2014.9.29 HBEC4 B Ecad 免疫染色　山下\HBEC4 miR　221  （B） Actin 1　200倍.tif"/>
          <p:cNvPicPr/>
          <p:nvPr/>
        </p:nvPicPr>
        <p:blipFill>
          <a:blip r:embed="rId3"/>
          <a:stretch/>
        </p:blipFill>
        <p:spPr>
          <a:xfrm>
            <a:off x="1190520" y="907920"/>
            <a:ext cx="974880" cy="735120"/>
          </a:xfrm>
          <a:prstGeom prst="rect">
            <a:avLst/>
          </a:prstGeom>
          <a:ln w="0">
            <a:noFill/>
          </a:ln>
        </p:spPr>
      </p:pic>
      <p:pic>
        <p:nvPicPr>
          <p:cNvPr id="116" name="Picture 9" descr="C:\Users\owner\Downloads\Desktop\リバイス実験\HBEC4 免疫染色　E-cad VIM\2014.9.29 HBEC4（B）免疫染色　山下\2014.9.29 HBEC4 B Ecad 免疫染色　山下\HBEC4 miR　221  （B） E-cad 1　200倍.tif"/>
          <p:cNvPicPr/>
          <p:nvPr/>
        </p:nvPicPr>
        <p:blipFill>
          <a:blip r:embed="rId4"/>
          <a:stretch/>
        </p:blipFill>
        <p:spPr>
          <a:xfrm>
            <a:off x="3284640" y="922320"/>
            <a:ext cx="974520" cy="735120"/>
          </a:xfrm>
          <a:prstGeom prst="rect">
            <a:avLst/>
          </a:prstGeom>
          <a:ln w="0">
            <a:noFill/>
          </a:ln>
        </p:spPr>
      </p:pic>
      <p:pic>
        <p:nvPicPr>
          <p:cNvPr id="117" name="Picture 14" descr="C:\Users\owner\Downloads\Desktop\リバイス実験\HBEC4 免疫染色　E-cad VIM\2014.9.29 HBEC4（B）免疫染色　山下\2014.9.29 HBEC4 B Ecad 免疫染色　山下\HBEC4 miR　222 （B） DAPI 3　200倍.tif"/>
          <p:cNvPicPr/>
          <p:nvPr/>
        </p:nvPicPr>
        <p:blipFill>
          <a:blip r:embed="rId5"/>
          <a:stretch/>
        </p:blipFill>
        <p:spPr>
          <a:xfrm>
            <a:off x="2219400" y="1682640"/>
            <a:ext cx="976320" cy="73512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15" descr="C:\Users\owner\Downloads\Desktop\リバイス実験\HBEC4 免疫染色　E-cad VIM\2014.9.29 HBEC4（B）免疫染色　山下\2014.9.29 HBEC4 B Ecad 免疫染色　山下\HBEC4 miR　222 （B） E-cad 3　200倍.tif"/>
          <p:cNvPicPr/>
          <p:nvPr/>
        </p:nvPicPr>
        <p:blipFill>
          <a:blip r:embed="rId6"/>
          <a:stretch/>
        </p:blipFill>
        <p:spPr>
          <a:xfrm>
            <a:off x="3287880" y="1687680"/>
            <a:ext cx="976320" cy="733320"/>
          </a:xfrm>
          <a:prstGeom prst="rect">
            <a:avLst/>
          </a:prstGeom>
          <a:ln w="0">
            <a:noFill/>
          </a:ln>
        </p:spPr>
      </p:pic>
      <p:pic>
        <p:nvPicPr>
          <p:cNvPr id="119" name="Picture 16" descr="C:\Users\owner\Downloads\Desktop\リバイス実験\HBEC4 免疫染色　E-cad VIM\2014.9.29 HBEC4（B）免疫染色　山下\2014.9.29 HBEC4 B Ecad 免疫染色　山下\HBEC4 miR　222  （B） Actin 3　200倍.tif"/>
          <p:cNvPicPr/>
          <p:nvPr/>
        </p:nvPicPr>
        <p:blipFill>
          <a:blip r:embed="rId7"/>
          <a:stretch/>
        </p:blipFill>
        <p:spPr>
          <a:xfrm>
            <a:off x="1174680" y="1687680"/>
            <a:ext cx="974880" cy="733320"/>
          </a:xfrm>
          <a:prstGeom prst="rect">
            <a:avLst/>
          </a:prstGeom>
          <a:ln w="0">
            <a:noFill/>
          </a:ln>
        </p:spPr>
      </p:pic>
      <p:pic>
        <p:nvPicPr>
          <p:cNvPr id="120" name="Picture 17" descr="C:\Users\owner\Downloads\Desktop\リバイス実験\HBEC4 免疫染色　E-cad VIM\2014.9.29 HBEC4（B）免疫染色　山下\2014.9.29 HBEC4 B Ecad 免疫染色　山下\HBEC4 miR　222  （B） 統合 3　200倍.tif"/>
          <p:cNvPicPr/>
          <p:nvPr/>
        </p:nvPicPr>
        <p:blipFill>
          <a:blip r:embed="rId8"/>
          <a:stretch/>
        </p:blipFill>
        <p:spPr>
          <a:xfrm>
            <a:off x="4322880" y="1687680"/>
            <a:ext cx="976320" cy="733320"/>
          </a:xfrm>
          <a:prstGeom prst="rect">
            <a:avLst/>
          </a:prstGeom>
          <a:ln w="0">
            <a:noFill/>
          </a:ln>
        </p:spPr>
      </p:pic>
      <p:pic>
        <p:nvPicPr>
          <p:cNvPr id="121" name="Picture 22" descr="C:\Users\owner\Downloads\Desktop\リバイス実験\HBEC4 免疫染色　E-cad VIM\2014.9.29 HBEC4（B）免疫染色　山下\2014.9.29 HBEC4 B Ecad 免疫染色　山下\HBEC4 miR　NC （B） 統合 1　200倍.tif"/>
          <p:cNvPicPr/>
          <p:nvPr/>
        </p:nvPicPr>
        <p:blipFill>
          <a:blip r:embed="rId9"/>
          <a:stretch/>
        </p:blipFill>
        <p:spPr>
          <a:xfrm>
            <a:off x="4334040" y="2465280"/>
            <a:ext cx="974520" cy="735120"/>
          </a:xfrm>
          <a:prstGeom prst="rect">
            <a:avLst/>
          </a:prstGeom>
          <a:ln w="0">
            <a:noFill/>
          </a:ln>
        </p:spPr>
      </p:pic>
      <p:pic>
        <p:nvPicPr>
          <p:cNvPr id="122" name="Picture 23" descr="C:\Users\owner\Downloads\Desktop\リバイス実験\HBEC4 免疫染色　E-cad VIM\2014.9.29 HBEC4（B）免疫染色　山下\2014.9.29 HBEC4 B Ecad 免疫染色　山下\HBEC4 miR　NC （B） Actin 1　200倍.tif"/>
          <p:cNvPicPr/>
          <p:nvPr/>
        </p:nvPicPr>
        <p:blipFill>
          <a:blip r:embed="rId10"/>
          <a:stretch/>
        </p:blipFill>
        <p:spPr>
          <a:xfrm>
            <a:off x="1185840" y="2465280"/>
            <a:ext cx="976320" cy="735120"/>
          </a:xfrm>
          <a:prstGeom prst="rect">
            <a:avLst/>
          </a:prstGeom>
          <a:ln w="0">
            <a:noFill/>
          </a:ln>
        </p:spPr>
      </p:pic>
      <p:pic>
        <p:nvPicPr>
          <p:cNvPr id="123" name="Picture 24" descr="C:\Users\owner\Downloads\Desktop\リバイス実験\HBEC4 免疫染色　E-cad VIM\2014.9.29 HBEC4（B）免疫染色　山下\2014.9.29 HBEC4 B Ecad 免疫染色　山下\HBEC4 miR　NC （B） DAPI 1　200倍.tif"/>
          <p:cNvPicPr/>
          <p:nvPr/>
        </p:nvPicPr>
        <p:blipFill>
          <a:blip r:embed="rId11"/>
          <a:stretch/>
        </p:blipFill>
        <p:spPr>
          <a:xfrm>
            <a:off x="2232000" y="2492280"/>
            <a:ext cx="974880" cy="735120"/>
          </a:xfrm>
          <a:prstGeom prst="rect">
            <a:avLst/>
          </a:prstGeom>
          <a:ln w="0">
            <a:noFill/>
          </a:ln>
        </p:spPr>
      </p:pic>
      <p:pic>
        <p:nvPicPr>
          <p:cNvPr id="124" name="Picture 25" descr="C:\Users\owner\Downloads\Desktop\リバイス実験\HBEC4 免疫染色　E-cad VIM\2014.9.29 HBEC4（B）免疫染色　山下\2014.9.29 HBEC4 B Ecad 免疫染色　山下\HBEC4 miR　NC （B） E-cad 1　200倍.tif"/>
          <p:cNvPicPr/>
          <p:nvPr/>
        </p:nvPicPr>
        <p:blipFill>
          <a:blip r:embed="rId12"/>
          <a:stretch/>
        </p:blipFill>
        <p:spPr>
          <a:xfrm>
            <a:off x="3287880" y="2465280"/>
            <a:ext cx="976320" cy="735120"/>
          </a:xfrm>
          <a:prstGeom prst="rect">
            <a:avLst/>
          </a:prstGeom>
          <a:ln w="0">
            <a:noFill/>
          </a:ln>
        </p:spPr>
      </p:pic>
      <p:pic>
        <p:nvPicPr>
          <p:cNvPr id="125" name="Picture 2" descr="C:\Users\owner\Downloads\Desktop\リバイス実験\HBEC4 免疫染色　E-cad VIM\2014.10.2HBEC4（C）免疫染色　山下\2014.9.29 HBEC4 C vim 免疫染色　山下\(vim)HBEC4 miR　221 （c） vim 2　200倍.tif"/>
          <p:cNvPicPr/>
          <p:nvPr/>
        </p:nvPicPr>
        <p:blipFill>
          <a:blip r:embed="rId13"/>
          <a:stretch/>
        </p:blipFill>
        <p:spPr>
          <a:xfrm>
            <a:off x="3284640" y="3816360"/>
            <a:ext cx="974520" cy="735120"/>
          </a:xfrm>
          <a:prstGeom prst="rect">
            <a:avLst/>
          </a:prstGeom>
          <a:ln w="0">
            <a:noFill/>
          </a:ln>
        </p:spPr>
      </p:pic>
      <p:pic>
        <p:nvPicPr>
          <p:cNvPr id="126" name="Picture 4" descr="C:\Users\owner\Downloads\Desktop\リバイス実験\HBEC4 免疫染色　E-cad VIM\2014.10.2HBEC4（C）免疫染色　山下\2014.9.29 HBEC4 C vim 免疫染色　山下\2(vim)HBEC4 miR　221 （c） DAPI 　200倍.tif"/>
          <p:cNvPicPr/>
          <p:nvPr/>
        </p:nvPicPr>
        <p:blipFill>
          <a:blip r:embed="rId14"/>
          <a:stretch/>
        </p:blipFill>
        <p:spPr>
          <a:xfrm>
            <a:off x="2232000" y="3805200"/>
            <a:ext cx="974880" cy="735120"/>
          </a:xfrm>
          <a:prstGeom prst="rect">
            <a:avLst/>
          </a:prstGeom>
          <a:ln w="0">
            <a:noFill/>
          </a:ln>
        </p:spPr>
      </p:pic>
      <p:pic>
        <p:nvPicPr>
          <p:cNvPr id="127" name="Picture 5" descr="C:\Users\owner\Downloads\Desktop\リバイス実験\HBEC4 免疫染色　E-cad VIM\2014.10.2HBEC4（C）免疫染色　山下\2014.9.29 HBEC4 C vim 免疫染色　山下\(vim)HBEC4 miR　221 （c） Actin 2　200倍.tif"/>
          <p:cNvPicPr/>
          <p:nvPr/>
        </p:nvPicPr>
        <p:blipFill>
          <a:blip r:embed="rId15"/>
          <a:stretch/>
        </p:blipFill>
        <p:spPr>
          <a:xfrm>
            <a:off x="1166760" y="3789360"/>
            <a:ext cx="976320" cy="733320"/>
          </a:xfrm>
          <a:prstGeom prst="rect">
            <a:avLst/>
          </a:prstGeom>
          <a:ln w="0">
            <a:noFill/>
          </a:ln>
        </p:spPr>
      </p:pic>
      <p:pic>
        <p:nvPicPr>
          <p:cNvPr id="128" name="Picture 7" descr="C:\Users\owner\Downloads\Desktop\リバイス実験\HBEC4 免疫染色　E-cad VIM\2014.10.2HBEC4（C）免疫染色　山下\2014.9.29 HBEC4 C vim 免疫染色　山下\(vim)HBEC4 miR　221 （c） 統合2　200倍.tif"/>
          <p:cNvPicPr/>
          <p:nvPr/>
        </p:nvPicPr>
        <p:blipFill>
          <a:blip r:embed="rId16"/>
          <a:stretch/>
        </p:blipFill>
        <p:spPr>
          <a:xfrm>
            <a:off x="4340160" y="3816360"/>
            <a:ext cx="976320" cy="735120"/>
          </a:xfrm>
          <a:prstGeom prst="rect">
            <a:avLst/>
          </a:prstGeom>
          <a:ln w="0">
            <a:noFill/>
          </a:ln>
        </p:spPr>
      </p:pic>
      <p:pic>
        <p:nvPicPr>
          <p:cNvPr id="129" name="Picture 8" descr="C:\Users\owner\Downloads\Desktop\リバイス実験\HBEC4 免疫染色　E-cad VIM\2014.10.2HBEC4（C）免疫染色　山下\2014.9.29 HBEC4 C vim 免疫染色　山下\(vim)HBEC4 miR　222 （c） 統合１　200倍.tif"/>
          <p:cNvPicPr/>
          <p:nvPr/>
        </p:nvPicPr>
        <p:blipFill>
          <a:blip r:embed="rId17"/>
          <a:stretch/>
        </p:blipFill>
        <p:spPr>
          <a:xfrm>
            <a:off x="4334040" y="4608360"/>
            <a:ext cx="974520" cy="735120"/>
          </a:xfrm>
          <a:prstGeom prst="rect">
            <a:avLst/>
          </a:prstGeom>
          <a:ln w="0">
            <a:noFill/>
          </a:ln>
        </p:spPr>
      </p:pic>
      <p:pic>
        <p:nvPicPr>
          <p:cNvPr id="130" name="Picture 9" descr="C:\Users\owner\Downloads\Desktop\リバイス実験\HBEC4 免疫染色　E-cad VIM\2014.10.2HBEC4（C）免疫染色　山下\2014.9.29 HBEC4 C vim 免疫染色　山下\(vim)HBEC4 miR　222 （c） Actin 1　200倍.tif"/>
          <p:cNvPicPr/>
          <p:nvPr/>
        </p:nvPicPr>
        <p:blipFill>
          <a:blip r:embed="rId18"/>
          <a:stretch/>
        </p:blipFill>
        <p:spPr>
          <a:xfrm>
            <a:off x="1165320" y="4581360"/>
            <a:ext cx="974520" cy="733680"/>
          </a:xfrm>
          <a:prstGeom prst="rect">
            <a:avLst/>
          </a:prstGeom>
          <a:ln w="0">
            <a:noFill/>
          </a:ln>
        </p:spPr>
      </p:pic>
      <p:pic>
        <p:nvPicPr>
          <p:cNvPr id="131" name="Picture 10" descr="C:\Users\owner\Downloads\Desktop\リバイス実験\HBEC4 免疫染色　E-cad VIM\2014.10.2HBEC4（C）免疫染色　山下\2014.9.29 HBEC4 C vim 免疫染色　山下\(vim)HBEC4 miR　222 （c） DAPI 1　200倍.tif"/>
          <p:cNvPicPr/>
          <p:nvPr/>
        </p:nvPicPr>
        <p:blipFill>
          <a:blip r:embed="rId19"/>
          <a:stretch/>
        </p:blipFill>
        <p:spPr>
          <a:xfrm>
            <a:off x="2220840" y="4594320"/>
            <a:ext cx="976320" cy="734760"/>
          </a:xfrm>
          <a:prstGeom prst="rect">
            <a:avLst/>
          </a:prstGeom>
          <a:ln w="0">
            <a:noFill/>
          </a:ln>
        </p:spPr>
      </p:pic>
      <p:pic>
        <p:nvPicPr>
          <p:cNvPr id="132" name="Picture 11" descr="C:\Users\owner\Downloads\Desktop\リバイス実験\HBEC4 免疫染色　E-cad VIM\2014.10.2HBEC4（C）免疫染色　山下\2014.9.29 HBEC4 C vim 免疫染色　山下\(vim)HBEC4 miR　222 （c） vim 1　200倍.tif"/>
          <p:cNvPicPr/>
          <p:nvPr/>
        </p:nvPicPr>
        <p:blipFill>
          <a:blip r:embed="rId20"/>
          <a:stretch/>
        </p:blipFill>
        <p:spPr>
          <a:xfrm>
            <a:off x="3284640" y="4594320"/>
            <a:ext cx="974520" cy="734760"/>
          </a:xfrm>
          <a:prstGeom prst="rect">
            <a:avLst/>
          </a:prstGeom>
          <a:ln w="0">
            <a:noFill/>
          </a:ln>
        </p:spPr>
      </p:pic>
      <p:pic>
        <p:nvPicPr>
          <p:cNvPr id="133" name="Picture 12" descr="C:\Users\owner\Downloads\Desktop\リバイス実験\HBEC4 免疫染色　E-cad VIM\2014.10.2HBEC4（C）免疫染色　山下\2014.9.29 HBEC4 C vim 免疫染色　山下\(vim)HBEC4 miR　NC （c） DAPI 3　200倍.tif"/>
          <p:cNvPicPr/>
          <p:nvPr/>
        </p:nvPicPr>
        <p:blipFill>
          <a:blip r:embed="rId21"/>
          <a:stretch/>
        </p:blipFill>
        <p:spPr>
          <a:xfrm>
            <a:off x="2227320" y="5373720"/>
            <a:ext cx="974520" cy="733320"/>
          </a:xfrm>
          <a:prstGeom prst="rect">
            <a:avLst/>
          </a:prstGeom>
          <a:ln w="0">
            <a:noFill/>
          </a:ln>
        </p:spPr>
      </p:pic>
      <p:pic>
        <p:nvPicPr>
          <p:cNvPr id="134" name="Picture 13" descr="C:\Users\owner\Downloads\Desktop\リバイス実験\HBEC4 免疫染色　E-cad VIM\2014.10.2HBEC4（C）免疫染色　山下\2014.9.29 HBEC4 C vim 免疫染色　山下\(vim)HBEC4 miR　NC （c） vim3　200倍.tif"/>
          <p:cNvPicPr/>
          <p:nvPr/>
        </p:nvPicPr>
        <p:blipFill>
          <a:blip r:embed="rId22"/>
          <a:stretch/>
        </p:blipFill>
        <p:spPr>
          <a:xfrm>
            <a:off x="3284640" y="5378400"/>
            <a:ext cx="976320" cy="735120"/>
          </a:xfrm>
          <a:prstGeom prst="rect">
            <a:avLst/>
          </a:prstGeom>
          <a:ln w="0">
            <a:noFill/>
          </a:ln>
        </p:spPr>
      </p:pic>
      <p:pic>
        <p:nvPicPr>
          <p:cNvPr id="135" name="Picture 14" descr="C:\Users\owner\Downloads\Desktop\リバイス実験\HBEC4 免疫染色　E-cad VIM\2014.10.2HBEC4（C）免疫染色　山下\2014.9.29 HBEC4 C vim 免疫染色　山下\(vim)HBEC4 miR　NC （c） 統合3　200倍.tif"/>
          <p:cNvPicPr/>
          <p:nvPr/>
        </p:nvPicPr>
        <p:blipFill>
          <a:blip r:embed="rId23"/>
          <a:stretch/>
        </p:blipFill>
        <p:spPr>
          <a:xfrm>
            <a:off x="4340160" y="5373720"/>
            <a:ext cx="976320" cy="733320"/>
          </a:xfrm>
          <a:prstGeom prst="rect">
            <a:avLst/>
          </a:prstGeom>
          <a:ln w="0">
            <a:noFill/>
          </a:ln>
        </p:spPr>
      </p:pic>
      <p:pic>
        <p:nvPicPr>
          <p:cNvPr id="136" name="Picture 15" descr="C:\Users\owner\Downloads\Desktop\リバイス実験\HBEC4 免疫染色　E-cad VIM\2014.10.2HBEC4（C）免疫染色　山下\2014.9.29 HBEC4 C vim 免疫染色　山下\(vim)HBEC4 miR　NC （c） Actin 3　200倍.tif"/>
          <p:cNvPicPr/>
          <p:nvPr/>
        </p:nvPicPr>
        <p:blipFill>
          <a:blip r:embed="rId24"/>
          <a:stretch/>
        </p:blipFill>
        <p:spPr>
          <a:xfrm>
            <a:off x="1150920" y="5373720"/>
            <a:ext cx="976320" cy="733320"/>
          </a:xfrm>
          <a:prstGeom prst="rect">
            <a:avLst/>
          </a:prstGeom>
          <a:ln w="0">
            <a:noFill/>
          </a:ln>
        </p:spPr>
      </p:pic>
      <p:sp>
        <p:nvSpPr>
          <p:cNvPr id="137" name="正方形/長方形 5"/>
          <p:cNvSpPr/>
          <p:nvPr/>
        </p:nvSpPr>
        <p:spPr>
          <a:xfrm>
            <a:off x="2160" y="0"/>
            <a:ext cx="256896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Figure S4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8" name="グラフ 50" descr=""/>
          <p:cNvPicPr/>
          <p:nvPr/>
        </p:nvPicPr>
        <p:blipFill>
          <a:blip r:embed="rId25"/>
          <a:stretch/>
        </p:blipFill>
        <p:spPr>
          <a:xfrm>
            <a:off x="5761080" y="907920"/>
            <a:ext cx="3370320" cy="2030400"/>
          </a:xfrm>
          <a:prstGeom prst="rect">
            <a:avLst/>
          </a:prstGeom>
          <a:ln w="0">
            <a:noFill/>
          </a:ln>
        </p:spPr>
      </p:pic>
      <p:pic>
        <p:nvPicPr>
          <p:cNvPr id="139" name="グラフ 51" descr=""/>
          <p:cNvPicPr/>
          <p:nvPr/>
        </p:nvPicPr>
        <p:blipFill>
          <a:blip r:embed="rId26"/>
          <a:stretch/>
        </p:blipFill>
        <p:spPr>
          <a:xfrm>
            <a:off x="5888160" y="3968640"/>
            <a:ext cx="3365280" cy="2024280"/>
          </a:xfrm>
          <a:prstGeom prst="rect">
            <a:avLst/>
          </a:prstGeom>
          <a:ln w="0">
            <a:noFill/>
          </a:ln>
        </p:spPr>
      </p:pic>
      <p:sp>
        <p:nvSpPr>
          <p:cNvPr id="140" name="正方形/長方形 48"/>
          <p:cNvSpPr/>
          <p:nvPr/>
        </p:nvSpPr>
        <p:spPr>
          <a:xfrm>
            <a:off x="6633000" y="45133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正方形/長方形 49"/>
          <p:cNvSpPr/>
          <p:nvPr/>
        </p:nvSpPr>
        <p:spPr>
          <a:xfrm>
            <a:off x="7569720" y="44402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テキスト ボックス 52"/>
          <p:cNvSpPr/>
          <p:nvPr/>
        </p:nvSpPr>
        <p:spPr>
          <a:xfrm rot="16200000">
            <a:off x="4562640" y="1388520"/>
            <a:ext cx="21481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-CADHERIN-positive cell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% of control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テキスト ボックス 53"/>
          <p:cNvSpPr/>
          <p:nvPr/>
        </p:nvSpPr>
        <p:spPr>
          <a:xfrm rot="16200000">
            <a:off x="4777560" y="4653360"/>
            <a:ext cx="1920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VIMENTIN-positive cell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(% of control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4" name="グループ化 55"/>
          <p:cNvGrpSpPr/>
          <p:nvPr/>
        </p:nvGrpSpPr>
        <p:grpSpPr>
          <a:xfrm>
            <a:off x="-36360" y="520560"/>
            <a:ext cx="9183600" cy="5935680"/>
            <a:chOff x="-36360" y="520560"/>
            <a:chExt cx="9183600" cy="5935680"/>
          </a:xfrm>
        </p:grpSpPr>
        <p:sp>
          <p:nvSpPr>
            <p:cNvPr id="145" name="正方形/長方形 31"/>
            <p:cNvSpPr/>
            <p:nvPr/>
          </p:nvSpPr>
          <p:spPr>
            <a:xfrm>
              <a:off x="1258920" y="808560"/>
              <a:ext cx="144000" cy="1440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正方形/長方形 32"/>
            <p:cNvSpPr/>
            <p:nvPr/>
          </p:nvSpPr>
          <p:spPr>
            <a:xfrm>
              <a:off x="1258920" y="599760"/>
              <a:ext cx="144360" cy="144360"/>
            </a:xfrm>
            <a:prstGeom prst="rect">
              <a:avLst/>
            </a:prstGeom>
            <a:solidFill>
              <a:srgbClr val="808080"/>
            </a:solidFill>
            <a:ln w="9360">
              <a:solidFill>
                <a:srgbClr val="7f7f7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テキスト ボックス 40"/>
            <p:cNvSpPr/>
            <p:nvPr/>
          </p:nvSpPr>
          <p:spPr>
            <a:xfrm>
              <a:off x="1424880" y="735120"/>
              <a:ext cx="2082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miR-222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テキスト ボックス 40"/>
            <p:cNvSpPr/>
            <p:nvPr/>
          </p:nvSpPr>
          <p:spPr>
            <a:xfrm>
              <a:off x="1391400" y="520560"/>
              <a:ext cx="2082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miR-221</a:t>
              </a:r>
              <a:endParaRPr b="1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9" name="グループ化 55"/>
            <p:cNvGrpSpPr/>
            <p:nvPr/>
          </p:nvGrpSpPr>
          <p:grpSpPr>
            <a:xfrm>
              <a:off x="13320" y="4259520"/>
              <a:ext cx="3319200" cy="2166840"/>
              <a:chOff x="13320" y="4259520"/>
              <a:chExt cx="3319200" cy="2166840"/>
            </a:xfrm>
          </p:grpSpPr>
          <p:pic>
            <p:nvPicPr>
              <p:cNvPr id="150" name="グラフ 11" descr=""/>
              <p:cNvPicPr/>
              <p:nvPr/>
            </p:nvPicPr>
            <p:blipFill>
              <a:blip r:embed="rId1"/>
              <a:stretch/>
            </p:blipFill>
            <p:spPr>
              <a:xfrm>
                <a:off x="164880" y="4487040"/>
                <a:ext cx="3167640" cy="19393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51" name="テキスト ボックス 4"/>
              <p:cNvSpPr/>
              <p:nvPr/>
            </p:nvSpPr>
            <p:spPr>
              <a:xfrm>
                <a:off x="1100520" y="4292640"/>
                <a:ext cx="1222920" cy="337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5007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HCC4011</a:t>
                </a:r>
                <a:endParaRPr b="1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正方形/長方形 8"/>
              <p:cNvSpPr/>
              <p:nvPr/>
            </p:nvSpPr>
            <p:spPr>
              <a:xfrm rot="16200000">
                <a:off x="-537840" y="4811040"/>
                <a:ext cx="13341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Relative to RNU-6B</a:t>
                </a:r>
                <a:endParaRPr b="1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3" name="グループ化 60"/>
            <p:cNvGrpSpPr/>
            <p:nvPr/>
          </p:nvGrpSpPr>
          <p:grpSpPr>
            <a:xfrm>
              <a:off x="5897160" y="1443600"/>
              <a:ext cx="3103560" cy="2237040"/>
              <a:chOff x="5897160" y="1443600"/>
              <a:chExt cx="3103560" cy="2237040"/>
            </a:xfrm>
          </p:grpSpPr>
          <p:pic>
            <p:nvPicPr>
              <p:cNvPr id="154" name="グラフ 97" descr=""/>
              <p:cNvPicPr/>
              <p:nvPr/>
            </p:nvPicPr>
            <p:blipFill>
              <a:blip r:embed="rId2"/>
              <a:stretch/>
            </p:blipFill>
            <p:spPr>
              <a:xfrm>
                <a:off x="6046920" y="1809720"/>
                <a:ext cx="2953800" cy="1870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55" name="テキスト ボックス 4"/>
              <p:cNvSpPr/>
              <p:nvPr/>
            </p:nvSpPr>
            <p:spPr>
              <a:xfrm>
                <a:off x="7237800" y="1445040"/>
                <a:ext cx="1153440" cy="337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5007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HCC4006</a:t>
                </a:r>
                <a:endParaRPr b="1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正方形/長方形 8"/>
              <p:cNvSpPr/>
              <p:nvPr/>
            </p:nvSpPr>
            <p:spPr>
              <a:xfrm rot="16200000">
                <a:off x="5319720" y="2020680"/>
                <a:ext cx="13856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Relative to RNU-6B</a:t>
                </a:r>
                <a:endParaRPr b="1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7" name="グループ化 61"/>
            <p:cNvGrpSpPr/>
            <p:nvPr/>
          </p:nvGrpSpPr>
          <p:grpSpPr>
            <a:xfrm>
              <a:off x="2988000" y="1395360"/>
              <a:ext cx="3187440" cy="2254680"/>
              <a:chOff x="2988000" y="1395360"/>
              <a:chExt cx="3187440" cy="2254680"/>
            </a:xfrm>
          </p:grpSpPr>
          <p:pic>
            <p:nvPicPr>
              <p:cNvPr id="158" name="グラフ 10" descr=""/>
              <p:cNvPicPr/>
              <p:nvPr/>
            </p:nvPicPr>
            <p:blipFill>
              <a:blip r:embed="rId3"/>
              <a:stretch/>
            </p:blipFill>
            <p:spPr>
              <a:xfrm>
                <a:off x="3151800" y="1676520"/>
                <a:ext cx="3023640" cy="1973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59" name="テキスト ボックス 4"/>
              <p:cNvSpPr/>
              <p:nvPr/>
            </p:nvSpPr>
            <p:spPr>
              <a:xfrm>
                <a:off x="4428720" y="1461960"/>
                <a:ext cx="936360" cy="337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5007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H3255</a:t>
                </a:r>
                <a:endParaRPr b="1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正方形/長方形 8"/>
              <p:cNvSpPr/>
              <p:nvPr/>
            </p:nvSpPr>
            <p:spPr>
              <a:xfrm rot="16200000">
                <a:off x="2457000" y="1926000"/>
                <a:ext cx="129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Relative to RNU-6B</a:t>
                </a:r>
                <a:endParaRPr b="1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1" name="グループ化 58"/>
            <p:cNvGrpSpPr/>
            <p:nvPr/>
          </p:nvGrpSpPr>
          <p:grpSpPr>
            <a:xfrm>
              <a:off x="3054240" y="4134600"/>
              <a:ext cx="3060000" cy="2304000"/>
              <a:chOff x="3054240" y="4134600"/>
              <a:chExt cx="3060000" cy="2304000"/>
            </a:xfrm>
          </p:grpSpPr>
          <p:sp>
            <p:nvSpPr>
              <p:cNvPr id="162" name="テキスト ボックス 4"/>
              <p:cNvSpPr/>
              <p:nvPr/>
            </p:nvSpPr>
            <p:spPr>
              <a:xfrm>
                <a:off x="4350240" y="4278960"/>
                <a:ext cx="864000" cy="337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5007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H838</a:t>
                </a:r>
                <a:endParaRPr b="1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63" name="グラフ 84" descr=""/>
              <p:cNvPicPr/>
              <p:nvPr/>
            </p:nvPicPr>
            <p:blipFill>
              <a:blip r:embed="rId4"/>
              <a:stretch/>
            </p:blipFill>
            <p:spPr>
              <a:xfrm>
                <a:off x="3200040" y="4541040"/>
                <a:ext cx="2914200" cy="18975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64" name="正方形/長方形 8"/>
              <p:cNvSpPr/>
              <p:nvPr/>
            </p:nvSpPr>
            <p:spPr>
              <a:xfrm rot="16200000">
                <a:off x="2429280" y="4759560"/>
                <a:ext cx="14810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Relative to RNU-6B</a:t>
                </a:r>
                <a:endParaRPr b="1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5" name="グループ化 57"/>
            <p:cNvGrpSpPr/>
            <p:nvPr/>
          </p:nvGrpSpPr>
          <p:grpSpPr>
            <a:xfrm>
              <a:off x="5911920" y="4076640"/>
              <a:ext cx="3235320" cy="2379600"/>
              <a:chOff x="5911920" y="4076640"/>
              <a:chExt cx="3235320" cy="2379600"/>
            </a:xfrm>
          </p:grpSpPr>
          <p:pic>
            <p:nvPicPr>
              <p:cNvPr id="166" name="グラフ 8" descr=""/>
              <p:cNvPicPr/>
              <p:nvPr/>
            </p:nvPicPr>
            <p:blipFill>
              <a:blip r:embed="rId5"/>
              <a:stretch/>
            </p:blipFill>
            <p:spPr>
              <a:xfrm>
                <a:off x="6059160" y="4468320"/>
                <a:ext cx="3088080" cy="1987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67" name="テキスト ボックス 4"/>
              <p:cNvSpPr/>
              <p:nvPr/>
            </p:nvSpPr>
            <p:spPr>
              <a:xfrm>
                <a:off x="7273440" y="4369680"/>
                <a:ext cx="888840" cy="337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5007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H1299</a:t>
                </a:r>
                <a:endParaRPr b="1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正方形/長方形 8"/>
              <p:cNvSpPr/>
              <p:nvPr/>
            </p:nvSpPr>
            <p:spPr>
              <a:xfrm rot="16200000">
                <a:off x="5313600" y="4674960"/>
                <a:ext cx="1427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Relative to RNU-6B</a:t>
                </a:r>
                <a:endParaRPr b="1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9" name="グループ化 68"/>
            <p:cNvGrpSpPr/>
            <p:nvPr/>
          </p:nvGrpSpPr>
          <p:grpSpPr>
            <a:xfrm>
              <a:off x="-36360" y="1400760"/>
              <a:ext cx="3312360" cy="2232720"/>
              <a:chOff x="-36360" y="1400760"/>
              <a:chExt cx="3312360" cy="2232720"/>
            </a:xfrm>
          </p:grpSpPr>
          <p:pic>
            <p:nvPicPr>
              <p:cNvPr id="170" name="グラフ 70" descr=""/>
              <p:cNvPicPr/>
              <p:nvPr/>
            </p:nvPicPr>
            <p:blipFill>
              <a:blip r:embed="rId6"/>
              <a:stretch/>
            </p:blipFill>
            <p:spPr>
              <a:xfrm>
                <a:off x="176760" y="1614600"/>
                <a:ext cx="3099240" cy="2018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71" name="正方形/長方形 8"/>
              <p:cNvSpPr/>
              <p:nvPr/>
            </p:nvSpPr>
            <p:spPr>
              <a:xfrm rot="16200000">
                <a:off x="-567720" y="1932120"/>
                <a:ext cx="12942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ahoma"/>
                    <a:ea typeface="MS Gothic"/>
                  </a:rPr>
                  <a:t>Relative to RNU-6B</a:t>
                </a:r>
                <a:endParaRPr b="1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2" name="テキスト ボックス 4"/>
            <p:cNvSpPr/>
            <p:nvPr/>
          </p:nvSpPr>
          <p:spPr>
            <a:xfrm>
              <a:off x="1331280" y="1434240"/>
              <a:ext cx="792360" cy="3373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5007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ahoma"/>
                  <a:ea typeface="MS Gothic"/>
                </a:rPr>
                <a:t>H460</a:t>
              </a:r>
              <a:endParaRPr b="1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3" name="正方形/長方形 5"/>
          <p:cNvSpPr/>
          <p:nvPr/>
        </p:nvSpPr>
        <p:spPr>
          <a:xfrm>
            <a:off x="38520" y="0"/>
            <a:ext cx="256896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Figure S5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" name="グラフ 3" descr=""/>
          <p:cNvPicPr/>
          <p:nvPr/>
        </p:nvPicPr>
        <p:blipFill>
          <a:blip r:embed="rId1"/>
          <a:stretch/>
        </p:blipFill>
        <p:spPr>
          <a:xfrm>
            <a:off x="249120" y="689040"/>
            <a:ext cx="8682120" cy="5711760"/>
          </a:xfrm>
          <a:prstGeom prst="rect">
            <a:avLst/>
          </a:prstGeom>
          <a:ln w="0">
            <a:noFill/>
          </a:ln>
        </p:spPr>
      </p:pic>
      <p:sp>
        <p:nvSpPr>
          <p:cNvPr id="175" name="PlaceHolder 1"/>
          <p:cNvSpPr>
            <a:spLocks noGrp="1"/>
          </p:cNvSpPr>
          <p:nvPr>
            <p:ph type="title"/>
          </p:nvPr>
        </p:nvSpPr>
        <p:spPr>
          <a:xfrm>
            <a:off x="663480" y="-144720"/>
            <a:ext cx="8229600" cy="981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ahoma"/>
              </a:rPr>
              <a:t>H1299 miR-NC/H1299 miR-221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76" name="正方形/長方形 5"/>
          <p:cNvSpPr/>
          <p:nvPr/>
        </p:nvSpPr>
        <p:spPr>
          <a:xfrm>
            <a:off x="38520" y="0"/>
            <a:ext cx="256896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Figure S6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7" name="グラフ 3" descr=""/>
          <p:cNvPicPr/>
          <p:nvPr/>
        </p:nvPicPr>
        <p:blipFill>
          <a:blip r:embed="rId1"/>
          <a:stretch/>
        </p:blipFill>
        <p:spPr>
          <a:xfrm>
            <a:off x="0" y="907920"/>
            <a:ext cx="9144000" cy="5658120"/>
          </a:xfrm>
          <a:prstGeom prst="rect">
            <a:avLst/>
          </a:prstGeom>
          <a:ln w="0">
            <a:noFill/>
          </a:ln>
        </p:spPr>
      </p:pic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590400" y="-144720"/>
            <a:ext cx="8229600" cy="981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ahoma"/>
              </a:rPr>
              <a:t>H1299 miR-NC/H1299 miR-222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79" name="正方形/長方形 7"/>
          <p:cNvSpPr/>
          <p:nvPr/>
        </p:nvSpPr>
        <p:spPr>
          <a:xfrm>
            <a:off x="38520" y="0"/>
            <a:ext cx="256896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Figure S7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0" name="グラフ 3" descr=""/>
          <p:cNvPicPr/>
          <p:nvPr/>
        </p:nvPicPr>
        <p:blipFill>
          <a:blip r:embed="rId1"/>
          <a:stretch/>
        </p:blipFill>
        <p:spPr>
          <a:xfrm>
            <a:off x="0" y="596880"/>
            <a:ext cx="9144000" cy="5664240"/>
          </a:xfrm>
          <a:prstGeom prst="rect">
            <a:avLst/>
          </a:prstGeom>
          <a:ln w="0">
            <a:noFill/>
          </a:ln>
        </p:spPr>
      </p:pic>
      <p:sp>
        <p:nvSpPr>
          <p:cNvPr id="181" name="PlaceHolder 1"/>
          <p:cNvSpPr>
            <a:spLocks noGrp="1"/>
          </p:cNvSpPr>
          <p:nvPr>
            <p:ph type="title"/>
          </p:nvPr>
        </p:nvSpPr>
        <p:spPr>
          <a:xfrm>
            <a:off x="519120" y="-73440"/>
            <a:ext cx="8229600" cy="981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ahoma"/>
              </a:rPr>
              <a:t>H3255 miR-NC/H3255 miR-221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82" name="正方形/長方形 6"/>
          <p:cNvSpPr/>
          <p:nvPr/>
        </p:nvSpPr>
        <p:spPr>
          <a:xfrm>
            <a:off x="38520" y="0"/>
            <a:ext cx="256896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Figure S8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3" name="グラフ 3" descr=""/>
          <p:cNvPicPr/>
          <p:nvPr/>
        </p:nvPicPr>
        <p:blipFill>
          <a:blip r:embed="rId1"/>
          <a:stretch/>
        </p:blipFill>
        <p:spPr>
          <a:xfrm>
            <a:off x="0" y="596880"/>
            <a:ext cx="9144000" cy="5664240"/>
          </a:xfrm>
          <a:prstGeom prst="rect">
            <a:avLst/>
          </a:prstGeom>
          <a:ln w="0">
            <a:noFill/>
          </a:ln>
        </p:spPr>
      </p:pic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519120" y="-73440"/>
            <a:ext cx="8229600" cy="981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ahoma"/>
              </a:rPr>
              <a:t>H3255 miR-NC/H3255 miR-222</a:t>
            </a:r>
            <a:endParaRPr b="0" lang="en-US" sz="2000" spc="-1" strike="noStrike">
              <a:solidFill>
                <a:srgbClr val="000000"/>
              </a:solidFill>
              <a:latin typeface="Tahoma"/>
            </a:endParaRPr>
          </a:p>
        </p:txBody>
      </p:sp>
      <p:sp>
        <p:nvSpPr>
          <p:cNvPr id="185" name="正方形/長方形 6"/>
          <p:cNvSpPr/>
          <p:nvPr/>
        </p:nvSpPr>
        <p:spPr>
          <a:xfrm>
            <a:off x="38520" y="0"/>
            <a:ext cx="2568960" cy="3373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ahoma"/>
                <a:ea typeface="MS Gothic"/>
              </a:rPr>
              <a:t>Supplemental Figure S9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6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5T12:09:28Z</dcterms:created>
  <dc:creator>Akira</dc:creator>
  <dc:description/>
  <dc:language>en-US</dc:language>
  <cp:lastModifiedBy>Mitsuo Sato</cp:lastModifiedBy>
  <cp:lastPrinted>2011-04-21T09:22:06Z</cp:lastPrinted>
  <dcterms:modified xsi:type="dcterms:W3CDTF">2014-12-14T03:52:44Z</dcterms:modified>
  <cp:revision>2197</cp:revision>
  <dc:subject/>
  <dc:title>CMML &amp; JMML are different disease entity but there remains confusion</dc:title>
</cp:coreProperties>
</file>